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4"/>
  </p:notesMasterIdLst>
  <p:sldIdLst>
    <p:sldId id="269" r:id="rId2"/>
    <p:sldId id="268" r:id="rId3"/>
  </p:sldIdLst>
  <p:sldSz cx="12192000" cy="16256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12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nfalzone" initials="n" lastIdx="6" clrIdx="0">
    <p:extLst/>
  </p:cmAuthor>
  <p:cmAuthor id="2" name="Katherine Vallis" initials="" lastIdx="4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0504D"/>
    <a:srgbClr val="9BBB59"/>
    <a:srgbClr val="4F81BD"/>
    <a:srgbClr val="703BA0"/>
    <a:srgbClr val="92D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8309" autoAdjust="0"/>
    <p:restoredTop sz="94660"/>
  </p:normalViewPr>
  <p:slideViewPr>
    <p:cSldViewPr snapToGrid="0">
      <p:cViewPr varScale="1">
        <p:scale>
          <a:sx n="35" d="100"/>
          <a:sy n="35" d="100"/>
        </p:scale>
        <p:origin x="1596" y="78"/>
      </p:cViewPr>
      <p:guideLst>
        <p:guide orient="horz" pos="512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1.xlsx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Aurelien\ownCloud\Reviewing%20article%20R&amp;O\save_160314_Results_Postdoc_Project_Part1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Aurelien\ownCloud\Reviewing%20article%20R&amp;O\save_160314_Results_Postdoc_Project_Part1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Aurelien\ownCloud\Reviewing%20article%20R&amp;O\save_160314_Results_Postdoc_Project_Part1.xlsx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2.xlsx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3.xlsx"/><Relationship Id="rId1" Type="http://schemas.openxmlformats.org/officeDocument/2006/relationships/themeOverride" Target="../theme/themeOverrid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981822303648699"/>
          <c:y val="0.25144742571404499"/>
          <c:w val="0.73673230752138652"/>
          <c:h val="0.54495696148418205"/>
        </c:manualLayout>
      </c:layout>
      <c:scatterChart>
        <c:scatterStyle val="smoothMarker"/>
        <c:varyColors val="0"/>
        <c:ser>
          <c:idx val="0"/>
          <c:order val="0"/>
          <c:tx>
            <c:v>Muscle before EBRT</c:v>
          </c:tx>
          <c:spPr>
            <a:ln w="19050" cap="rnd">
              <a:solidFill>
                <a:srgbClr val="9BBB59"/>
              </a:solidFill>
              <a:round/>
            </a:ln>
            <a:effectLst/>
          </c:spPr>
          <c:marker>
            <c:symbol val="x"/>
            <c:size val="9"/>
            <c:spPr>
              <a:solidFill>
                <a:srgbClr val="9BBB59"/>
              </a:solidFill>
              <a:ln w="25400">
                <a:solidFill>
                  <a:srgbClr val="9BBB59"/>
                </a:solidFill>
              </a:ln>
              <a:effectLst/>
            </c:spPr>
          </c:marker>
          <c:xVal>
            <c:numRef>
              <c:f>'Vessel permeability'!$O$5:$O$64</c:f>
              <c:numCache>
                <c:formatCode>General</c:formatCode>
                <c:ptCount val="60"/>
                <c:pt idx="0">
                  <c:v>0</c:v>
                </c:pt>
                <c:pt idx="1">
                  <c:v>9</c:v>
                </c:pt>
                <c:pt idx="2">
                  <c:v>18</c:v>
                </c:pt>
                <c:pt idx="3">
                  <c:v>27</c:v>
                </c:pt>
                <c:pt idx="4">
                  <c:v>36</c:v>
                </c:pt>
                <c:pt idx="5">
                  <c:v>45</c:v>
                </c:pt>
                <c:pt idx="6">
                  <c:v>54</c:v>
                </c:pt>
                <c:pt idx="7">
                  <c:v>63</c:v>
                </c:pt>
                <c:pt idx="8">
                  <c:v>72</c:v>
                </c:pt>
                <c:pt idx="9">
                  <c:v>81</c:v>
                </c:pt>
                <c:pt idx="10">
                  <c:v>90</c:v>
                </c:pt>
                <c:pt idx="11">
                  <c:v>99</c:v>
                </c:pt>
                <c:pt idx="12">
                  <c:v>108</c:v>
                </c:pt>
                <c:pt idx="13">
                  <c:v>117</c:v>
                </c:pt>
                <c:pt idx="14">
                  <c:v>126</c:v>
                </c:pt>
                <c:pt idx="15">
                  <c:v>135</c:v>
                </c:pt>
                <c:pt idx="16">
                  <c:v>144</c:v>
                </c:pt>
                <c:pt idx="17">
                  <c:v>153</c:v>
                </c:pt>
                <c:pt idx="18">
                  <c:v>162</c:v>
                </c:pt>
                <c:pt idx="19">
                  <c:v>171</c:v>
                </c:pt>
                <c:pt idx="20">
                  <c:v>180</c:v>
                </c:pt>
                <c:pt idx="21">
                  <c:v>189</c:v>
                </c:pt>
                <c:pt idx="22">
                  <c:v>198</c:v>
                </c:pt>
                <c:pt idx="23">
                  <c:v>207</c:v>
                </c:pt>
                <c:pt idx="24">
                  <c:v>216</c:v>
                </c:pt>
                <c:pt idx="25">
                  <c:v>225</c:v>
                </c:pt>
                <c:pt idx="26">
                  <c:v>234</c:v>
                </c:pt>
                <c:pt idx="27">
                  <c:v>243</c:v>
                </c:pt>
                <c:pt idx="28">
                  <c:v>252</c:v>
                </c:pt>
                <c:pt idx="29">
                  <c:v>261</c:v>
                </c:pt>
                <c:pt idx="30">
                  <c:v>270</c:v>
                </c:pt>
                <c:pt idx="31">
                  <c:v>279</c:v>
                </c:pt>
                <c:pt idx="32">
                  <c:v>288</c:v>
                </c:pt>
                <c:pt idx="33">
                  <c:v>297</c:v>
                </c:pt>
                <c:pt idx="34">
                  <c:v>306</c:v>
                </c:pt>
                <c:pt idx="35">
                  <c:v>315</c:v>
                </c:pt>
                <c:pt idx="36">
                  <c:v>324</c:v>
                </c:pt>
                <c:pt idx="37">
                  <c:v>333</c:v>
                </c:pt>
                <c:pt idx="38">
                  <c:v>342</c:v>
                </c:pt>
                <c:pt idx="39">
                  <c:v>351</c:v>
                </c:pt>
                <c:pt idx="40">
                  <c:v>360</c:v>
                </c:pt>
                <c:pt idx="41">
                  <c:v>369</c:v>
                </c:pt>
                <c:pt idx="42">
                  <c:v>378</c:v>
                </c:pt>
                <c:pt idx="43">
                  <c:v>387</c:v>
                </c:pt>
                <c:pt idx="44">
                  <c:v>396</c:v>
                </c:pt>
                <c:pt idx="45">
                  <c:v>405</c:v>
                </c:pt>
                <c:pt idx="46">
                  <c:v>414</c:v>
                </c:pt>
                <c:pt idx="47">
                  <c:v>423</c:v>
                </c:pt>
                <c:pt idx="48">
                  <c:v>432</c:v>
                </c:pt>
                <c:pt idx="49">
                  <c:v>441</c:v>
                </c:pt>
                <c:pt idx="50">
                  <c:v>450</c:v>
                </c:pt>
                <c:pt idx="51">
                  <c:v>459</c:v>
                </c:pt>
                <c:pt idx="52">
                  <c:v>468</c:v>
                </c:pt>
                <c:pt idx="53">
                  <c:v>477</c:v>
                </c:pt>
                <c:pt idx="54">
                  <c:v>486</c:v>
                </c:pt>
                <c:pt idx="55">
                  <c:v>495</c:v>
                </c:pt>
                <c:pt idx="56">
                  <c:v>504</c:v>
                </c:pt>
                <c:pt idx="57">
                  <c:v>513</c:v>
                </c:pt>
                <c:pt idx="58">
                  <c:v>522</c:v>
                </c:pt>
                <c:pt idx="59">
                  <c:v>531</c:v>
                </c:pt>
              </c:numCache>
            </c:numRef>
          </c:xVal>
          <c:yVal>
            <c:numRef>
              <c:f>'Vessel permeability'!$AU$5:$AU$64</c:f>
              <c:numCache>
                <c:formatCode>General</c:formatCode>
                <c:ptCount val="60"/>
                <c:pt idx="0">
                  <c:v>100.42738193262304</c:v>
                </c:pt>
                <c:pt idx="1">
                  <c:v>99.332496525861998</c:v>
                </c:pt>
                <c:pt idx="2">
                  <c:v>99.479924846868499</c:v>
                </c:pt>
                <c:pt idx="3">
                  <c:v>100.42319524567228</c:v>
                </c:pt>
                <c:pt idx="4">
                  <c:v>99.388952094765585</c:v>
                </c:pt>
                <c:pt idx="5">
                  <c:v>100.44767657488609</c:v>
                </c:pt>
                <c:pt idx="6">
                  <c:v>99.490078360619236</c:v>
                </c:pt>
                <c:pt idx="7">
                  <c:v>100.55812527323363</c:v>
                </c:pt>
                <c:pt idx="8">
                  <c:v>100.55265464989709</c:v>
                </c:pt>
                <c:pt idx="9">
                  <c:v>99.89951449557239</c:v>
                </c:pt>
                <c:pt idx="10">
                  <c:v>100.26632667362153</c:v>
                </c:pt>
                <c:pt idx="11">
                  <c:v>102.46881518730032</c:v>
                </c:pt>
                <c:pt idx="12">
                  <c:v>109.44448322249274</c:v>
                </c:pt>
                <c:pt idx="13">
                  <c:v>116.45836505095053</c:v>
                </c:pt>
                <c:pt idx="14">
                  <c:v>118.26789919089209</c:v>
                </c:pt>
                <c:pt idx="15">
                  <c:v>119.24843340698034</c:v>
                </c:pt>
                <c:pt idx="16">
                  <c:v>122.08201284967049</c:v>
                </c:pt>
                <c:pt idx="17">
                  <c:v>124.16190891839496</c:v>
                </c:pt>
                <c:pt idx="18">
                  <c:v>123.70327245331698</c:v>
                </c:pt>
                <c:pt idx="19">
                  <c:v>124.28198798662453</c:v>
                </c:pt>
                <c:pt idx="20">
                  <c:v>122.77850380511126</c:v>
                </c:pt>
                <c:pt idx="21">
                  <c:v>124.87841903886924</c:v>
                </c:pt>
                <c:pt idx="22">
                  <c:v>124.91699534469684</c:v>
                </c:pt>
                <c:pt idx="23">
                  <c:v>124.52443794486436</c:v>
                </c:pt>
                <c:pt idx="24">
                  <c:v>123.69631481646505</c:v>
                </c:pt>
                <c:pt idx="25">
                  <c:v>124.44404606943056</c:v>
                </c:pt>
                <c:pt idx="26">
                  <c:v>125.95005616423875</c:v>
                </c:pt>
                <c:pt idx="27">
                  <c:v>123.12220642567529</c:v>
                </c:pt>
                <c:pt idx="28">
                  <c:v>124.89232233858259</c:v>
                </c:pt>
                <c:pt idx="29">
                  <c:v>126.19628301843044</c:v>
                </c:pt>
                <c:pt idx="30">
                  <c:v>124.61030223330408</c:v>
                </c:pt>
                <c:pt idx="31">
                  <c:v>123.34097736868688</c:v>
                </c:pt>
                <c:pt idx="32">
                  <c:v>124.14536295897936</c:v>
                </c:pt>
                <c:pt idx="33">
                  <c:v>123.36774342833962</c:v>
                </c:pt>
                <c:pt idx="34">
                  <c:v>124.12509832714073</c:v>
                </c:pt>
                <c:pt idx="35">
                  <c:v>123.01555139818959</c:v>
                </c:pt>
                <c:pt idx="36">
                  <c:v>121.6744761374038</c:v>
                </c:pt>
                <c:pt idx="37">
                  <c:v>124.5679488818498</c:v>
                </c:pt>
                <c:pt idx="38">
                  <c:v>123.41145313356725</c:v>
                </c:pt>
                <c:pt idx="39">
                  <c:v>122.35623354656528</c:v>
                </c:pt>
                <c:pt idx="40">
                  <c:v>124.31371202671654</c:v>
                </c:pt>
                <c:pt idx="41">
                  <c:v>122.86453183787098</c:v>
                </c:pt>
                <c:pt idx="42">
                  <c:v>122.89651316908376</c:v>
                </c:pt>
                <c:pt idx="43">
                  <c:v>123.93275443017598</c:v>
                </c:pt>
                <c:pt idx="44">
                  <c:v>121.22856203722665</c:v>
                </c:pt>
                <c:pt idx="45">
                  <c:v>122.21994753252599</c:v>
                </c:pt>
                <c:pt idx="46">
                  <c:v>121.38424726294153</c:v>
                </c:pt>
                <c:pt idx="47">
                  <c:v>122.0438340803273</c:v>
                </c:pt>
                <c:pt idx="48">
                  <c:v>122.2527941342269</c:v>
                </c:pt>
                <c:pt idx="49">
                  <c:v>122.79363503754985</c:v>
                </c:pt>
                <c:pt idx="50">
                  <c:v>121.63775909295032</c:v>
                </c:pt>
                <c:pt idx="51">
                  <c:v>122.12392181640254</c:v>
                </c:pt>
                <c:pt idx="52">
                  <c:v>119.99798889739773</c:v>
                </c:pt>
                <c:pt idx="53">
                  <c:v>122.49021591450821</c:v>
                </c:pt>
                <c:pt idx="54">
                  <c:v>121.4415914517959</c:v>
                </c:pt>
                <c:pt idx="55">
                  <c:v>121.06517080025387</c:v>
                </c:pt>
                <c:pt idx="56">
                  <c:v>121.84324624058175</c:v>
                </c:pt>
                <c:pt idx="57">
                  <c:v>118.23836190081421</c:v>
                </c:pt>
                <c:pt idx="58">
                  <c:v>121.8318803791291</c:v>
                </c:pt>
                <c:pt idx="59">
                  <c:v>120.00435007984817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102A-4513-9AE8-E64BC7E519D4}"/>
            </c:ext>
          </c:extLst>
        </c:ser>
        <c:ser>
          <c:idx val="1"/>
          <c:order val="1"/>
          <c:tx>
            <c:v>Tumour before EBRT</c:v>
          </c:tx>
          <c:spPr>
            <a:ln w="19050" cap="rnd">
              <a:solidFill>
                <a:srgbClr val="4F81BD"/>
              </a:solidFill>
              <a:round/>
            </a:ln>
            <a:effectLst/>
          </c:spPr>
          <c:marker>
            <c:symbol val="triangle"/>
            <c:size val="9"/>
            <c:spPr>
              <a:solidFill>
                <a:srgbClr val="4F81BD"/>
              </a:solidFill>
              <a:ln w="25400">
                <a:solidFill>
                  <a:srgbClr val="4F81BD"/>
                </a:solidFill>
              </a:ln>
              <a:effectLst/>
            </c:spPr>
          </c:marker>
          <c:xVal>
            <c:numRef>
              <c:f>'Vessel permeability'!$O$5:$O$64</c:f>
              <c:numCache>
                <c:formatCode>General</c:formatCode>
                <c:ptCount val="60"/>
                <c:pt idx="0">
                  <c:v>0</c:v>
                </c:pt>
                <c:pt idx="1">
                  <c:v>9</c:v>
                </c:pt>
                <c:pt idx="2">
                  <c:v>18</c:v>
                </c:pt>
                <c:pt idx="3">
                  <c:v>27</c:v>
                </c:pt>
                <c:pt idx="4">
                  <c:v>36</c:v>
                </c:pt>
                <c:pt idx="5">
                  <c:v>45</c:v>
                </c:pt>
                <c:pt idx="6">
                  <c:v>54</c:v>
                </c:pt>
                <c:pt idx="7">
                  <c:v>63</c:v>
                </c:pt>
                <c:pt idx="8">
                  <c:v>72</c:v>
                </c:pt>
                <c:pt idx="9">
                  <c:v>81</c:v>
                </c:pt>
                <c:pt idx="10">
                  <c:v>90</c:v>
                </c:pt>
                <c:pt idx="11">
                  <c:v>99</c:v>
                </c:pt>
                <c:pt idx="12">
                  <c:v>108</c:v>
                </c:pt>
                <c:pt idx="13">
                  <c:v>117</c:v>
                </c:pt>
                <c:pt idx="14">
                  <c:v>126</c:v>
                </c:pt>
                <c:pt idx="15">
                  <c:v>135</c:v>
                </c:pt>
                <c:pt idx="16">
                  <c:v>144</c:v>
                </c:pt>
                <c:pt idx="17">
                  <c:v>153</c:v>
                </c:pt>
                <c:pt idx="18">
                  <c:v>162</c:v>
                </c:pt>
                <c:pt idx="19">
                  <c:v>171</c:v>
                </c:pt>
                <c:pt idx="20">
                  <c:v>180</c:v>
                </c:pt>
                <c:pt idx="21">
                  <c:v>189</c:v>
                </c:pt>
                <c:pt idx="22">
                  <c:v>198</c:v>
                </c:pt>
                <c:pt idx="23">
                  <c:v>207</c:v>
                </c:pt>
                <c:pt idx="24">
                  <c:v>216</c:v>
                </c:pt>
                <c:pt idx="25">
                  <c:v>225</c:v>
                </c:pt>
                <c:pt idx="26">
                  <c:v>234</c:v>
                </c:pt>
                <c:pt idx="27">
                  <c:v>243</c:v>
                </c:pt>
                <c:pt idx="28">
                  <c:v>252</c:v>
                </c:pt>
                <c:pt idx="29">
                  <c:v>261</c:v>
                </c:pt>
                <c:pt idx="30">
                  <c:v>270</c:v>
                </c:pt>
                <c:pt idx="31">
                  <c:v>279</c:v>
                </c:pt>
                <c:pt idx="32">
                  <c:v>288</c:v>
                </c:pt>
                <c:pt idx="33">
                  <c:v>297</c:v>
                </c:pt>
                <c:pt idx="34">
                  <c:v>306</c:v>
                </c:pt>
                <c:pt idx="35">
                  <c:v>315</c:v>
                </c:pt>
                <c:pt idx="36">
                  <c:v>324</c:v>
                </c:pt>
                <c:pt idx="37">
                  <c:v>333</c:v>
                </c:pt>
                <c:pt idx="38">
                  <c:v>342</c:v>
                </c:pt>
                <c:pt idx="39">
                  <c:v>351</c:v>
                </c:pt>
                <c:pt idx="40">
                  <c:v>360</c:v>
                </c:pt>
                <c:pt idx="41">
                  <c:v>369</c:v>
                </c:pt>
                <c:pt idx="42">
                  <c:v>378</c:v>
                </c:pt>
                <c:pt idx="43">
                  <c:v>387</c:v>
                </c:pt>
                <c:pt idx="44">
                  <c:v>396</c:v>
                </c:pt>
                <c:pt idx="45">
                  <c:v>405</c:v>
                </c:pt>
                <c:pt idx="46">
                  <c:v>414</c:v>
                </c:pt>
                <c:pt idx="47">
                  <c:v>423</c:v>
                </c:pt>
                <c:pt idx="48">
                  <c:v>432</c:v>
                </c:pt>
                <c:pt idx="49">
                  <c:v>441</c:v>
                </c:pt>
                <c:pt idx="50">
                  <c:v>450</c:v>
                </c:pt>
                <c:pt idx="51">
                  <c:v>459</c:v>
                </c:pt>
                <c:pt idx="52">
                  <c:v>468</c:v>
                </c:pt>
                <c:pt idx="53">
                  <c:v>477</c:v>
                </c:pt>
                <c:pt idx="54">
                  <c:v>486</c:v>
                </c:pt>
                <c:pt idx="55">
                  <c:v>495</c:v>
                </c:pt>
                <c:pt idx="56">
                  <c:v>504</c:v>
                </c:pt>
                <c:pt idx="57">
                  <c:v>513</c:v>
                </c:pt>
                <c:pt idx="58">
                  <c:v>522</c:v>
                </c:pt>
                <c:pt idx="59">
                  <c:v>531</c:v>
                </c:pt>
              </c:numCache>
            </c:numRef>
          </c:xVal>
          <c:yVal>
            <c:numRef>
              <c:f>'Vessel permeability'!$Z$5:$Z$64</c:f>
              <c:numCache>
                <c:formatCode>General</c:formatCode>
                <c:ptCount val="60"/>
                <c:pt idx="0">
                  <c:v>100.82879640691588</c:v>
                </c:pt>
                <c:pt idx="1">
                  <c:v>101.73910665242136</c:v>
                </c:pt>
                <c:pt idx="2">
                  <c:v>100.00081014185088</c:v>
                </c:pt>
                <c:pt idx="3">
                  <c:v>100.81075886601216</c:v>
                </c:pt>
                <c:pt idx="4">
                  <c:v>100.93950011197389</c:v>
                </c:pt>
                <c:pt idx="5">
                  <c:v>99.859003130158314</c:v>
                </c:pt>
                <c:pt idx="6">
                  <c:v>98.245377348425905</c:v>
                </c:pt>
                <c:pt idx="7">
                  <c:v>98.178486174087467</c:v>
                </c:pt>
                <c:pt idx="8">
                  <c:v>99.693035469991003</c:v>
                </c:pt>
                <c:pt idx="9">
                  <c:v>99.705125698162988</c:v>
                </c:pt>
                <c:pt idx="10">
                  <c:v>97.001601624688945</c:v>
                </c:pt>
                <c:pt idx="11">
                  <c:v>121.96553684297346</c:v>
                </c:pt>
                <c:pt idx="12">
                  <c:v>130.78275734789744</c:v>
                </c:pt>
                <c:pt idx="13">
                  <c:v>134.67366077411609</c:v>
                </c:pt>
                <c:pt idx="14">
                  <c:v>136.60859210696816</c:v>
                </c:pt>
                <c:pt idx="15">
                  <c:v>137.49102708476534</c:v>
                </c:pt>
                <c:pt idx="16">
                  <c:v>140.03777244288034</c:v>
                </c:pt>
                <c:pt idx="17">
                  <c:v>140.52555672195291</c:v>
                </c:pt>
                <c:pt idx="18">
                  <c:v>140.78399618155782</c:v>
                </c:pt>
                <c:pt idx="19">
                  <c:v>143.06426144695772</c:v>
                </c:pt>
                <c:pt idx="20">
                  <c:v>141.5167985537324</c:v>
                </c:pt>
                <c:pt idx="21">
                  <c:v>142.84077688463654</c:v>
                </c:pt>
                <c:pt idx="22">
                  <c:v>143.77289688165902</c:v>
                </c:pt>
                <c:pt idx="23">
                  <c:v>141.30879651526493</c:v>
                </c:pt>
                <c:pt idx="24">
                  <c:v>143.23023495044643</c:v>
                </c:pt>
                <c:pt idx="25">
                  <c:v>142.95226483275641</c:v>
                </c:pt>
                <c:pt idx="26">
                  <c:v>143.47625712919873</c:v>
                </c:pt>
                <c:pt idx="27">
                  <c:v>141.45358884520635</c:v>
                </c:pt>
                <c:pt idx="28">
                  <c:v>144.47709473466028</c:v>
                </c:pt>
                <c:pt idx="29">
                  <c:v>142.93627629212372</c:v>
                </c:pt>
                <c:pt idx="30">
                  <c:v>143.37905157089671</c:v>
                </c:pt>
                <c:pt idx="31">
                  <c:v>142.69171122975058</c:v>
                </c:pt>
                <c:pt idx="32">
                  <c:v>141.1924338505313</c:v>
                </c:pt>
                <c:pt idx="33">
                  <c:v>142.65280092382318</c:v>
                </c:pt>
                <c:pt idx="34">
                  <c:v>141.84941053563921</c:v>
                </c:pt>
                <c:pt idx="35">
                  <c:v>141.3107940893556</c:v>
                </c:pt>
                <c:pt idx="36">
                  <c:v>141.58678782737502</c:v>
                </c:pt>
                <c:pt idx="37">
                  <c:v>141.49551140808475</c:v>
                </c:pt>
                <c:pt idx="38">
                  <c:v>141.4409940610858</c:v>
                </c:pt>
                <c:pt idx="39">
                  <c:v>142.72804641364067</c:v>
                </c:pt>
                <c:pt idx="40">
                  <c:v>140.97310074523935</c:v>
                </c:pt>
                <c:pt idx="41">
                  <c:v>139.64370988931239</c:v>
                </c:pt>
                <c:pt idx="42">
                  <c:v>140.71215504546242</c:v>
                </c:pt>
                <c:pt idx="43">
                  <c:v>140.63800636688299</c:v>
                </c:pt>
                <c:pt idx="44">
                  <c:v>141.51957237345772</c:v>
                </c:pt>
                <c:pt idx="45">
                  <c:v>140.13276583358862</c:v>
                </c:pt>
                <c:pt idx="46">
                  <c:v>141.36635791084501</c:v>
                </c:pt>
                <c:pt idx="47">
                  <c:v>139.89890395334567</c:v>
                </c:pt>
                <c:pt idx="48">
                  <c:v>140.6054278939485</c:v>
                </c:pt>
                <c:pt idx="49">
                  <c:v>140.3679523650853</c:v>
                </c:pt>
                <c:pt idx="50">
                  <c:v>139.77648498307991</c:v>
                </c:pt>
                <c:pt idx="51">
                  <c:v>138.28955600284803</c:v>
                </c:pt>
                <c:pt idx="52">
                  <c:v>140.36961877636253</c:v>
                </c:pt>
                <c:pt idx="53">
                  <c:v>141.52142423591042</c:v>
                </c:pt>
                <c:pt idx="54">
                  <c:v>139.24655295041578</c:v>
                </c:pt>
                <c:pt idx="55">
                  <c:v>139.50500565653317</c:v>
                </c:pt>
                <c:pt idx="56">
                  <c:v>140.34873432469604</c:v>
                </c:pt>
                <c:pt idx="57">
                  <c:v>137.97943130062467</c:v>
                </c:pt>
                <c:pt idx="58">
                  <c:v>137.77409975908478</c:v>
                </c:pt>
                <c:pt idx="59">
                  <c:v>138.6184934021770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102A-4513-9AE8-E64BC7E519D4}"/>
            </c:ext>
          </c:extLst>
        </c:ser>
        <c:ser>
          <c:idx val="4"/>
          <c:order val="2"/>
          <c:tx>
            <c:v>Muscle 24h after EBRT</c:v>
          </c:tx>
          <c:xVal>
            <c:numRef>
              <c:f>'Vessel permeability'!$O$5:$O$64</c:f>
              <c:numCache>
                <c:formatCode>General</c:formatCode>
                <c:ptCount val="60"/>
                <c:pt idx="0">
                  <c:v>0</c:v>
                </c:pt>
                <c:pt idx="1">
                  <c:v>9</c:v>
                </c:pt>
                <c:pt idx="2">
                  <c:v>18</c:v>
                </c:pt>
                <c:pt idx="3">
                  <c:v>27</c:v>
                </c:pt>
                <c:pt idx="4">
                  <c:v>36</c:v>
                </c:pt>
                <c:pt idx="5">
                  <c:v>45</c:v>
                </c:pt>
                <c:pt idx="6">
                  <c:v>54</c:v>
                </c:pt>
                <c:pt idx="7">
                  <c:v>63</c:v>
                </c:pt>
                <c:pt idx="8">
                  <c:v>72</c:v>
                </c:pt>
                <c:pt idx="9">
                  <c:v>81</c:v>
                </c:pt>
                <c:pt idx="10">
                  <c:v>90</c:v>
                </c:pt>
                <c:pt idx="11">
                  <c:v>99</c:v>
                </c:pt>
                <c:pt idx="12">
                  <c:v>108</c:v>
                </c:pt>
                <c:pt idx="13">
                  <c:v>117</c:v>
                </c:pt>
                <c:pt idx="14">
                  <c:v>126</c:v>
                </c:pt>
                <c:pt idx="15">
                  <c:v>135</c:v>
                </c:pt>
                <c:pt idx="16">
                  <c:v>144</c:v>
                </c:pt>
                <c:pt idx="17">
                  <c:v>153</c:v>
                </c:pt>
                <c:pt idx="18">
                  <c:v>162</c:v>
                </c:pt>
                <c:pt idx="19">
                  <c:v>171</c:v>
                </c:pt>
                <c:pt idx="20">
                  <c:v>180</c:v>
                </c:pt>
                <c:pt idx="21">
                  <c:v>189</c:v>
                </c:pt>
                <c:pt idx="22">
                  <c:v>198</c:v>
                </c:pt>
                <c:pt idx="23">
                  <c:v>207</c:v>
                </c:pt>
                <c:pt idx="24">
                  <c:v>216</c:v>
                </c:pt>
                <c:pt idx="25">
                  <c:v>225</c:v>
                </c:pt>
                <c:pt idx="26">
                  <c:v>234</c:v>
                </c:pt>
                <c:pt idx="27">
                  <c:v>243</c:v>
                </c:pt>
                <c:pt idx="28">
                  <c:v>252</c:v>
                </c:pt>
                <c:pt idx="29">
                  <c:v>261</c:v>
                </c:pt>
                <c:pt idx="30">
                  <c:v>270</c:v>
                </c:pt>
                <c:pt idx="31">
                  <c:v>279</c:v>
                </c:pt>
                <c:pt idx="32">
                  <c:v>288</c:v>
                </c:pt>
                <c:pt idx="33">
                  <c:v>297</c:v>
                </c:pt>
                <c:pt idx="34">
                  <c:v>306</c:v>
                </c:pt>
                <c:pt idx="35">
                  <c:v>315</c:v>
                </c:pt>
                <c:pt idx="36">
                  <c:v>324</c:v>
                </c:pt>
                <c:pt idx="37">
                  <c:v>333</c:v>
                </c:pt>
                <c:pt idx="38">
                  <c:v>342</c:v>
                </c:pt>
                <c:pt idx="39">
                  <c:v>351</c:v>
                </c:pt>
                <c:pt idx="40">
                  <c:v>360</c:v>
                </c:pt>
                <c:pt idx="41">
                  <c:v>369</c:v>
                </c:pt>
                <c:pt idx="42">
                  <c:v>378</c:v>
                </c:pt>
                <c:pt idx="43">
                  <c:v>387</c:v>
                </c:pt>
                <c:pt idx="44">
                  <c:v>396</c:v>
                </c:pt>
                <c:pt idx="45">
                  <c:v>405</c:v>
                </c:pt>
                <c:pt idx="46">
                  <c:v>414</c:v>
                </c:pt>
                <c:pt idx="47">
                  <c:v>423</c:v>
                </c:pt>
                <c:pt idx="48">
                  <c:v>432</c:v>
                </c:pt>
                <c:pt idx="49">
                  <c:v>441</c:v>
                </c:pt>
                <c:pt idx="50">
                  <c:v>450</c:v>
                </c:pt>
                <c:pt idx="51">
                  <c:v>459</c:v>
                </c:pt>
                <c:pt idx="52">
                  <c:v>468</c:v>
                </c:pt>
                <c:pt idx="53">
                  <c:v>477</c:v>
                </c:pt>
                <c:pt idx="54">
                  <c:v>486</c:v>
                </c:pt>
                <c:pt idx="55">
                  <c:v>495</c:v>
                </c:pt>
                <c:pt idx="56">
                  <c:v>504</c:v>
                </c:pt>
                <c:pt idx="57">
                  <c:v>513</c:v>
                </c:pt>
                <c:pt idx="58">
                  <c:v>522</c:v>
                </c:pt>
                <c:pt idx="59">
                  <c:v>531</c:v>
                </c:pt>
              </c:numCache>
            </c:numRef>
          </c:xVal>
          <c:yVal>
            <c:numRef>
              <c:f>'Vessel permeability'!$AQ$5:$AQ$64</c:f>
              <c:numCache>
                <c:formatCode>General</c:formatCode>
                <c:ptCount val="60"/>
                <c:pt idx="0">
                  <c:v>100.42738193262304</c:v>
                </c:pt>
                <c:pt idx="1">
                  <c:v>99.332496525861998</c:v>
                </c:pt>
                <c:pt idx="2">
                  <c:v>99.479924846868499</c:v>
                </c:pt>
                <c:pt idx="3">
                  <c:v>100.42319524567228</c:v>
                </c:pt>
                <c:pt idx="4">
                  <c:v>99.388952094765585</c:v>
                </c:pt>
                <c:pt idx="5">
                  <c:v>100.44767657488609</c:v>
                </c:pt>
                <c:pt idx="6">
                  <c:v>99.490078360619236</c:v>
                </c:pt>
                <c:pt idx="7">
                  <c:v>100.55812527323363</c:v>
                </c:pt>
                <c:pt idx="8">
                  <c:v>100.55265464989709</c:v>
                </c:pt>
                <c:pt idx="9">
                  <c:v>99.89951449557239</c:v>
                </c:pt>
                <c:pt idx="10">
                  <c:v>100.26632667362153</c:v>
                </c:pt>
                <c:pt idx="11">
                  <c:v>105.59447752322686</c:v>
                </c:pt>
                <c:pt idx="12">
                  <c:v>115.59496836610505</c:v>
                </c:pt>
                <c:pt idx="13">
                  <c:v>120.11748029521183</c:v>
                </c:pt>
                <c:pt idx="14">
                  <c:v>122.61824523215006</c:v>
                </c:pt>
                <c:pt idx="15">
                  <c:v>124.11137163774225</c:v>
                </c:pt>
                <c:pt idx="16">
                  <c:v>126.86300031779601</c:v>
                </c:pt>
                <c:pt idx="17">
                  <c:v>127.05554102034907</c:v>
                </c:pt>
                <c:pt idx="18">
                  <c:v>127.8263750946068</c:v>
                </c:pt>
                <c:pt idx="19">
                  <c:v>128.09795645969612</c:v>
                </c:pt>
                <c:pt idx="20">
                  <c:v>127.70968164788422</c:v>
                </c:pt>
                <c:pt idx="21">
                  <c:v>128.07885334088579</c:v>
                </c:pt>
                <c:pt idx="22">
                  <c:v>128.15612639171786</c:v>
                </c:pt>
                <c:pt idx="23">
                  <c:v>127.3192029781615</c:v>
                </c:pt>
                <c:pt idx="24">
                  <c:v>127.86738631086197</c:v>
                </c:pt>
                <c:pt idx="25">
                  <c:v>127.06737291651244</c:v>
                </c:pt>
                <c:pt idx="26">
                  <c:v>127.6869487253157</c:v>
                </c:pt>
                <c:pt idx="27">
                  <c:v>127.44090495973772</c:v>
                </c:pt>
                <c:pt idx="28">
                  <c:v>126.71471175464747</c:v>
                </c:pt>
                <c:pt idx="29">
                  <c:v>126.85165158089944</c:v>
                </c:pt>
                <c:pt idx="30">
                  <c:v>127.42397025006274</c:v>
                </c:pt>
                <c:pt idx="31">
                  <c:v>125.44936258692314</c:v>
                </c:pt>
                <c:pt idx="32">
                  <c:v>126.31957813275039</c:v>
                </c:pt>
                <c:pt idx="33">
                  <c:v>126.96001305693754</c:v>
                </c:pt>
                <c:pt idx="34">
                  <c:v>124.83101240067457</c:v>
                </c:pt>
                <c:pt idx="35">
                  <c:v>126.22559407664319</c:v>
                </c:pt>
                <c:pt idx="36">
                  <c:v>126.22978955234969</c:v>
                </c:pt>
                <c:pt idx="37">
                  <c:v>126.17713484640144</c:v>
                </c:pt>
                <c:pt idx="38">
                  <c:v>126.16260416708401</c:v>
                </c:pt>
                <c:pt idx="39">
                  <c:v>124.64359819443202</c:v>
                </c:pt>
                <c:pt idx="40">
                  <c:v>126.10496460908108</c:v>
                </c:pt>
                <c:pt idx="41">
                  <c:v>125.29135155601814</c:v>
                </c:pt>
                <c:pt idx="42">
                  <c:v>124.99878134811146</c:v>
                </c:pt>
                <c:pt idx="43">
                  <c:v>126.5070513197214</c:v>
                </c:pt>
                <c:pt idx="44">
                  <c:v>125.14596209931636</c:v>
                </c:pt>
                <c:pt idx="45">
                  <c:v>124.46697896996007</c:v>
                </c:pt>
                <c:pt idx="46">
                  <c:v>124.24076917134963</c:v>
                </c:pt>
                <c:pt idx="47">
                  <c:v>123.69521387509829</c:v>
                </c:pt>
                <c:pt idx="48">
                  <c:v>124.07985903399786</c:v>
                </c:pt>
                <c:pt idx="49">
                  <c:v>124.38064325113208</c:v>
                </c:pt>
                <c:pt idx="50">
                  <c:v>125.02398904774252</c:v>
                </c:pt>
                <c:pt idx="51">
                  <c:v>123.50407573728539</c:v>
                </c:pt>
                <c:pt idx="52">
                  <c:v>124.91305851598379</c:v>
                </c:pt>
                <c:pt idx="53">
                  <c:v>123.80864286671842</c:v>
                </c:pt>
                <c:pt idx="54">
                  <c:v>124.7762129683899</c:v>
                </c:pt>
                <c:pt idx="55">
                  <c:v>124.71343514809985</c:v>
                </c:pt>
                <c:pt idx="56">
                  <c:v>126.18820089816963</c:v>
                </c:pt>
                <c:pt idx="57">
                  <c:v>123.63089229834972</c:v>
                </c:pt>
                <c:pt idx="58">
                  <c:v>122.7823371610769</c:v>
                </c:pt>
                <c:pt idx="59">
                  <c:v>122.7968090105116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102A-4513-9AE8-E64BC7E519D4}"/>
            </c:ext>
          </c:extLst>
        </c:ser>
        <c:ser>
          <c:idx val="2"/>
          <c:order val="3"/>
          <c:tx>
            <c:v>Tumour 24h after EBRT</c:v>
          </c:tx>
          <c:spPr>
            <a:ln w="19050" cap="rnd">
              <a:solidFill>
                <a:srgbClr val="C0504D"/>
              </a:solidFill>
              <a:round/>
            </a:ln>
            <a:effectLst/>
          </c:spPr>
          <c:marker>
            <c:symbol val="diamond"/>
            <c:size val="9"/>
            <c:spPr>
              <a:solidFill>
                <a:srgbClr val="C0504D"/>
              </a:solidFill>
              <a:ln w="25400">
                <a:solidFill>
                  <a:srgbClr val="C0504D"/>
                </a:solidFill>
              </a:ln>
              <a:effectLst/>
            </c:spPr>
          </c:marker>
          <c:xVal>
            <c:numRef>
              <c:f>'Vessel permeability'!$O$5:$O$64</c:f>
              <c:numCache>
                <c:formatCode>General</c:formatCode>
                <c:ptCount val="60"/>
                <c:pt idx="0">
                  <c:v>0</c:v>
                </c:pt>
                <c:pt idx="1">
                  <c:v>9</c:v>
                </c:pt>
                <c:pt idx="2">
                  <c:v>18</c:v>
                </c:pt>
                <c:pt idx="3">
                  <c:v>27</c:v>
                </c:pt>
                <c:pt idx="4">
                  <c:v>36</c:v>
                </c:pt>
                <c:pt idx="5">
                  <c:v>45</c:v>
                </c:pt>
                <c:pt idx="6">
                  <c:v>54</c:v>
                </c:pt>
                <c:pt idx="7">
                  <c:v>63</c:v>
                </c:pt>
                <c:pt idx="8">
                  <c:v>72</c:v>
                </c:pt>
                <c:pt idx="9">
                  <c:v>81</c:v>
                </c:pt>
                <c:pt idx="10">
                  <c:v>90</c:v>
                </c:pt>
                <c:pt idx="11">
                  <c:v>99</c:v>
                </c:pt>
                <c:pt idx="12">
                  <c:v>108</c:v>
                </c:pt>
                <c:pt idx="13">
                  <c:v>117</c:v>
                </c:pt>
                <c:pt idx="14">
                  <c:v>126</c:v>
                </c:pt>
                <c:pt idx="15">
                  <c:v>135</c:v>
                </c:pt>
                <c:pt idx="16">
                  <c:v>144</c:v>
                </c:pt>
                <c:pt idx="17">
                  <c:v>153</c:v>
                </c:pt>
                <c:pt idx="18">
                  <c:v>162</c:v>
                </c:pt>
                <c:pt idx="19">
                  <c:v>171</c:v>
                </c:pt>
                <c:pt idx="20">
                  <c:v>180</c:v>
                </c:pt>
                <c:pt idx="21">
                  <c:v>189</c:v>
                </c:pt>
                <c:pt idx="22">
                  <c:v>198</c:v>
                </c:pt>
                <c:pt idx="23">
                  <c:v>207</c:v>
                </c:pt>
                <c:pt idx="24">
                  <c:v>216</c:v>
                </c:pt>
                <c:pt idx="25">
                  <c:v>225</c:v>
                </c:pt>
                <c:pt idx="26">
                  <c:v>234</c:v>
                </c:pt>
                <c:pt idx="27">
                  <c:v>243</c:v>
                </c:pt>
                <c:pt idx="28">
                  <c:v>252</c:v>
                </c:pt>
                <c:pt idx="29">
                  <c:v>261</c:v>
                </c:pt>
                <c:pt idx="30">
                  <c:v>270</c:v>
                </c:pt>
                <c:pt idx="31">
                  <c:v>279</c:v>
                </c:pt>
                <c:pt idx="32">
                  <c:v>288</c:v>
                </c:pt>
                <c:pt idx="33">
                  <c:v>297</c:v>
                </c:pt>
                <c:pt idx="34">
                  <c:v>306</c:v>
                </c:pt>
                <c:pt idx="35">
                  <c:v>315</c:v>
                </c:pt>
                <c:pt idx="36">
                  <c:v>324</c:v>
                </c:pt>
                <c:pt idx="37">
                  <c:v>333</c:v>
                </c:pt>
                <c:pt idx="38">
                  <c:v>342</c:v>
                </c:pt>
                <c:pt idx="39">
                  <c:v>351</c:v>
                </c:pt>
                <c:pt idx="40">
                  <c:v>360</c:v>
                </c:pt>
                <c:pt idx="41">
                  <c:v>369</c:v>
                </c:pt>
                <c:pt idx="42">
                  <c:v>378</c:v>
                </c:pt>
                <c:pt idx="43">
                  <c:v>387</c:v>
                </c:pt>
                <c:pt idx="44">
                  <c:v>396</c:v>
                </c:pt>
                <c:pt idx="45">
                  <c:v>405</c:v>
                </c:pt>
                <c:pt idx="46">
                  <c:v>414</c:v>
                </c:pt>
                <c:pt idx="47">
                  <c:v>423</c:v>
                </c:pt>
                <c:pt idx="48">
                  <c:v>432</c:v>
                </c:pt>
                <c:pt idx="49">
                  <c:v>441</c:v>
                </c:pt>
                <c:pt idx="50">
                  <c:v>450</c:v>
                </c:pt>
                <c:pt idx="51">
                  <c:v>459</c:v>
                </c:pt>
                <c:pt idx="52">
                  <c:v>468</c:v>
                </c:pt>
                <c:pt idx="53">
                  <c:v>477</c:v>
                </c:pt>
                <c:pt idx="54">
                  <c:v>486</c:v>
                </c:pt>
                <c:pt idx="55">
                  <c:v>495</c:v>
                </c:pt>
                <c:pt idx="56">
                  <c:v>504</c:v>
                </c:pt>
                <c:pt idx="57">
                  <c:v>513</c:v>
                </c:pt>
                <c:pt idx="58">
                  <c:v>522</c:v>
                </c:pt>
                <c:pt idx="59">
                  <c:v>531</c:v>
                </c:pt>
              </c:numCache>
            </c:numRef>
          </c:xVal>
          <c:yVal>
            <c:numRef>
              <c:f>'Vessel permeability'!$AH$5:$AH$64</c:f>
              <c:numCache>
                <c:formatCode>General</c:formatCode>
                <c:ptCount val="60"/>
                <c:pt idx="0">
                  <c:v>97.699321385878989</c:v>
                </c:pt>
                <c:pt idx="1">
                  <c:v>99.408277365941416</c:v>
                </c:pt>
                <c:pt idx="2">
                  <c:v>100.23022877157317</c:v>
                </c:pt>
                <c:pt idx="3">
                  <c:v>99.728379216140212</c:v>
                </c:pt>
                <c:pt idx="4">
                  <c:v>99.494627005278574</c:v>
                </c:pt>
                <c:pt idx="5">
                  <c:v>99.745512466873947</c:v>
                </c:pt>
                <c:pt idx="6">
                  <c:v>101.18734185313679</c:v>
                </c:pt>
                <c:pt idx="7">
                  <c:v>100.37841337648817</c:v>
                </c:pt>
                <c:pt idx="8">
                  <c:v>100.22197524549792</c:v>
                </c:pt>
                <c:pt idx="9">
                  <c:v>101.905923313191</c:v>
                </c:pt>
                <c:pt idx="10">
                  <c:v>101.51459351866596</c:v>
                </c:pt>
                <c:pt idx="11">
                  <c:v>122.68658206909666</c:v>
                </c:pt>
                <c:pt idx="12">
                  <c:v>143.43038088921989</c:v>
                </c:pt>
                <c:pt idx="13">
                  <c:v>152.71525174201693</c:v>
                </c:pt>
                <c:pt idx="14">
                  <c:v>158.63165744792985</c:v>
                </c:pt>
                <c:pt idx="15">
                  <c:v>163.91609010468636</c:v>
                </c:pt>
                <c:pt idx="16">
                  <c:v>169.03434566983861</c:v>
                </c:pt>
                <c:pt idx="17">
                  <c:v>171.27529737731092</c:v>
                </c:pt>
                <c:pt idx="18">
                  <c:v>174.00549031760102</c:v>
                </c:pt>
                <c:pt idx="19">
                  <c:v>175.48893617546003</c:v>
                </c:pt>
                <c:pt idx="20">
                  <c:v>177.28604032868995</c:v>
                </c:pt>
                <c:pt idx="21">
                  <c:v>177.99576350924264</c:v>
                </c:pt>
                <c:pt idx="22">
                  <c:v>178.44298367183623</c:v>
                </c:pt>
                <c:pt idx="23">
                  <c:v>179.26378704673206</c:v>
                </c:pt>
                <c:pt idx="24">
                  <c:v>181.34137526719329</c:v>
                </c:pt>
                <c:pt idx="25">
                  <c:v>181.26791416718896</c:v>
                </c:pt>
                <c:pt idx="26">
                  <c:v>181.25123841313703</c:v>
                </c:pt>
                <c:pt idx="27">
                  <c:v>182.09741712742482</c:v>
                </c:pt>
                <c:pt idx="28">
                  <c:v>182.57804598520752</c:v>
                </c:pt>
                <c:pt idx="29">
                  <c:v>183.38941063168676</c:v>
                </c:pt>
                <c:pt idx="30">
                  <c:v>182.03814128391085</c:v>
                </c:pt>
                <c:pt idx="31">
                  <c:v>181.31265877234699</c:v>
                </c:pt>
                <c:pt idx="32">
                  <c:v>182.93615723160184</c:v>
                </c:pt>
                <c:pt idx="33">
                  <c:v>183.7078254628714</c:v>
                </c:pt>
                <c:pt idx="34">
                  <c:v>182.40741258998702</c:v>
                </c:pt>
                <c:pt idx="35">
                  <c:v>183.56801876594204</c:v>
                </c:pt>
                <c:pt idx="36">
                  <c:v>182.91438896761051</c:v>
                </c:pt>
                <c:pt idx="37">
                  <c:v>184.10164575495801</c:v>
                </c:pt>
                <c:pt idx="38">
                  <c:v>183.63276741351214</c:v>
                </c:pt>
                <c:pt idx="39">
                  <c:v>184.18314878882225</c:v>
                </c:pt>
                <c:pt idx="40">
                  <c:v>184.05874543329855</c:v>
                </c:pt>
                <c:pt idx="41">
                  <c:v>183.44362684783536</c:v>
                </c:pt>
                <c:pt idx="42">
                  <c:v>184.49452817884693</c:v>
                </c:pt>
                <c:pt idx="43">
                  <c:v>183.44290057185302</c:v>
                </c:pt>
                <c:pt idx="44">
                  <c:v>184.09629590313511</c:v>
                </c:pt>
                <c:pt idx="45">
                  <c:v>184.46841369637843</c:v>
                </c:pt>
                <c:pt idx="46">
                  <c:v>184.23023949415165</c:v>
                </c:pt>
                <c:pt idx="47">
                  <c:v>185.21654801240035</c:v>
                </c:pt>
                <c:pt idx="48">
                  <c:v>185.01450604029654</c:v>
                </c:pt>
                <c:pt idx="49">
                  <c:v>184.92114240495644</c:v>
                </c:pt>
                <c:pt idx="50">
                  <c:v>184.66999817180042</c:v>
                </c:pt>
                <c:pt idx="51">
                  <c:v>183.42317531648141</c:v>
                </c:pt>
                <c:pt idx="52">
                  <c:v>184.7336645537826</c:v>
                </c:pt>
                <c:pt idx="53">
                  <c:v>184.54590791556831</c:v>
                </c:pt>
                <c:pt idx="54">
                  <c:v>183.88039321124964</c:v>
                </c:pt>
                <c:pt idx="55">
                  <c:v>184.14554256157757</c:v>
                </c:pt>
                <c:pt idx="56">
                  <c:v>183.57572615535341</c:v>
                </c:pt>
                <c:pt idx="57">
                  <c:v>184.77346104639145</c:v>
                </c:pt>
                <c:pt idx="58">
                  <c:v>184.38892221823704</c:v>
                </c:pt>
                <c:pt idx="59">
                  <c:v>184.253035695999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102A-4513-9AE8-E64BC7E519D4}"/>
            </c:ext>
          </c:extLst>
        </c:ser>
        <c:ser>
          <c:idx val="5"/>
          <c:order val="4"/>
          <c:tx>
            <c:v>Muscle 72h after EBRT</c:v>
          </c:tx>
          <c:xVal>
            <c:numRef>
              <c:f>'Vessel permeability'!$O$5:$O$64</c:f>
              <c:numCache>
                <c:formatCode>General</c:formatCode>
                <c:ptCount val="60"/>
                <c:pt idx="0">
                  <c:v>0</c:v>
                </c:pt>
                <c:pt idx="1">
                  <c:v>9</c:v>
                </c:pt>
                <c:pt idx="2">
                  <c:v>18</c:v>
                </c:pt>
                <c:pt idx="3">
                  <c:v>27</c:v>
                </c:pt>
                <c:pt idx="4">
                  <c:v>36</c:v>
                </c:pt>
                <c:pt idx="5">
                  <c:v>45</c:v>
                </c:pt>
                <c:pt idx="6">
                  <c:v>54</c:v>
                </c:pt>
                <c:pt idx="7">
                  <c:v>63</c:v>
                </c:pt>
                <c:pt idx="8">
                  <c:v>72</c:v>
                </c:pt>
                <c:pt idx="9">
                  <c:v>81</c:v>
                </c:pt>
                <c:pt idx="10">
                  <c:v>90</c:v>
                </c:pt>
                <c:pt idx="11">
                  <c:v>99</c:v>
                </c:pt>
                <c:pt idx="12">
                  <c:v>108</c:v>
                </c:pt>
                <c:pt idx="13">
                  <c:v>117</c:v>
                </c:pt>
                <c:pt idx="14">
                  <c:v>126</c:v>
                </c:pt>
                <c:pt idx="15">
                  <c:v>135</c:v>
                </c:pt>
                <c:pt idx="16">
                  <c:v>144</c:v>
                </c:pt>
                <c:pt idx="17">
                  <c:v>153</c:v>
                </c:pt>
                <c:pt idx="18">
                  <c:v>162</c:v>
                </c:pt>
                <c:pt idx="19">
                  <c:v>171</c:v>
                </c:pt>
                <c:pt idx="20">
                  <c:v>180</c:v>
                </c:pt>
                <c:pt idx="21">
                  <c:v>189</c:v>
                </c:pt>
                <c:pt idx="22">
                  <c:v>198</c:v>
                </c:pt>
                <c:pt idx="23">
                  <c:v>207</c:v>
                </c:pt>
                <c:pt idx="24">
                  <c:v>216</c:v>
                </c:pt>
                <c:pt idx="25">
                  <c:v>225</c:v>
                </c:pt>
                <c:pt idx="26">
                  <c:v>234</c:v>
                </c:pt>
                <c:pt idx="27">
                  <c:v>243</c:v>
                </c:pt>
                <c:pt idx="28">
                  <c:v>252</c:v>
                </c:pt>
                <c:pt idx="29">
                  <c:v>261</c:v>
                </c:pt>
                <c:pt idx="30">
                  <c:v>270</c:v>
                </c:pt>
                <c:pt idx="31">
                  <c:v>279</c:v>
                </c:pt>
                <c:pt idx="32">
                  <c:v>288</c:v>
                </c:pt>
                <c:pt idx="33">
                  <c:v>297</c:v>
                </c:pt>
                <c:pt idx="34">
                  <c:v>306</c:v>
                </c:pt>
                <c:pt idx="35">
                  <c:v>315</c:v>
                </c:pt>
                <c:pt idx="36">
                  <c:v>324</c:v>
                </c:pt>
                <c:pt idx="37">
                  <c:v>333</c:v>
                </c:pt>
                <c:pt idx="38">
                  <c:v>342</c:v>
                </c:pt>
                <c:pt idx="39">
                  <c:v>351</c:v>
                </c:pt>
                <c:pt idx="40">
                  <c:v>360</c:v>
                </c:pt>
                <c:pt idx="41">
                  <c:v>369</c:v>
                </c:pt>
                <c:pt idx="42">
                  <c:v>378</c:v>
                </c:pt>
                <c:pt idx="43">
                  <c:v>387</c:v>
                </c:pt>
                <c:pt idx="44">
                  <c:v>396</c:v>
                </c:pt>
                <c:pt idx="45">
                  <c:v>405</c:v>
                </c:pt>
                <c:pt idx="46">
                  <c:v>414</c:v>
                </c:pt>
                <c:pt idx="47">
                  <c:v>423</c:v>
                </c:pt>
                <c:pt idx="48">
                  <c:v>432</c:v>
                </c:pt>
                <c:pt idx="49">
                  <c:v>441</c:v>
                </c:pt>
                <c:pt idx="50">
                  <c:v>450</c:v>
                </c:pt>
                <c:pt idx="51">
                  <c:v>459</c:v>
                </c:pt>
                <c:pt idx="52">
                  <c:v>468</c:v>
                </c:pt>
                <c:pt idx="53">
                  <c:v>477</c:v>
                </c:pt>
                <c:pt idx="54">
                  <c:v>486</c:v>
                </c:pt>
                <c:pt idx="55">
                  <c:v>495</c:v>
                </c:pt>
                <c:pt idx="56">
                  <c:v>504</c:v>
                </c:pt>
                <c:pt idx="57">
                  <c:v>513</c:v>
                </c:pt>
                <c:pt idx="58">
                  <c:v>522</c:v>
                </c:pt>
                <c:pt idx="59">
                  <c:v>531</c:v>
                </c:pt>
              </c:numCache>
            </c:numRef>
          </c:xVal>
          <c:yVal>
            <c:numRef>
              <c:f>'Vessel permeability'!$AM$5:$AM$121</c:f>
              <c:numCache>
                <c:formatCode>General</c:formatCode>
                <c:ptCount val="117"/>
                <c:pt idx="0">
                  <c:v>99.552488310682989</c:v>
                </c:pt>
                <c:pt idx="1">
                  <c:v>99.561938815955671</c:v>
                </c:pt>
                <c:pt idx="2">
                  <c:v>100.42877447111702</c:v>
                </c:pt>
                <c:pt idx="3">
                  <c:v>99.857370482738517</c:v>
                </c:pt>
                <c:pt idx="4">
                  <c:v>99.61874321101206</c:v>
                </c:pt>
                <c:pt idx="5">
                  <c:v>99.234629341294564</c:v>
                </c:pt>
                <c:pt idx="6">
                  <c:v>100.84291410073234</c:v>
                </c:pt>
                <c:pt idx="7">
                  <c:v>99.50126984552044</c:v>
                </c:pt>
                <c:pt idx="8">
                  <c:v>100.54773774211452</c:v>
                </c:pt>
                <c:pt idx="9">
                  <c:v>100.85413367883183</c:v>
                </c:pt>
                <c:pt idx="10">
                  <c:v>100.04084936719089</c:v>
                </c:pt>
                <c:pt idx="11">
                  <c:v>106.43</c:v>
                </c:pt>
                <c:pt idx="12">
                  <c:v>110.15</c:v>
                </c:pt>
                <c:pt idx="13">
                  <c:v>110.87127236398048</c:v>
                </c:pt>
                <c:pt idx="14">
                  <c:v>113.72367458052548</c:v>
                </c:pt>
                <c:pt idx="15">
                  <c:v>117.39368881462131</c:v>
                </c:pt>
                <c:pt idx="16">
                  <c:v>117.46855312419001</c:v>
                </c:pt>
                <c:pt idx="17">
                  <c:v>117.31103679906334</c:v>
                </c:pt>
                <c:pt idx="18">
                  <c:v>119.66625906495233</c:v>
                </c:pt>
                <c:pt idx="19">
                  <c:v>120.04844257242948</c:v>
                </c:pt>
                <c:pt idx="20">
                  <c:v>120.2150462452004</c:v>
                </c:pt>
                <c:pt idx="21">
                  <c:v>120.69778149511059</c:v>
                </c:pt>
                <c:pt idx="22">
                  <c:v>120.49901314534418</c:v>
                </c:pt>
                <c:pt idx="23">
                  <c:v>122.46690595037418</c:v>
                </c:pt>
                <c:pt idx="24">
                  <c:v>120.30861354647804</c:v>
                </c:pt>
                <c:pt idx="25">
                  <c:v>119.52019687166388</c:v>
                </c:pt>
                <c:pt idx="26">
                  <c:v>120.49185950326151</c:v>
                </c:pt>
                <c:pt idx="27">
                  <c:v>120.59326725901894</c:v>
                </c:pt>
                <c:pt idx="28">
                  <c:v>121.28496781817634</c:v>
                </c:pt>
                <c:pt idx="29">
                  <c:v>120.32837299577541</c:v>
                </c:pt>
                <c:pt idx="30">
                  <c:v>121.08197269128857</c:v>
                </c:pt>
                <c:pt idx="31">
                  <c:v>121.35147392654287</c:v>
                </c:pt>
                <c:pt idx="32">
                  <c:v>120.94742806327953</c:v>
                </c:pt>
                <c:pt idx="33">
                  <c:v>120.61935625667397</c:v>
                </c:pt>
                <c:pt idx="34">
                  <c:v>120.54096253207915</c:v>
                </c:pt>
                <c:pt idx="35">
                  <c:v>119.93136459266304</c:v>
                </c:pt>
                <c:pt idx="36">
                  <c:v>120.62213515535676</c:v>
                </c:pt>
                <c:pt idx="37">
                  <c:v>119.78940217436111</c:v>
                </c:pt>
                <c:pt idx="38">
                  <c:v>120.91844398501003</c:v>
                </c:pt>
                <c:pt idx="39">
                  <c:v>119.90403938679425</c:v>
                </c:pt>
                <c:pt idx="40">
                  <c:v>119.07225736640595</c:v>
                </c:pt>
                <c:pt idx="41">
                  <c:v>119.76662064231441</c:v>
                </c:pt>
                <c:pt idx="42">
                  <c:v>120.60207977350234</c:v>
                </c:pt>
                <c:pt idx="43">
                  <c:v>121.31739664338205</c:v>
                </c:pt>
                <c:pt idx="44">
                  <c:v>119.800190728451</c:v>
                </c:pt>
                <c:pt idx="45">
                  <c:v>119.33095949787229</c:v>
                </c:pt>
                <c:pt idx="46">
                  <c:v>119.0653573228354</c:v>
                </c:pt>
                <c:pt idx="47">
                  <c:v>117.28210546928437</c:v>
                </c:pt>
                <c:pt idx="48">
                  <c:v>117.42260959470217</c:v>
                </c:pt>
                <c:pt idx="49">
                  <c:v>118.72947671084437</c:v>
                </c:pt>
                <c:pt idx="50">
                  <c:v>118.17799502949832</c:v>
                </c:pt>
                <c:pt idx="51">
                  <c:v>118.9016595508821</c:v>
                </c:pt>
                <c:pt idx="52">
                  <c:v>117.60228407291959</c:v>
                </c:pt>
                <c:pt idx="53">
                  <c:v>119.11507318091087</c:v>
                </c:pt>
                <c:pt idx="54">
                  <c:v>117.93039834882264</c:v>
                </c:pt>
                <c:pt idx="55">
                  <c:v>119.19230454517864</c:v>
                </c:pt>
                <c:pt idx="56">
                  <c:v>117.42118308616489</c:v>
                </c:pt>
                <c:pt idx="57">
                  <c:v>117.79687866456024</c:v>
                </c:pt>
                <c:pt idx="58">
                  <c:v>118.43169917386136</c:v>
                </c:pt>
                <c:pt idx="59">
                  <c:v>117.1331691595251</c:v>
                </c:pt>
                <c:pt idx="65">
                  <c:v>99.703516851714426</c:v>
                </c:pt>
                <c:pt idx="66">
                  <c:v>100.63453666249099</c:v>
                </c:pt>
                <c:pt idx="67">
                  <c:v>99.118669573113593</c:v>
                </c:pt>
                <c:pt idx="68">
                  <c:v>101.82054923448283</c:v>
                </c:pt>
                <c:pt idx="69">
                  <c:v>99.970747153405213</c:v>
                </c:pt>
                <c:pt idx="70">
                  <c:v>100.14811384093161</c:v>
                </c:pt>
                <c:pt idx="71">
                  <c:v>98.755833486457874</c:v>
                </c:pt>
                <c:pt idx="72">
                  <c:v>100.81209359097021</c:v>
                </c:pt>
                <c:pt idx="73">
                  <c:v>100.20565978792652</c:v>
                </c:pt>
                <c:pt idx="74">
                  <c:v>98.83027981850671</c:v>
                </c:pt>
                <c:pt idx="75">
                  <c:v>98.27594485925772</c:v>
                </c:pt>
                <c:pt idx="76">
                  <c:v>118.79055370273808</c:v>
                </c:pt>
                <c:pt idx="77">
                  <c:v>125.01575874521355</c:v>
                </c:pt>
                <c:pt idx="78">
                  <c:v>135.015383659939</c:v>
                </c:pt>
                <c:pt idx="79">
                  <c:v>138.37640330268232</c:v>
                </c:pt>
                <c:pt idx="80">
                  <c:v>137.03288970230227</c:v>
                </c:pt>
                <c:pt idx="81">
                  <c:v>139.54155968136675</c:v>
                </c:pt>
                <c:pt idx="82">
                  <c:v>142.35864111058225</c:v>
                </c:pt>
                <c:pt idx="83">
                  <c:v>141.29290686685047</c:v>
                </c:pt>
                <c:pt idx="84">
                  <c:v>140.51217721468112</c:v>
                </c:pt>
                <c:pt idx="85">
                  <c:v>143.66569681828918</c:v>
                </c:pt>
                <c:pt idx="86">
                  <c:v>139.18708433516548</c:v>
                </c:pt>
                <c:pt idx="87">
                  <c:v>144.41412887565079</c:v>
                </c:pt>
                <c:pt idx="88">
                  <c:v>140.71140157824516</c:v>
                </c:pt>
                <c:pt idx="89">
                  <c:v>140.33080688689023</c:v>
                </c:pt>
                <c:pt idx="90">
                  <c:v>143.8696205216348</c:v>
                </c:pt>
                <c:pt idx="91">
                  <c:v>139.8232712796852</c:v>
                </c:pt>
                <c:pt idx="92">
                  <c:v>139.58483507212011</c:v>
                </c:pt>
                <c:pt idx="93">
                  <c:v>138.47700027258034</c:v>
                </c:pt>
                <c:pt idx="94">
                  <c:v>136.6622707417925</c:v>
                </c:pt>
                <c:pt idx="95">
                  <c:v>135.77672853550933</c:v>
                </c:pt>
                <c:pt idx="96">
                  <c:v>132.48803034984581</c:v>
                </c:pt>
                <c:pt idx="97">
                  <c:v>138.55998508448812</c:v>
                </c:pt>
                <c:pt idx="98">
                  <c:v>131.97660396573337</c:v>
                </c:pt>
                <c:pt idx="99">
                  <c:v>130.78843118830991</c:v>
                </c:pt>
                <c:pt idx="100">
                  <c:v>131.47122452619286</c:v>
                </c:pt>
                <c:pt idx="101">
                  <c:v>131.95487297464047</c:v>
                </c:pt>
                <c:pt idx="102">
                  <c:v>131.78521989773142</c:v>
                </c:pt>
                <c:pt idx="103">
                  <c:v>130.32096781893358</c:v>
                </c:pt>
                <c:pt idx="104">
                  <c:v>133.77807859401966</c:v>
                </c:pt>
                <c:pt idx="105">
                  <c:v>130.40451931593267</c:v>
                </c:pt>
                <c:pt idx="106">
                  <c:v>128.93296598348888</c:v>
                </c:pt>
                <c:pt idx="107">
                  <c:v>124.82606436629483</c:v>
                </c:pt>
                <c:pt idx="108">
                  <c:v>127.54242443132399</c:v>
                </c:pt>
                <c:pt idx="109">
                  <c:v>126.61455706843445</c:v>
                </c:pt>
                <c:pt idx="110">
                  <c:v>124.58351278102394</c:v>
                </c:pt>
                <c:pt idx="111">
                  <c:v>122.78225238734535</c:v>
                </c:pt>
                <c:pt idx="112">
                  <c:v>126.50787168920175</c:v>
                </c:pt>
                <c:pt idx="113">
                  <c:v>124.09658516091993</c:v>
                </c:pt>
                <c:pt idx="114">
                  <c:v>122.6527821209658</c:v>
                </c:pt>
                <c:pt idx="115">
                  <c:v>122.61161452232032</c:v>
                </c:pt>
                <c:pt idx="116">
                  <c:v>123.40908211706468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5-102A-4513-9AE8-E64BC7E519D4}"/>
            </c:ext>
          </c:extLst>
        </c:ser>
        <c:ser>
          <c:idx val="3"/>
          <c:order val="5"/>
          <c:tx>
            <c:v>Tumour 72h after EBRT</c:v>
          </c:tx>
          <c:spPr>
            <a:ln w="19050" cap="rnd">
              <a:solidFill>
                <a:schemeClr val="tx1">
                  <a:lumMod val="85000"/>
                  <a:lumOff val="15000"/>
                </a:schemeClr>
              </a:solidFill>
              <a:round/>
            </a:ln>
            <a:effectLst/>
          </c:spPr>
          <c:marker>
            <c:symbol val="diamond"/>
            <c:size val="9"/>
            <c:spPr>
              <a:solidFill>
                <a:schemeClr val="tx1">
                  <a:lumMod val="85000"/>
                  <a:lumOff val="15000"/>
                </a:schemeClr>
              </a:solidFill>
              <a:ln w="9525">
                <a:solidFill>
                  <a:schemeClr val="tx1">
                    <a:lumMod val="85000"/>
                    <a:lumOff val="15000"/>
                  </a:schemeClr>
                </a:solidFill>
              </a:ln>
              <a:effectLst/>
            </c:spPr>
          </c:marker>
          <c:xVal>
            <c:numRef>
              <c:f>'Vessel permeability'!$O$5:$O$64</c:f>
              <c:numCache>
                <c:formatCode>General</c:formatCode>
                <c:ptCount val="60"/>
                <c:pt idx="0">
                  <c:v>0</c:v>
                </c:pt>
                <c:pt idx="1">
                  <c:v>9</c:v>
                </c:pt>
                <c:pt idx="2">
                  <c:v>18</c:v>
                </c:pt>
                <c:pt idx="3">
                  <c:v>27</c:v>
                </c:pt>
                <c:pt idx="4">
                  <c:v>36</c:v>
                </c:pt>
                <c:pt idx="5">
                  <c:v>45</c:v>
                </c:pt>
                <c:pt idx="6">
                  <c:v>54</c:v>
                </c:pt>
                <c:pt idx="7">
                  <c:v>63</c:v>
                </c:pt>
                <c:pt idx="8">
                  <c:v>72</c:v>
                </c:pt>
                <c:pt idx="9">
                  <c:v>81</c:v>
                </c:pt>
                <c:pt idx="10">
                  <c:v>90</c:v>
                </c:pt>
                <c:pt idx="11">
                  <c:v>99</c:v>
                </c:pt>
                <c:pt idx="12">
                  <c:v>108</c:v>
                </c:pt>
                <c:pt idx="13">
                  <c:v>117</c:v>
                </c:pt>
                <c:pt idx="14">
                  <c:v>126</c:v>
                </c:pt>
                <c:pt idx="15">
                  <c:v>135</c:v>
                </c:pt>
                <c:pt idx="16">
                  <c:v>144</c:v>
                </c:pt>
                <c:pt idx="17">
                  <c:v>153</c:v>
                </c:pt>
                <c:pt idx="18">
                  <c:v>162</c:v>
                </c:pt>
                <c:pt idx="19">
                  <c:v>171</c:v>
                </c:pt>
                <c:pt idx="20">
                  <c:v>180</c:v>
                </c:pt>
                <c:pt idx="21">
                  <c:v>189</c:v>
                </c:pt>
                <c:pt idx="22">
                  <c:v>198</c:v>
                </c:pt>
                <c:pt idx="23">
                  <c:v>207</c:v>
                </c:pt>
                <c:pt idx="24">
                  <c:v>216</c:v>
                </c:pt>
                <c:pt idx="25">
                  <c:v>225</c:v>
                </c:pt>
                <c:pt idx="26">
                  <c:v>234</c:v>
                </c:pt>
                <c:pt idx="27">
                  <c:v>243</c:v>
                </c:pt>
                <c:pt idx="28">
                  <c:v>252</c:v>
                </c:pt>
                <c:pt idx="29">
                  <c:v>261</c:v>
                </c:pt>
                <c:pt idx="30">
                  <c:v>270</c:v>
                </c:pt>
                <c:pt idx="31">
                  <c:v>279</c:v>
                </c:pt>
                <c:pt idx="32">
                  <c:v>288</c:v>
                </c:pt>
                <c:pt idx="33">
                  <c:v>297</c:v>
                </c:pt>
                <c:pt idx="34">
                  <c:v>306</c:v>
                </c:pt>
                <c:pt idx="35">
                  <c:v>315</c:v>
                </c:pt>
                <c:pt idx="36">
                  <c:v>324</c:v>
                </c:pt>
                <c:pt idx="37">
                  <c:v>333</c:v>
                </c:pt>
                <c:pt idx="38">
                  <c:v>342</c:v>
                </c:pt>
                <c:pt idx="39">
                  <c:v>351</c:v>
                </c:pt>
                <c:pt idx="40">
                  <c:v>360</c:v>
                </c:pt>
                <c:pt idx="41">
                  <c:v>369</c:v>
                </c:pt>
                <c:pt idx="42">
                  <c:v>378</c:v>
                </c:pt>
                <c:pt idx="43">
                  <c:v>387</c:v>
                </c:pt>
                <c:pt idx="44">
                  <c:v>396</c:v>
                </c:pt>
                <c:pt idx="45">
                  <c:v>405</c:v>
                </c:pt>
                <c:pt idx="46">
                  <c:v>414</c:v>
                </c:pt>
                <c:pt idx="47">
                  <c:v>423</c:v>
                </c:pt>
                <c:pt idx="48">
                  <c:v>432</c:v>
                </c:pt>
                <c:pt idx="49">
                  <c:v>441</c:v>
                </c:pt>
                <c:pt idx="50">
                  <c:v>450</c:v>
                </c:pt>
                <c:pt idx="51">
                  <c:v>459</c:v>
                </c:pt>
                <c:pt idx="52">
                  <c:v>468</c:v>
                </c:pt>
                <c:pt idx="53">
                  <c:v>477</c:v>
                </c:pt>
                <c:pt idx="54">
                  <c:v>486</c:v>
                </c:pt>
                <c:pt idx="55">
                  <c:v>495</c:v>
                </c:pt>
                <c:pt idx="56">
                  <c:v>504</c:v>
                </c:pt>
                <c:pt idx="57">
                  <c:v>513</c:v>
                </c:pt>
                <c:pt idx="58">
                  <c:v>522</c:v>
                </c:pt>
                <c:pt idx="59">
                  <c:v>531</c:v>
                </c:pt>
              </c:numCache>
            </c:numRef>
          </c:xVal>
          <c:yVal>
            <c:numRef>
              <c:f>'Vessel permeability'!$AD$5:$AD$152</c:f>
              <c:numCache>
                <c:formatCode>General</c:formatCode>
                <c:ptCount val="148"/>
                <c:pt idx="0">
                  <c:v>100.41778137492481</c:v>
                </c:pt>
                <c:pt idx="1">
                  <c:v>98.953252347964622</c:v>
                </c:pt>
                <c:pt idx="2">
                  <c:v>101.133071958447</c:v>
                </c:pt>
                <c:pt idx="3">
                  <c:v>100.03196780052312</c:v>
                </c:pt>
                <c:pt idx="4">
                  <c:v>100.21963303815298</c:v>
                </c:pt>
                <c:pt idx="5">
                  <c:v>99.313788162371097</c:v>
                </c:pt>
                <c:pt idx="6">
                  <c:v>98.994116029202033</c:v>
                </c:pt>
                <c:pt idx="7">
                  <c:v>100.53311161365785</c:v>
                </c:pt>
                <c:pt idx="8">
                  <c:v>100.21840577714154</c:v>
                </c:pt>
                <c:pt idx="9">
                  <c:v>100.1848718976148</c:v>
                </c:pt>
                <c:pt idx="10">
                  <c:v>100.52362676509932</c:v>
                </c:pt>
                <c:pt idx="11">
                  <c:v>120.08838692699959</c:v>
                </c:pt>
                <c:pt idx="12">
                  <c:v>138.71743543646994</c:v>
                </c:pt>
                <c:pt idx="13">
                  <c:v>147.19460581556595</c:v>
                </c:pt>
                <c:pt idx="14">
                  <c:v>152.77033591754571</c:v>
                </c:pt>
                <c:pt idx="15">
                  <c:v>156.61439192428898</c:v>
                </c:pt>
                <c:pt idx="16">
                  <c:v>159.68925328401832</c:v>
                </c:pt>
                <c:pt idx="17">
                  <c:v>161.86246682446304</c:v>
                </c:pt>
                <c:pt idx="18">
                  <c:v>163.72012601539552</c:v>
                </c:pt>
                <c:pt idx="19">
                  <c:v>165.43488269927329</c:v>
                </c:pt>
                <c:pt idx="20">
                  <c:v>166.66677676783394</c:v>
                </c:pt>
                <c:pt idx="21">
                  <c:v>167.23059897348597</c:v>
                </c:pt>
                <c:pt idx="22">
                  <c:v>167.66404231285918</c:v>
                </c:pt>
                <c:pt idx="23">
                  <c:v>168.49564964157341</c:v>
                </c:pt>
                <c:pt idx="24">
                  <c:v>169.95842438993469</c:v>
                </c:pt>
                <c:pt idx="25">
                  <c:v>170.37123477055692</c:v>
                </c:pt>
                <c:pt idx="26">
                  <c:v>170.91372377403405</c:v>
                </c:pt>
                <c:pt idx="27">
                  <c:v>170.22849227719874</c:v>
                </c:pt>
                <c:pt idx="28">
                  <c:v>169.92338579445493</c:v>
                </c:pt>
                <c:pt idx="29">
                  <c:v>171.02557921992724</c:v>
                </c:pt>
                <c:pt idx="30">
                  <c:v>170.51629232445947</c:v>
                </c:pt>
                <c:pt idx="31">
                  <c:v>171.52192849423022</c:v>
                </c:pt>
                <c:pt idx="32">
                  <c:v>172.07712610844422</c:v>
                </c:pt>
                <c:pt idx="33">
                  <c:v>171.87023867502032</c:v>
                </c:pt>
                <c:pt idx="34">
                  <c:v>172.36278138496601</c:v>
                </c:pt>
                <c:pt idx="35">
                  <c:v>171.2502545979392</c:v>
                </c:pt>
                <c:pt idx="36">
                  <c:v>171.7536341987778</c:v>
                </c:pt>
                <c:pt idx="37">
                  <c:v>172.51222096532683</c:v>
                </c:pt>
                <c:pt idx="38">
                  <c:v>173.01749283822733</c:v>
                </c:pt>
                <c:pt idx="39">
                  <c:v>172.30817707805028</c:v>
                </c:pt>
                <c:pt idx="40">
                  <c:v>172.265306619537</c:v>
                </c:pt>
                <c:pt idx="41">
                  <c:v>172.16097475340888</c:v>
                </c:pt>
                <c:pt idx="42">
                  <c:v>173.10394574280238</c:v>
                </c:pt>
                <c:pt idx="43">
                  <c:v>172.86097742284835</c:v>
                </c:pt>
                <c:pt idx="44">
                  <c:v>172.10125588026844</c:v>
                </c:pt>
                <c:pt idx="45">
                  <c:v>172.2756869575895</c:v>
                </c:pt>
                <c:pt idx="46">
                  <c:v>172.48258466712232</c:v>
                </c:pt>
                <c:pt idx="47">
                  <c:v>172.02759232728627</c:v>
                </c:pt>
                <c:pt idx="48">
                  <c:v>172.40640787149474</c:v>
                </c:pt>
                <c:pt idx="49">
                  <c:v>172.18160771215983</c:v>
                </c:pt>
                <c:pt idx="50">
                  <c:v>172.46931527444002</c:v>
                </c:pt>
                <c:pt idx="51">
                  <c:v>172.38475464192683</c:v>
                </c:pt>
                <c:pt idx="52">
                  <c:v>171.01485536623281</c:v>
                </c:pt>
                <c:pt idx="53">
                  <c:v>171.22204080681615</c:v>
                </c:pt>
                <c:pt idx="54">
                  <c:v>171.81151805246333</c:v>
                </c:pt>
                <c:pt idx="55">
                  <c:v>172.14041079138943</c:v>
                </c:pt>
                <c:pt idx="56">
                  <c:v>171.8358665586066</c:v>
                </c:pt>
                <c:pt idx="57">
                  <c:v>172.13918353037798</c:v>
                </c:pt>
                <c:pt idx="58">
                  <c:v>170.92713116017936</c:v>
                </c:pt>
                <c:pt idx="59">
                  <c:v>172.70215575501851</c:v>
                </c:pt>
                <c:pt idx="65">
                  <c:v>100.49635799190517</c:v>
                </c:pt>
                <c:pt idx="66">
                  <c:v>99.152833753854409</c:v>
                </c:pt>
                <c:pt idx="67">
                  <c:v>100.30524468753576</c:v>
                </c:pt>
                <c:pt idx="68">
                  <c:v>100.51328330588581</c:v>
                </c:pt>
                <c:pt idx="69">
                  <c:v>100.21524823889973</c:v>
                </c:pt>
                <c:pt idx="70">
                  <c:v>99.88500166787658</c:v>
                </c:pt>
                <c:pt idx="71">
                  <c:v>100.36270336102187</c:v>
                </c:pt>
                <c:pt idx="72">
                  <c:v>99.61251673637291</c:v>
                </c:pt>
                <c:pt idx="73">
                  <c:v>99.311751090906426</c:v>
                </c:pt>
                <c:pt idx="74">
                  <c:v>100.14505916574143</c:v>
                </c:pt>
                <c:pt idx="75">
                  <c:v>99.473278596861462</c:v>
                </c:pt>
                <c:pt idx="76">
                  <c:v>139.37800106184548</c:v>
                </c:pt>
                <c:pt idx="77">
                  <c:v>154.99756251202555</c:v>
                </c:pt>
                <c:pt idx="78">
                  <c:v>164.77023492027016</c:v>
                </c:pt>
                <c:pt idx="79">
                  <c:v>169.58816586086022</c:v>
                </c:pt>
                <c:pt idx="80">
                  <c:v>173.61835209911095</c:v>
                </c:pt>
                <c:pt idx="81">
                  <c:v>175.17206873327476</c:v>
                </c:pt>
                <c:pt idx="82">
                  <c:v>178.53563259357296</c:v>
                </c:pt>
                <c:pt idx="83">
                  <c:v>177.99885640809683</c:v>
                </c:pt>
                <c:pt idx="84">
                  <c:v>178.9956030054052</c:v>
                </c:pt>
                <c:pt idx="85">
                  <c:v>181.80746183472303</c:v>
                </c:pt>
                <c:pt idx="86">
                  <c:v>182.16611147137638</c:v>
                </c:pt>
                <c:pt idx="87">
                  <c:v>181.52940893131091</c:v>
                </c:pt>
                <c:pt idx="88">
                  <c:v>183.42596658987301</c:v>
                </c:pt>
                <c:pt idx="89">
                  <c:v>183.16182681891723</c:v>
                </c:pt>
                <c:pt idx="90">
                  <c:v>184.32876458548157</c:v>
                </c:pt>
                <c:pt idx="91">
                  <c:v>182.59083683465772</c:v>
                </c:pt>
                <c:pt idx="92">
                  <c:v>184.09398533050506</c:v>
                </c:pt>
                <c:pt idx="93">
                  <c:v>183.33139457729683</c:v>
                </c:pt>
                <c:pt idx="94">
                  <c:v>181.90494504014572</c:v>
                </c:pt>
                <c:pt idx="95">
                  <c:v>184.81439388983389</c:v>
                </c:pt>
                <c:pt idx="96">
                  <c:v>184.60117377547689</c:v>
                </c:pt>
                <c:pt idx="97">
                  <c:v>183.77033798115795</c:v>
                </c:pt>
                <c:pt idx="98">
                  <c:v>184.85464564629547</c:v>
                </c:pt>
                <c:pt idx="99">
                  <c:v>185.41381607107292</c:v>
                </c:pt>
                <c:pt idx="100">
                  <c:v>185.12775204658558</c:v>
                </c:pt>
                <c:pt idx="101">
                  <c:v>185.45006323804191</c:v>
                </c:pt>
                <c:pt idx="102">
                  <c:v>185.90624269027686</c:v>
                </c:pt>
                <c:pt idx="103">
                  <c:v>184.88567441754836</c:v>
                </c:pt>
                <c:pt idx="104">
                  <c:v>184.35370878889725</c:v>
                </c:pt>
                <c:pt idx="105">
                  <c:v>185.26339537758548</c:v>
                </c:pt>
                <c:pt idx="106">
                  <c:v>184.45955269158748</c:v>
                </c:pt>
                <c:pt idx="107">
                  <c:v>184.46892910190283</c:v>
                </c:pt>
                <c:pt idx="108">
                  <c:v>183.23198481863619</c:v>
                </c:pt>
                <c:pt idx="109">
                  <c:v>185.60574893740443</c:v>
                </c:pt>
                <c:pt idx="110">
                  <c:v>184.88297297041731</c:v>
                </c:pt>
                <c:pt idx="111">
                  <c:v>184.08627717546329</c:v>
                </c:pt>
                <c:pt idx="112">
                  <c:v>184.41851050451311</c:v>
                </c:pt>
                <c:pt idx="113">
                  <c:v>182.58208189312882</c:v>
                </c:pt>
                <c:pt idx="114">
                  <c:v>184.20944840475539</c:v>
                </c:pt>
                <c:pt idx="115">
                  <c:v>184.34452852966757</c:v>
                </c:pt>
                <c:pt idx="116">
                  <c:v>184.88567441754836</c:v>
                </c:pt>
                <c:pt idx="117">
                  <c:v>184.35370878889725</c:v>
                </c:pt>
                <c:pt idx="118">
                  <c:v>185.26339537758548</c:v>
                </c:pt>
                <c:pt idx="119">
                  <c:v>184.45955269158748</c:v>
                </c:pt>
                <c:pt idx="120">
                  <c:v>184.46892910190283</c:v>
                </c:pt>
                <c:pt idx="121">
                  <c:v>184.45955269158748</c:v>
                </c:pt>
                <c:pt idx="122">
                  <c:v>184.46892910190283</c:v>
                </c:pt>
                <c:pt idx="123">
                  <c:v>183.23198481863619</c:v>
                </c:pt>
                <c:pt idx="124">
                  <c:v>184.34452852966757</c:v>
                </c:pt>
                <c:pt idx="131">
                  <c:v>101.14786431933251</c:v>
                </c:pt>
                <c:pt idx="132">
                  <c:v>98.873702876680355</c:v>
                </c:pt>
                <c:pt idx="133">
                  <c:v>100.6478643666139</c:v>
                </c:pt>
                <c:pt idx="134">
                  <c:v>101.2342139115962</c:v>
                </c:pt>
                <c:pt idx="135">
                  <c:v>99.299551838515328</c:v>
                </c:pt>
                <c:pt idx="136">
                  <c:v>100.49211771339132</c:v>
                </c:pt>
                <c:pt idx="137">
                  <c:v>99.331747893405108</c:v>
                </c:pt>
                <c:pt idx="138">
                  <c:v>99.904726258270031</c:v>
                </c:pt>
                <c:pt idx="139">
                  <c:v>98.611110573822444</c:v>
                </c:pt>
                <c:pt idx="140">
                  <c:v>100.45710024837263</c:v>
                </c:pt>
                <c:pt idx="141">
                  <c:v>99.703833604337404</c:v>
                </c:pt>
                <c:pt idx="142">
                  <c:v>167.94866574079364</c:v>
                </c:pt>
                <c:pt idx="143">
                  <c:v>189.23690148957127</c:v>
                </c:pt>
                <c:pt idx="144">
                  <c:v>200.98258315674369</c:v>
                </c:pt>
                <c:pt idx="145">
                  <c:v>207.80461702190084</c:v>
                </c:pt>
                <c:pt idx="146">
                  <c:v>209.95033295175523</c:v>
                </c:pt>
                <c:pt idx="147">
                  <c:v>211.7726286269229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102A-4513-9AE8-E64BC7E519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21012976"/>
        <c:axId val="165558392"/>
      </c:scatterChart>
      <c:valAx>
        <c:axId val="121012976"/>
        <c:scaling>
          <c:orientation val="minMax"/>
          <c:max val="500"/>
          <c:min val="0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en-GB"/>
                  <a:t>Time (sec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65558392"/>
        <c:crosses val="autoZero"/>
        <c:crossBetween val="midCat"/>
        <c:majorUnit val="100"/>
        <c:minorUnit val="45"/>
      </c:valAx>
      <c:valAx>
        <c:axId val="165558392"/>
        <c:scaling>
          <c:orientation val="minMax"/>
          <c:max val="190"/>
          <c:min val="9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Normalized T1 signal enhancement (%)</a:t>
                </a:r>
              </a:p>
            </c:rich>
          </c:tx>
          <c:layout>
            <c:manualLayout>
              <c:xMode val="edge"/>
              <c:yMode val="edge"/>
              <c:x val="6.3051049883346297E-2"/>
              <c:y val="0.1435348569870510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21012976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1466607756610967"/>
          <c:y val="4.0766970407975597E-2"/>
          <c:w val="0.78180826410843063"/>
          <c:h val="0.20708336968183633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300907805115671"/>
          <c:y val="0.209324183460737"/>
          <c:w val="0.67443396602656702"/>
          <c:h val="0.6312107173191260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C00000">
                <a:alpha val="70000"/>
              </a:srgbClr>
            </a:solidFill>
            <a:ln>
              <a:solidFill>
                <a:sysClr val="window" lastClr="FFFFFF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4F81BD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B833-4BE3-874E-8297F51EB437}"/>
              </c:ext>
            </c:extLst>
          </c:dPt>
          <c:dPt>
            <c:idx val="1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B833-4BE3-874E-8297F51EB437}"/>
              </c:ext>
            </c:extLst>
          </c:dPt>
          <c:dPt>
            <c:idx val="2"/>
            <c:invertIfNegative val="0"/>
            <c:bubble3D val="0"/>
            <c:spPr>
              <a:solidFill>
                <a:sysClr val="windowText" lastClr="000000"/>
              </a:solidFill>
              <a:ln>
                <a:solidFill>
                  <a:sysClr val="window" lastClr="FFFF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B833-4BE3-874E-8297F51EB437}"/>
              </c:ext>
            </c:extLst>
          </c:dPt>
          <c:cat>
            <c:strRef>
              <c:f>'Vessel permeability'!$D$6:$F$6</c:f>
              <c:strCache>
                <c:ptCount val="3"/>
                <c:pt idx="0">
                  <c:v>Before EBRT</c:v>
                </c:pt>
                <c:pt idx="1">
                  <c:v>24h after EBRT</c:v>
                </c:pt>
                <c:pt idx="2">
                  <c:v>72h after EBRT</c:v>
                </c:pt>
              </c:strCache>
            </c:strRef>
          </c:cat>
          <c:val>
            <c:numRef>
              <c:f>'Vessel permeability'!$D$8:$F$8</c:f>
              <c:numCache>
                <c:formatCode>General</c:formatCode>
                <c:ptCount val="3"/>
                <c:pt idx="0">
                  <c:v>142</c:v>
                </c:pt>
                <c:pt idx="1">
                  <c:v>182</c:v>
                </c:pt>
                <c:pt idx="2">
                  <c:v>17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B833-4BE3-874E-8297F51EB4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37"/>
        <c:axId val="165559960"/>
        <c:axId val="165559568"/>
      </c:barChart>
      <c:catAx>
        <c:axId val="1655599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65559568"/>
        <c:crosses val="autoZero"/>
        <c:auto val="1"/>
        <c:lblAlgn val="ctr"/>
        <c:lblOffset val="100"/>
        <c:noMultiLvlLbl val="0"/>
      </c:catAx>
      <c:valAx>
        <c:axId val="165559568"/>
        <c:scaling>
          <c:orientation val="minMax"/>
          <c:min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Normalized T1 signal enhancement (%)</a:t>
                </a:r>
              </a:p>
            </c:rich>
          </c:tx>
          <c:layout>
            <c:manualLayout>
              <c:xMode val="edge"/>
              <c:yMode val="edge"/>
              <c:x val="0.13726555311518099"/>
              <c:y val="0.1495482974287699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65559960"/>
        <c:crosses val="autoZero"/>
        <c:crossBetween val="between"/>
        <c:majorUnit val="4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 baseline="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300907805115671"/>
          <c:y val="0.209324183460737"/>
          <c:w val="0.67443396602656702"/>
          <c:h val="0.6312107173191260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C00000">
                <a:alpha val="70000"/>
              </a:srgbClr>
            </a:solidFill>
            <a:ln>
              <a:solidFill>
                <a:sysClr val="window" lastClr="FFFFFF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4F81BD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B833-4BE3-874E-8297F51EB437}"/>
              </c:ext>
            </c:extLst>
          </c:dPt>
          <c:dPt>
            <c:idx val="1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B833-4BE3-874E-8297F51EB437}"/>
              </c:ext>
            </c:extLst>
          </c:dPt>
          <c:dPt>
            <c:idx val="2"/>
            <c:invertIfNegative val="0"/>
            <c:bubble3D val="0"/>
            <c:spPr>
              <a:solidFill>
                <a:sysClr val="windowText" lastClr="000000"/>
              </a:solidFill>
              <a:ln>
                <a:solidFill>
                  <a:sysClr val="window" lastClr="FFFF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B833-4BE3-874E-8297F51EB437}"/>
              </c:ext>
            </c:extLst>
          </c:dPt>
          <c:cat>
            <c:strRef>
              <c:f>'Vessel permeability'!$D$6:$F$6</c:f>
              <c:strCache>
                <c:ptCount val="3"/>
                <c:pt idx="0">
                  <c:v>Before EBRT</c:v>
                </c:pt>
                <c:pt idx="1">
                  <c:v>24h after EBRT</c:v>
                </c:pt>
                <c:pt idx="2">
                  <c:v>72h after EBRT</c:v>
                </c:pt>
              </c:strCache>
            </c:strRef>
          </c:cat>
          <c:val>
            <c:numRef>
              <c:f>'Vessel permeability'!$D$10:$F$10</c:f>
              <c:numCache>
                <c:formatCode>General</c:formatCode>
                <c:ptCount val="3"/>
                <c:pt idx="0">
                  <c:v>160</c:v>
                </c:pt>
                <c:pt idx="1">
                  <c:v>203</c:v>
                </c:pt>
                <c:pt idx="2">
                  <c:v>17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B833-4BE3-874E-8297F51EB4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37"/>
        <c:axId val="165560744"/>
        <c:axId val="165561136"/>
      </c:barChart>
      <c:catAx>
        <c:axId val="1655607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65561136"/>
        <c:crosses val="autoZero"/>
        <c:auto val="1"/>
        <c:lblAlgn val="ctr"/>
        <c:lblOffset val="100"/>
        <c:noMultiLvlLbl val="0"/>
      </c:catAx>
      <c:valAx>
        <c:axId val="165561136"/>
        <c:scaling>
          <c:orientation val="minMax"/>
          <c:min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Normalized T1 signal enhancement (%)</a:t>
                </a:r>
              </a:p>
            </c:rich>
          </c:tx>
          <c:layout>
            <c:manualLayout>
              <c:xMode val="edge"/>
              <c:yMode val="edge"/>
              <c:x val="0.13726555311518099"/>
              <c:y val="0.1495482974287699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65560744"/>
        <c:crosses val="autoZero"/>
        <c:crossBetween val="between"/>
        <c:majorUnit val="4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 baseline="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300907805115671"/>
          <c:y val="0.209324183460737"/>
          <c:w val="0.67443396602656702"/>
          <c:h val="0.63121071731912604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rgbClr val="C00000">
                <a:alpha val="70000"/>
              </a:srgbClr>
            </a:solidFill>
            <a:ln>
              <a:solidFill>
                <a:sysClr val="window" lastClr="FFFFFF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4F81BD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B833-4BE3-874E-8297F51EB437}"/>
              </c:ext>
            </c:extLst>
          </c:dPt>
          <c:dPt>
            <c:idx val="1"/>
            <c:invertIfNegative val="0"/>
            <c:bubble3D val="0"/>
            <c:spPr>
              <a:solidFill>
                <a:srgbClr val="C0504D"/>
              </a:solidFill>
              <a:ln>
                <a:solidFill>
                  <a:sysClr val="window" lastClr="FFFF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B833-4BE3-874E-8297F51EB437}"/>
              </c:ext>
            </c:extLst>
          </c:dPt>
          <c:dPt>
            <c:idx val="2"/>
            <c:invertIfNegative val="0"/>
            <c:bubble3D val="0"/>
            <c:spPr>
              <a:solidFill>
                <a:sysClr val="windowText" lastClr="000000"/>
              </a:solidFill>
              <a:ln>
                <a:solidFill>
                  <a:sysClr val="window" lastClr="FFFFFF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B833-4BE3-874E-8297F51EB437}"/>
              </c:ext>
            </c:extLst>
          </c:dPt>
          <c:cat>
            <c:strRef>
              <c:f>'Vessel permeability'!$D$6:$F$6</c:f>
              <c:strCache>
                <c:ptCount val="3"/>
                <c:pt idx="0">
                  <c:v>Before EBRT</c:v>
                </c:pt>
                <c:pt idx="1">
                  <c:v>24h after EBRT</c:v>
                </c:pt>
                <c:pt idx="2">
                  <c:v>72h after EBRT</c:v>
                </c:pt>
              </c:strCache>
            </c:strRef>
          </c:cat>
          <c:val>
            <c:numRef>
              <c:f>'Vessel permeability'!$D$9:$F$9</c:f>
              <c:numCache>
                <c:formatCode>General</c:formatCode>
                <c:ptCount val="3"/>
                <c:pt idx="0">
                  <c:v>147</c:v>
                </c:pt>
                <c:pt idx="1">
                  <c:v>185</c:v>
                </c:pt>
                <c:pt idx="2">
                  <c:v>15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6-B833-4BE3-874E-8297F51EB4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37"/>
        <c:axId val="165561920"/>
        <c:axId val="165771800"/>
      </c:barChart>
      <c:catAx>
        <c:axId val="1655619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65771800"/>
        <c:crosses val="autoZero"/>
        <c:auto val="1"/>
        <c:lblAlgn val="ctr"/>
        <c:lblOffset val="100"/>
        <c:noMultiLvlLbl val="0"/>
      </c:catAx>
      <c:valAx>
        <c:axId val="165771800"/>
        <c:scaling>
          <c:orientation val="minMax"/>
          <c:min val="10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Normalized T1 signal enhancement (%)</a:t>
                </a:r>
              </a:p>
            </c:rich>
          </c:tx>
          <c:layout>
            <c:manualLayout>
              <c:xMode val="edge"/>
              <c:yMode val="edge"/>
              <c:x val="0.13726555311518099"/>
              <c:y val="0.1495482974287699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65561920"/>
        <c:crosses val="autoZero"/>
        <c:crossBetween val="between"/>
        <c:majorUnit val="4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 baseline="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981822303648699"/>
          <c:y val="0.25144742571404499"/>
          <c:w val="0.73673230752138652"/>
          <c:h val="0.54495696148418205"/>
        </c:manualLayout>
      </c:layout>
      <c:scatterChart>
        <c:scatterStyle val="smoothMarker"/>
        <c:varyColors val="0"/>
        <c:ser>
          <c:idx val="0"/>
          <c:order val="0"/>
          <c:tx>
            <c:v>Muscle before EBRT</c:v>
          </c:tx>
          <c:spPr>
            <a:ln w="19050" cap="rnd">
              <a:solidFill>
                <a:srgbClr val="9BBB59"/>
              </a:solidFill>
              <a:round/>
            </a:ln>
            <a:effectLst/>
          </c:spPr>
          <c:marker>
            <c:symbol val="x"/>
            <c:size val="9"/>
            <c:spPr>
              <a:solidFill>
                <a:srgbClr val="9BBB59"/>
              </a:solidFill>
              <a:ln w="25400">
                <a:solidFill>
                  <a:srgbClr val="9BBB59"/>
                </a:solidFill>
              </a:ln>
              <a:effectLst/>
            </c:spPr>
          </c:marker>
          <c:xVal>
            <c:numRef>
              <c:f>'Vessel permeability'!$O$5:$O$64</c:f>
              <c:numCache>
                <c:formatCode>General</c:formatCode>
                <c:ptCount val="60"/>
                <c:pt idx="0">
                  <c:v>0</c:v>
                </c:pt>
                <c:pt idx="1">
                  <c:v>9</c:v>
                </c:pt>
                <c:pt idx="2">
                  <c:v>18</c:v>
                </c:pt>
                <c:pt idx="3">
                  <c:v>27</c:v>
                </c:pt>
                <c:pt idx="4">
                  <c:v>36</c:v>
                </c:pt>
                <c:pt idx="5">
                  <c:v>45</c:v>
                </c:pt>
                <c:pt idx="6">
                  <c:v>54</c:v>
                </c:pt>
                <c:pt idx="7">
                  <c:v>63</c:v>
                </c:pt>
                <c:pt idx="8">
                  <c:v>72</c:v>
                </c:pt>
                <c:pt idx="9">
                  <c:v>81</c:v>
                </c:pt>
                <c:pt idx="10">
                  <c:v>90</c:v>
                </c:pt>
                <c:pt idx="11">
                  <c:v>99</c:v>
                </c:pt>
                <c:pt idx="12">
                  <c:v>108</c:v>
                </c:pt>
                <c:pt idx="13">
                  <c:v>117</c:v>
                </c:pt>
                <c:pt idx="14">
                  <c:v>126</c:v>
                </c:pt>
                <c:pt idx="15">
                  <c:v>135</c:v>
                </c:pt>
                <c:pt idx="16">
                  <c:v>144</c:v>
                </c:pt>
                <c:pt idx="17">
                  <c:v>153</c:v>
                </c:pt>
                <c:pt idx="18">
                  <c:v>162</c:v>
                </c:pt>
                <c:pt idx="19">
                  <c:v>171</c:v>
                </c:pt>
                <c:pt idx="20">
                  <c:v>180</c:v>
                </c:pt>
                <c:pt idx="21">
                  <c:v>189</c:v>
                </c:pt>
                <c:pt idx="22">
                  <c:v>198</c:v>
                </c:pt>
                <c:pt idx="23">
                  <c:v>207</c:v>
                </c:pt>
                <c:pt idx="24">
                  <c:v>216</c:v>
                </c:pt>
                <c:pt idx="25">
                  <c:v>225</c:v>
                </c:pt>
                <c:pt idx="26">
                  <c:v>234</c:v>
                </c:pt>
                <c:pt idx="27">
                  <c:v>243</c:v>
                </c:pt>
                <c:pt idx="28">
                  <c:v>252</c:v>
                </c:pt>
                <c:pt idx="29">
                  <c:v>261</c:v>
                </c:pt>
                <c:pt idx="30">
                  <c:v>270</c:v>
                </c:pt>
                <c:pt idx="31">
                  <c:v>279</c:v>
                </c:pt>
                <c:pt idx="32">
                  <c:v>288</c:v>
                </c:pt>
                <c:pt idx="33">
                  <c:v>297</c:v>
                </c:pt>
                <c:pt idx="34">
                  <c:v>306</c:v>
                </c:pt>
                <c:pt idx="35">
                  <c:v>315</c:v>
                </c:pt>
                <c:pt idx="36">
                  <c:v>324</c:v>
                </c:pt>
                <c:pt idx="37">
                  <c:v>333</c:v>
                </c:pt>
                <c:pt idx="38">
                  <c:v>342</c:v>
                </c:pt>
                <c:pt idx="39">
                  <c:v>351</c:v>
                </c:pt>
                <c:pt idx="40">
                  <c:v>360</c:v>
                </c:pt>
                <c:pt idx="41">
                  <c:v>369</c:v>
                </c:pt>
                <c:pt idx="42">
                  <c:v>378</c:v>
                </c:pt>
                <c:pt idx="43">
                  <c:v>387</c:v>
                </c:pt>
                <c:pt idx="44">
                  <c:v>396</c:v>
                </c:pt>
                <c:pt idx="45">
                  <c:v>405</c:v>
                </c:pt>
                <c:pt idx="46">
                  <c:v>414</c:v>
                </c:pt>
                <c:pt idx="47">
                  <c:v>423</c:v>
                </c:pt>
                <c:pt idx="48">
                  <c:v>432</c:v>
                </c:pt>
                <c:pt idx="49">
                  <c:v>441</c:v>
                </c:pt>
                <c:pt idx="50">
                  <c:v>450</c:v>
                </c:pt>
                <c:pt idx="51">
                  <c:v>459</c:v>
                </c:pt>
                <c:pt idx="52">
                  <c:v>468</c:v>
                </c:pt>
                <c:pt idx="53">
                  <c:v>477</c:v>
                </c:pt>
                <c:pt idx="54">
                  <c:v>486</c:v>
                </c:pt>
                <c:pt idx="55">
                  <c:v>495</c:v>
                </c:pt>
                <c:pt idx="56">
                  <c:v>504</c:v>
                </c:pt>
                <c:pt idx="57">
                  <c:v>513</c:v>
                </c:pt>
                <c:pt idx="58">
                  <c:v>522</c:v>
                </c:pt>
                <c:pt idx="59">
                  <c:v>531</c:v>
                </c:pt>
              </c:numCache>
            </c:numRef>
          </c:xVal>
          <c:yVal>
            <c:numRef>
              <c:f>'Vessel permeability'!$AU$136:$AU$195</c:f>
              <c:numCache>
                <c:formatCode>General</c:formatCode>
                <c:ptCount val="60"/>
                <c:pt idx="0">
                  <c:v>100.00109443228314</c:v>
                </c:pt>
                <c:pt idx="1">
                  <c:v>103.36418360496936</c:v>
                </c:pt>
                <c:pt idx="2">
                  <c:v>99.520452621170662</c:v>
                </c:pt>
                <c:pt idx="3">
                  <c:v>100.93218141081972</c:v>
                </c:pt>
                <c:pt idx="4">
                  <c:v>97.148255201069162</c:v>
                </c:pt>
                <c:pt idx="5">
                  <c:v>100.34339200993685</c:v>
                </c:pt>
                <c:pt idx="6">
                  <c:v>100.14552527392115</c:v>
                </c:pt>
                <c:pt idx="7">
                  <c:v>98.263381745371703</c:v>
                </c:pt>
                <c:pt idx="8">
                  <c:v>100.95931109003359</c:v>
                </c:pt>
                <c:pt idx="9">
                  <c:v>99.32222261042476</c:v>
                </c:pt>
                <c:pt idx="10">
                  <c:v>101.44683838310638</c:v>
                </c:pt>
                <c:pt idx="11">
                  <c:v>128.39194489764088</c:v>
                </c:pt>
                <c:pt idx="12">
                  <c:v>129.48998061606335</c:v>
                </c:pt>
                <c:pt idx="13">
                  <c:v>129.37479834959134</c:v>
                </c:pt>
                <c:pt idx="14">
                  <c:v>131.37563664756618</c:v>
                </c:pt>
                <c:pt idx="15">
                  <c:v>131.4069536569726</c:v>
                </c:pt>
                <c:pt idx="16">
                  <c:v>129.78817436841632</c:v>
                </c:pt>
                <c:pt idx="17">
                  <c:v>130.75116134204347</c:v>
                </c:pt>
                <c:pt idx="18">
                  <c:v>128.80237116905093</c:v>
                </c:pt>
                <c:pt idx="19">
                  <c:v>130.784105648663</c:v>
                </c:pt>
                <c:pt idx="20">
                  <c:v>129.51798358045212</c:v>
                </c:pt>
                <c:pt idx="21">
                  <c:v>130.11899022254062</c:v>
                </c:pt>
                <c:pt idx="22">
                  <c:v>129.84601111504503</c:v>
                </c:pt>
                <c:pt idx="23">
                  <c:v>128.14377361069938</c:v>
                </c:pt>
                <c:pt idx="24">
                  <c:v>128.10558289786485</c:v>
                </c:pt>
                <c:pt idx="25">
                  <c:v>127.80095633114207</c:v>
                </c:pt>
                <c:pt idx="26">
                  <c:v>129.2514459662448</c:v>
                </c:pt>
                <c:pt idx="27">
                  <c:v>128.40866700380258</c:v>
                </c:pt>
                <c:pt idx="28">
                  <c:v>128.90215334561719</c:v>
                </c:pt>
                <c:pt idx="29">
                  <c:v>131.96576925573092</c:v>
                </c:pt>
                <c:pt idx="30">
                  <c:v>128.62435158010089</c:v>
                </c:pt>
                <c:pt idx="31">
                  <c:v>129.78928461906156</c:v>
                </c:pt>
                <c:pt idx="32">
                  <c:v>128.83823962027591</c:v>
                </c:pt>
                <c:pt idx="33">
                  <c:v>128.41904959396803</c:v>
                </c:pt>
                <c:pt idx="34">
                  <c:v>128.50044830240446</c:v>
                </c:pt>
                <c:pt idx="35">
                  <c:v>129.20991603952902</c:v>
                </c:pt>
                <c:pt idx="36">
                  <c:v>125.93756541405466</c:v>
                </c:pt>
                <c:pt idx="37">
                  <c:v>127.68322289658585</c:v>
                </c:pt>
                <c:pt idx="38">
                  <c:v>125.8766689147194</c:v>
                </c:pt>
                <c:pt idx="39">
                  <c:v>126.3122759832048</c:v>
                </c:pt>
                <c:pt idx="40">
                  <c:v>127.19405062816963</c:v>
                </c:pt>
                <c:pt idx="41">
                  <c:v>124.07016548755306</c:v>
                </c:pt>
                <c:pt idx="42">
                  <c:v>125.68859740239762</c:v>
                </c:pt>
                <c:pt idx="43">
                  <c:v>127.44905330881168</c:v>
                </c:pt>
                <c:pt idx="44">
                  <c:v>127.1702430529692</c:v>
                </c:pt>
                <c:pt idx="45">
                  <c:v>127.391953836307</c:v>
                </c:pt>
                <c:pt idx="46">
                  <c:v>124.94515126551784</c:v>
                </c:pt>
                <c:pt idx="47">
                  <c:v>127.03323634416708</c:v>
                </c:pt>
                <c:pt idx="48">
                  <c:v>125.25672791015126</c:v>
                </c:pt>
                <c:pt idx="49">
                  <c:v>128.76927433043932</c:v>
                </c:pt>
                <c:pt idx="50">
                  <c:v>125.04017869660041</c:v>
                </c:pt>
                <c:pt idx="51">
                  <c:v>126.09887114181555</c:v>
                </c:pt>
                <c:pt idx="52">
                  <c:v>126.84126626166862</c:v>
                </c:pt>
                <c:pt idx="53">
                  <c:v>126.79145556186783</c:v>
                </c:pt>
                <c:pt idx="54">
                  <c:v>125.37922433516371</c:v>
                </c:pt>
                <c:pt idx="55">
                  <c:v>127.6761458894926</c:v>
                </c:pt>
                <c:pt idx="56">
                  <c:v>126.28368805971118</c:v>
                </c:pt>
                <c:pt idx="57">
                  <c:v>126.95363438882683</c:v>
                </c:pt>
                <c:pt idx="58">
                  <c:v>124.40428692474954</c:v>
                </c:pt>
                <c:pt idx="59">
                  <c:v>127.447078420913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102A-4513-9AE8-E64BC7E519D4}"/>
            </c:ext>
          </c:extLst>
        </c:ser>
        <c:ser>
          <c:idx val="1"/>
          <c:order val="1"/>
          <c:tx>
            <c:v>Tumour before EBRT</c:v>
          </c:tx>
          <c:spPr>
            <a:ln w="19050" cap="rnd">
              <a:solidFill>
                <a:srgbClr val="4F81BD"/>
              </a:solidFill>
              <a:round/>
            </a:ln>
            <a:effectLst/>
          </c:spPr>
          <c:marker>
            <c:symbol val="triangle"/>
            <c:size val="9"/>
            <c:spPr>
              <a:solidFill>
                <a:srgbClr val="4F81BD"/>
              </a:solidFill>
              <a:ln w="25400">
                <a:solidFill>
                  <a:srgbClr val="4F81BD"/>
                </a:solidFill>
              </a:ln>
              <a:effectLst/>
            </c:spPr>
          </c:marker>
          <c:xVal>
            <c:numRef>
              <c:f>'Vessel permeability'!$O$5:$O$64</c:f>
              <c:numCache>
                <c:formatCode>General</c:formatCode>
                <c:ptCount val="60"/>
                <c:pt idx="0">
                  <c:v>0</c:v>
                </c:pt>
                <c:pt idx="1">
                  <c:v>9</c:v>
                </c:pt>
                <c:pt idx="2">
                  <c:v>18</c:v>
                </c:pt>
                <c:pt idx="3">
                  <c:v>27</c:v>
                </c:pt>
                <c:pt idx="4">
                  <c:v>36</c:v>
                </c:pt>
                <c:pt idx="5">
                  <c:v>45</c:v>
                </c:pt>
                <c:pt idx="6">
                  <c:v>54</c:v>
                </c:pt>
                <c:pt idx="7">
                  <c:v>63</c:v>
                </c:pt>
                <c:pt idx="8">
                  <c:v>72</c:v>
                </c:pt>
                <c:pt idx="9">
                  <c:v>81</c:v>
                </c:pt>
                <c:pt idx="10">
                  <c:v>90</c:v>
                </c:pt>
                <c:pt idx="11">
                  <c:v>99</c:v>
                </c:pt>
                <c:pt idx="12">
                  <c:v>108</c:v>
                </c:pt>
                <c:pt idx="13">
                  <c:v>117</c:v>
                </c:pt>
                <c:pt idx="14">
                  <c:v>126</c:v>
                </c:pt>
                <c:pt idx="15">
                  <c:v>135</c:v>
                </c:pt>
                <c:pt idx="16">
                  <c:v>144</c:v>
                </c:pt>
                <c:pt idx="17">
                  <c:v>153</c:v>
                </c:pt>
                <c:pt idx="18">
                  <c:v>162</c:v>
                </c:pt>
                <c:pt idx="19">
                  <c:v>171</c:v>
                </c:pt>
                <c:pt idx="20">
                  <c:v>180</c:v>
                </c:pt>
                <c:pt idx="21">
                  <c:v>189</c:v>
                </c:pt>
                <c:pt idx="22">
                  <c:v>198</c:v>
                </c:pt>
                <c:pt idx="23">
                  <c:v>207</c:v>
                </c:pt>
                <c:pt idx="24">
                  <c:v>216</c:v>
                </c:pt>
                <c:pt idx="25">
                  <c:v>225</c:v>
                </c:pt>
                <c:pt idx="26">
                  <c:v>234</c:v>
                </c:pt>
                <c:pt idx="27">
                  <c:v>243</c:v>
                </c:pt>
                <c:pt idx="28">
                  <c:v>252</c:v>
                </c:pt>
                <c:pt idx="29">
                  <c:v>261</c:v>
                </c:pt>
                <c:pt idx="30">
                  <c:v>270</c:v>
                </c:pt>
                <c:pt idx="31">
                  <c:v>279</c:v>
                </c:pt>
                <c:pt idx="32">
                  <c:v>288</c:v>
                </c:pt>
                <c:pt idx="33">
                  <c:v>297</c:v>
                </c:pt>
                <c:pt idx="34">
                  <c:v>306</c:v>
                </c:pt>
                <c:pt idx="35">
                  <c:v>315</c:v>
                </c:pt>
                <c:pt idx="36">
                  <c:v>324</c:v>
                </c:pt>
                <c:pt idx="37">
                  <c:v>333</c:v>
                </c:pt>
                <c:pt idx="38">
                  <c:v>342</c:v>
                </c:pt>
                <c:pt idx="39">
                  <c:v>351</c:v>
                </c:pt>
                <c:pt idx="40">
                  <c:v>360</c:v>
                </c:pt>
                <c:pt idx="41">
                  <c:v>369</c:v>
                </c:pt>
                <c:pt idx="42">
                  <c:v>378</c:v>
                </c:pt>
                <c:pt idx="43">
                  <c:v>387</c:v>
                </c:pt>
                <c:pt idx="44">
                  <c:v>396</c:v>
                </c:pt>
                <c:pt idx="45">
                  <c:v>405</c:v>
                </c:pt>
                <c:pt idx="46">
                  <c:v>414</c:v>
                </c:pt>
                <c:pt idx="47">
                  <c:v>423</c:v>
                </c:pt>
                <c:pt idx="48">
                  <c:v>432</c:v>
                </c:pt>
                <c:pt idx="49">
                  <c:v>441</c:v>
                </c:pt>
                <c:pt idx="50">
                  <c:v>450</c:v>
                </c:pt>
                <c:pt idx="51">
                  <c:v>459</c:v>
                </c:pt>
                <c:pt idx="52">
                  <c:v>468</c:v>
                </c:pt>
                <c:pt idx="53">
                  <c:v>477</c:v>
                </c:pt>
                <c:pt idx="54">
                  <c:v>486</c:v>
                </c:pt>
                <c:pt idx="55">
                  <c:v>495</c:v>
                </c:pt>
                <c:pt idx="56">
                  <c:v>504</c:v>
                </c:pt>
                <c:pt idx="57">
                  <c:v>513</c:v>
                </c:pt>
                <c:pt idx="58">
                  <c:v>522</c:v>
                </c:pt>
                <c:pt idx="59">
                  <c:v>531</c:v>
                </c:pt>
              </c:numCache>
            </c:numRef>
          </c:xVal>
          <c:yVal>
            <c:numRef>
              <c:f>'Vessel permeability'!$Z$136:$Z$195</c:f>
              <c:numCache>
                <c:formatCode>General</c:formatCode>
                <c:ptCount val="60"/>
                <c:pt idx="0">
                  <c:v>99.44321246691284</c:v>
                </c:pt>
                <c:pt idx="1">
                  <c:v>100.80662919473254</c:v>
                </c:pt>
                <c:pt idx="2">
                  <c:v>97.441543681474968</c:v>
                </c:pt>
                <c:pt idx="3">
                  <c:v>98.362242615278021</c:v>
                </c:pt>
                <c:pt idx="4">
                  <c:v>101.32696853363205</c:v>
                </c:pt>
                <c:pt idx="5">
                  <c:v>101.12774842648757</c:v>
                </c:pt>
                <c:pt idx="6">
                  <c:v>99.018341221495533</c:v>
                </c:pt>
                <c:pt idx="7">
                  <c:v>100.28798776945365</c:v>
                </c:pt>
                <c:pt idx="8">
                  <c:v>100.47796953913436</c:v>
                </c:pt>
                <c:pt idx="9">
                  <c:v>101.70735655139866</c:v>
                </c:pt>
                <c:pt idx="10">
                  <c:v>100.79421913353342</c:v>
                </c:pt>
                <c:pt idx="11">
                  <c:v>132.92912741920003</c:v>
                </c:pt>
                <c:pt idx="12">
                  <c:v>142.32132907700489</c:v>
                </c:pt>
                <c:pt idx="13">
                  <c:v>149.76796164815994</c:v>
                </c:pt>
                <c:pt idx="14">
                  <c:v>151.89910689321718</c:v>
                </c:pt>
                <c:pt idx="15">
                  <c:v>154.41901635413529</c:v>
                </c:pt>
                <c:pt idx="16">
                  <c:v>157.34500664063512</c:v>
                </c:pt>
                <c:pt idx="17">
                  <c:v>157.97993405683158</c:v>
                </c:pt>
                <c:pt idx="18">
                  <c:v>159.16189285772745</c:v>
                </c:pt>
                <c:pt idx="19">
                  <c:v>161.17237813873572</c:v>
                </c:pt>
                <c:pt idx="20">
                  <c:v>161.90986059222217</c:v>
                </c:pt>
                <c:pt idx="21">
                  <c:v>161.33659327827004</c:v>
                </c:pt>
                <c:pt idx="22">
                  <c:v>161.64632277890544</c:v>
                </c:pt>
                <c:pt idx="23">
                  <c:v>160.98907992655231</c:v>
                </c:pt>
                <c:pt idx="24">
                  <c:v>162.26484054545173</c:v>
                </c:pt>
                <c:pt idx="25">
                  <c:v>162.46787304870708</c:v>
                </c:pt>
                <c:pt idx="26">
                  <c:v>162.91248649473181</c:v>
                </c:pt>
                <c:pt idx="27">
                  <c:v>163.8622898826622</c:v>
                </c:pt>
                <c:pt idx="28">
                  <c:v>162.62430256879782</c:v>
                </c:pt>
                <c:pt idx="29">
                  <c:v>163.60435465699112</c:v>
                </c:pt>
                <c:pt idx="30">
                  <c:v>163.80559433219983</c:v>
                </c:pt>
                <c:pt idx="31">
                  <c:v>162.33490584742049</c:v>
                </c:pt>
                <c:pt idx="32">
                  <c:v>162.86395885792894</c:v>
                </c:pt>
                <c:pt idx="33">
                  <c:v>160.99191154026121</c:v>
                </c:pt>
                <c:pt idx="34">
                  <c:v>161.87875766212528</c:v>
                </c:pt>
                <c:pt idx="35">
                  <c:v>163.32713862028342</c:v>
                </c:pt>
                <c:pt idx="36">
                  <c:v>160.85620236666804</c:v>
                </c:pt>
                <c:pt idx="37">
                  <c:v>160.96070578620279</c:v>
                </c:pt>
                <c:pt idx="38">
                  <c:v>162.75841401622003</c:v>
                </c:pt>
                <c:pt idx="39">
                  <c:v>163.34141269534871</c:v>
                </c:pt>
                <c:pt idx="40">
                  <c:v>161.34698640791675</c:v>
                </c:pt>
                <c:pt idx="41">
                  <c:v>161.67125627131253</c:v>
                </c:pt>
                <c:pt idx="42">
                  <c:v>161.50995447735397</c:v>
                </c:pt>
                <c:pt idx="43">
                  <c:v>163.12178071359116</c:v>
                </c:pt>
                <c:pt idx="44">
                  <c:v>160.92174605084278</c:v>
                </c:pt>
                <c:pt idx="45">
                  <c:v>160.23886839393489</c:v>
                </c:pt>
                <c:pt idx="46">
                  <c:v>162.16648810802394</c:v>
                </c:pt>
                <c:pt idx="47">
                  <c:v>164.37690271785988</c:v>
                </c:pt>
                <c:pt idx="48">
                  <c:v>161.96730754855699</c:v>
                </c:pt>
                <c:pt idx="49">
                  <c:v>162.74835308706432</c:v>
                </c:pt>
                <c:pt idx="50">
                  <c:v>162.75841401622003</c:v>
                </c:pt>
                <c:pt idx="51">
                  <c:v>163.34141269534871</c:v>
                </c:pt>
                <c:pt idx="52">
                  <c:v>161.34698640791675</c:v>
                </c:pt>
                <c:pt idx="53">
                  <c:v>161.67125627131253</c:v>
                </c:pt>
                <c:pt idx="54">
                  <c:v>160.92174605084278</c:v>
                </c:pt>
                <c:pt idx="55">
                  <c:v>160.23886839393489</c:v>
                </c:pt>
                <c:pt idx="56">
                  <c:v>162.16648810802394</c:v>
                </c:pt>
                <c:pt idx="57">
                  <c:v>164.37690271785988</c:v>
                </c:pt>
                <c:pt idx="58">
                  <c:v>161.96730754855699</c:v>
                </c:pt>
                <c:pt idx="59">
                  <c:v>162.74835308706432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102A-4513-9AE8-E64BC7E519D4}"/>
            </c:ext>
          </c:extLst>
        </c:ser>
        <c:ser>
          <c:idx val="4"/>
          <c:order val="2"/>
          <c:tx>
            <c:v>Muscle 24h after EBRT</c:v>
          </c:tx>
          <c:xVal>
            <c:numRef>
              <c:f>'Vessel permeability'!$O$5:$O$64</c:f>
              <c:numCache>
                <c:formatCode>General</c:formatCode>
                <c:ptCount val="60"/>
                <c:pt idx="0">
                  <c:v>0</c:v>
                </c:pt>
                <c:pt idx="1">
                  <c:v>9</c:v>
                </c:pt>
                <c:pt idx="2">
                  <c:v>18</c:v>
                </c:pt>
                <c:pt idx="3">
                  <c:v>27</c:v>
                </c:pt>
                <c:pt idx="4">
                  <c:v>36</c:v>
                </c:pt>
                <c:pt idx="5">
                  <c:v>45</c:v>
                </c:pt>
                <c:pt idx="6">
                  <c:v>54</c:v>
                </c:pt>
                <c:pt idx="7">
                  <c:v>63</c:v>
                </c:pt>
                <c:pt idx="8">
                  <c:v>72</c:v>
                </c:pt>
                <c:pt idx="9">
                  <c:v>81</c:v>
                </c:pt>
                <c:pt idx="10">
                  <c:v>90</c:v>
                </c:pt>
                <c:pt idx="11">
                  <c:v>99</c:v>
                </c:pt>
                <c:pt idx="12">
                  <c:v>108</c:v>
                </c:pt>
                <c:pt idx="13">
                  <c:v>117</c:v>
                </c:pt>
                <c:pt idx="14">
                  <c:v>126</c:v>
                </c:pt>
                <c:pt idx="15">
                  <c:v>135</c:v>
                </c:pt>
                <c:pt idx="16">
                  <c:v>144</c:v>
                </c:pt>
                <c:pt idx="17">
                  <c:v>153</c:v>
                </c:pt>
                <c:pt idx="18">
                  <c:v>162</c:v>
                </c:pt>
                <c:pt idx="19">
                  <c:v>171</c:v>
                </c:pt>
                <c:pt idx="20">
                  <c:v>180</c:v>
                </c:pt>
                <c:pt idx="21">
                  <c:v>189</c:v>
                </c:pt>
                <c:pt idx="22">
                  <c:v>198</c:v>
                </c:pt>
                <c:pt idx="23">
                  <c:v>207</c:v>
                </c:pt>
                <c:pt idx="24">
                  <c:v>216</c:v>
                </c:pt>
                <c:pt idx="25">
                  <c:v>225</c:v>
                </c:pt>
                <c:pt idx="26">
                  <c:v>234</c:v>
                </c:pt>
                <c:pt idx="27">
                  <c:v>243</c:v>
                </c:pt>
                <c:pt idx="28">
                  <c:v>252</c:v>
                </c:pt>
                <c:pt idx="29">
                  <c:v>261</c:v>
                </c:pt>
                <c:pt idx="30">
                  <c:v>270</c:v>
                </c:pt>
                <c:pt idx="31">
                  <c:v>279</c:v>
                </c:pt>
                <c:pt idx="32">
                  <c:v>288</c:v>
                </c:pt>
                <c:pt idx="33">
                  <c:v>297</c:v>
                </c:pt>
                <c:pt idx="34">
                  <c:v>306</c:v>
                </c:pt>
                <c:pt idx="35">
                  <c:v>315</c:v>
                </c:pt>
                <c:pt idx="36">
                  <c:v>324</c:v>
                </c:pt>
                <c:pt idx="37">
                  <c:v>333</c:v>
                </c:pt>
                <c:pt idx="38">
                  <c:v>342</c:v>
                </c:pt>
                <c:pt idx="39">
                  <c:v>351</c:v>
                </c:pt>
                <c:pt idx="40">
                  <c:v>360</c:v>
                </c:pt>
                <c:pt idx="41">
                  <c:v>369</c:v>
                </c:pt>
                <c:pt idx="42">
                  <c:v>378</c:v>
                </c:pt>
                <c:pt idx="43">
                  <c:v>387</c:v>
                </c:pt>
                <c:pt idx="44">
                  <c:v>396</c:v>
                </c:pt>
                <c:pt idx="45">
                  <c:v>405</c:v>
                </c:pt>
                <c:pt idx="46">
                  <c:v>414</c:v>
                </c:pt>
                <c:pt idx="47">
                  <c:v>423</c:v>
                </c:pt>
                <c:pt idx="48">
                  <c:v>432</c:v>
                </c:pt>
                <c:pt idx="49">
                  <c:v>441</c:v>
                </c:pt>
                <c:pt idx="50">
                  <c:v>450</c:v>
                </c:pt>
                <c:pt idx="51">
                  <c:v>459</c:v>
                </c:pt>
                <c:pt idx="52">
                  <c:v>468</c:v>
                </c:pt>
                <c:pt idx="53">
                  <c:v>477</c:v>
                </c:pt>
                <c:pt idx="54">
                  <c:v>486</c:v>
                </c:pt>
                <c:pt idx="55">
                  <c:v>495</c:v>
                </c:pt>
                <c:pt idx="56">
                  <c:v>504</c:v>
                </c:pt>
                <c:pt idx="57">
                  <c:v>513</c:v>
                </c:pt>
                <c:pt idx="58">
                  <c:v>522</c:v>
                </c:pt>
                <c:pt idx="59">
                  <c:v>531</c:v>
                </c:pt>
              </c:numCache>
            </c:numRef>
          </c:xVal>
          <c:yVal>
            <c:numRef>
              <c:f>'Vessel permeability'!$AQ$136:$AQ$195</c:f>
              <c:numCache>
                <c:formatCode>General</c:formatCode>
                <c:ptCount val="60"/>
                <c:pt idx="0">
                  <c:v>98.321488456381346</c:v>
                </c:pt>
                <c:pt idx="1">
                  <c:v>97.980181525647538</c:v>
                </c:pt>
                <c:pt idx="2">
                  <c:v>99.505616858634966</c:v>
                </c:pt>
                <c:pt idx="3">
                  <c:v>99.677341854545105</c:v>
                </c:pt>
                <c:pt idx="4">
                  <c:v>99.710314147235124</c:v>
                </c:pt>
                <c:pt idx="5">
                  <c:v>98.295251476141857</c:v>
                </c:pt>
                <c:pt idx="6">
                  <c:v>105.87910796068539</c:v>
                </c:pt>
                <c:pt idx="7">
                  <c:v>100.40869452416361</c:v>
                </c:pt>
                <c:pt idx="8">
                  <c:v>99.511911238461451</c:v>
                </c:pt>
                <c:pt idx="9">
                  <c:v>100.71009195810387</c:v>
                </c:pt>
                <c:pt idx="10">
                  <c:v>100.4751043381353</c:v>
                </c:pt>
                <c:pt idx="11">
                  <c:v>116.31528114107621</c:v>
                </c:pt>
                <c:pt idx="12">
                  <c:v>127.32006034270023</c:v>
                </c:pt>
                <c:pt idx="13">
                  <c:v>133.54719227913731</c:v>
                </c:pt>
                <c:pt idx="14">
                  <c:v>137.17357106512696</c:v>
                </c:pt>
                <c:pt idx="15">
                  <c:v>136.01933925535906</c:v>
                </c:pt>
                <c:pt idx="16">
                  <c:v>138.37304253077417</c:v>
                </c:pt>
                <c:pt idx="17">
                  <c:v>139.18918512386171</c:v>
                </c:pt>
                <c:pt idx="18">
                  <c:v>140.53946201750352</c:v>
                </c:pt>
                <c:pt idx="19">
                  <c:v>138.67380203098057</c:v>
                </c:pt>
                <c:pt idx="20">
                  <c:v>138.52209131329016</c:v>
                </c:pt>
                <c:pt idx="21">
                  <c:v>137.51157407030959</c:v>
                </c:pt>
                <c:pt idx="22">
                  <c:v>137.70349162354694</c:v>
                </c:pt>
                <c:pt idx="23">
                  <c:v>137.23364971987974</c:v>
                </c:pt>
                <c:pt idx="24">
                  <c:v>135.63248674646232</c:v>
                </c:pt>
                <c:pt idx="25">
                  <c:v>135.22806861040982</c:v>
                </c:pt>
                <c:pt idx="26">
                  <c:v>136.28634702315651</c:v>
                </c:pt>
                <c:pt idx="27">
                  <c:v>137.04972831754543</c:v>
                </c:pt>
                <c:pt idx="28">
                  <c:v>135.97793621803822</c:v>
                </c:pt>
                <c:pt idx="29">
                  <c:v>136.07390037425435</c:v>
                </c:pt>
                <c:pt idx="30">
                  <c:v>135.45914770202586</c:v>
                </c:pt>
                <c:pt idx="31">
                  <c:v>135.55896985725195</c:v>
                </c:pt>
                <c:pt idx="32">
                  <c:v>134.47889069476361</c:v>
                </c:pt>
                <c:pt idx="33">
                  <c:v>132.87168201936882</c:v>
                </c:pt>
                <c:pt idx="34">
                  <c:v>133.32139360727524</c:v>
                </c:pt>
                <c:pt idx="35">
                  <c:v>132.65565766227823</c:v>
                </c:pt>
                <c:pt idx="36">
                  <c:v>132.58197910926717</c:v>
                </c:pt>
                <c:pt idx="37">
                  <c:v>132.61450236231741</c:v>
                </c:pt>
                <c:pt idx="38">
                  <c:v>131.05666059756169</c:v>
                </c:pt>
                <c:pt idx="39">
                  <c:v>133.35461731150255</c:v>
                </c:pt>
                <c:pt idx="40">
                  <c:v>131.46953821959087</c:v>
                </c:pt>
                <c:pt idx="41">
                  <c:v>132.01906106559008</c:v>
                </c:pt>
                <c:pt idx="42">
                  <c:v>132.02665857452737</c:v>
                </c:pt>
                <c:pt idx="43">
                  <c:v>128.88698659230687</c:v>
                </c:pt>
                <c:pt idx="44">
                  <c:v>128.19545189108592</c:v>
                </c:pt>
                <c:pt idx="45">
                  <c:v>130.0960490525967</c:v>
                </c:pt>
                <c:pt idx="46">
                  <c:v>130.18989019895329</c:v>
                </c:pt>
                <c:pt idx="47">
                  <c:v>130.15803511949539</c:v>
                </c:pt>
                <c:pt idx="48">
                  <c:v>128.29282770885118</c:v>
                </c:pt>
                <c:pt idx="49">
                  <c:v>128.5970465661018</c:v>
                </c:pt>
                <c:pt idx="50">
                  <c:v>128.81476301350142</c:v>
                </c:pt>
                <c:pt idx="51">
                  <c:v>127.5327980416189</c:v>
                </c:pt>
                <c:pt idx="52">
                  <c:v>128.53069599040145</c:v>
                </c:pt>
                <c:pt idx="53">
                  <c:v>129.33063095984602</c:v>
                </c:pt>
                <c:pt idx="54">
                  <c:v>128.2053662133298</c:v>
                </c:pt>
                <c:pt idx="55">
                  <c:v>128.92486585535229</c:v>
                </c:pt>
                <c:pt idx="56">
                  <c:v>127.47348453115117</c:v>
                </c:pt>
                <c:pt idx="57">
                  <c:v>126.68206298159623</c:v>
                </c:pt>
                <c:pt idx="58">
                  <c:v>123.74571012664728</c:v>
                </c:pt>
                <c:pt idx="59">
                  <c:v>126.1427129543958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102A-4513-9AE8-E64BC7E519D4}"/>
            </c:ext>
          </c:extLst>
        </c:ser>
        <c:ser>
          <c:idx val="2"/>
          <c:order val="3"/>
          <c:tx>
            <c:v>Tumour 24h after EBRT</c:v>
          </c:tx>
          <c:spPr>
            <a:ln w="19050" cap="rnd">
              <a:solidFill>
                <a:srgbClr val="C0504D"/>
              </a:solidFill>
              <a:round/>
            </a:ln>
            <a:effectLst/>
          </c:spPr>
          <c:marker>
            <c:symbol val="diamond"/>
            <c:size val="9"/>
            <c:spPr>
              <a:solidFill>
                <a:srgbClr val="C0504D"/>
              </a:solidFill>
              <a:ln w="25400">
                <a:solidFill>
                  <a:srgbClr val="C0504D"/>
                </a:solidFill>
              </a:ln>
              <a:effectLst/>
            </c:spPr>
          </c:marker>
          <c:xVal>
            <c:numRef>
              <c:f>'Vessel permeability'!$O$5:$O$64</c:f>
              <c:numCache>
                <c:formatCode>General</c:formatCode>
                <c:ptCount val="60"/>
                <c:pt idx="0">
                  <c:v>0</c:v>
                </c:pt>
                <c:pt idx="1">
                  <c:v>9</c:v>
                </c:pt>
                <c:pt idx="2">
                  <c:v>18</c:v>
                </c:pt>
                <c:pt idx="3">
                  <c:v>27</c:v>
                </c:pt>
                <c:pt idx="4">
                  <c:v>36</c:v>
                </c:pt>
                <c:pt idx="5">
                  <c:v>45</c:v>
                </c:pt>
                <c:pt idx="6">
                  <c:v>54</c:v>
                </c:pt>
                <c:pt idx="7">
                  <c:v>63</c:v>
                </c:pt>
                <c:pt idx="8">
                  <c:v>72</c:v>
                </c:pt>
                <c:pt idx="9">
                  <c:v>81</c:v>
                </c:pt>
                <c:pt idx="10">
                  <c:v>90</c:v>
                </c:pt>
                <c:pt idx="11">
                  <c:v>99</c:v>
                </c:pt>
                <c:pt idx="12">
                  <c:v>108</c:v>
                </c:pt>
                <c:pt idx="13">
                  <c:v>117</c:v>
                </c:pt>
                <c:pt idx="14">
                  <c:v>126</c:v>
                </c:pt>
                <c:pt idx="15">
                  <c:v>135</c:v>
                </c:pt>
                <c:pt idx="16">
                  <c:v>144</c:v>
                </c:pt>
                <c:pt idx="17">
                  <c:v>153</c:v>
                </c:pt>
                <c:pt idx="18">
                  <c:v>162</c:v>
                </c:pt>
                <c:pt idx="19">
                  <c:v>171</c:v>
                </c:pt>
                <c:pt idx="20">
                  <c:v>180</c:v>
                </c:pt>
                <c:pt idx="21">
                  <c:v>189</c:v>
                </c:pt>
                <c:pt idx="22">
                  <c:v>198</c:v>
                </c:pt>
                <c:pt idx="23">
                  <c:v>207</c:v>
                </c:pt>
                <c:pt idx="24">
                  <c:v>216</c:v>
                </c:pt>
                <c:pt idx="25">
                  <c:v>225</c:v>
                </c:pt>
                <c:pt idx="26">
                  <c:v>234</c:v>
                </c:pt>
                <c:pt idx="27">
                  <c:v>243</c:v>
                </c:pt>
                <c:pt idx="28">
                  <c:v>252</c:v>
                </c:pt>
                <c:pt idx="29">
                  <c:v>261</c:v>
                </c:pt>
                <c:pt idx="30">
                  <c:v>270</c:v>
                </c:pt>
                <c:pt idx="31">
                  <c:v>279</c:v>
                </c:pt>
                <c:pt idx="32">
                  <c:v>288</c:v>
                </c:pt>
                <c:pt idx="33">
                  <c:v>297</c:v>
                </c:pt>
                <c:pt idx="34">
                  <c:v>306</c:v>
                </c:pt>
                <c:pt idx="35">
                  <c:v>315</c:v>
                </c:pt>
                <c:pt idx="36">
                  <c:v>324</c:v>
                </c:pt>
                <c:pt idx="37">
                  <c:v>333</c:v>
                </c:pt>
                <c:pt idx="38">
                  <c:v>342</c:v>
                </c:pt>
                <c:pt idx="39">
                  <c:v>351</c:v>
                </c:pt>
                <c:pt idx="40">
                  <c:v>360</c:v>
                </c:pt>
                <c:pt idx="41">
                  <c:v>369</c:v>
                </c:pt>
                <c:pt idx="42">
                  <c:v>378</c:v>
                </c:pt>
                <c:pt idx="43">
                  <c:v>387</c:v>
                </c:pt>
                <c:pt idx="44">
                  <c:v>396</c:v>
                </c:pt>
                <c:pt idx="45">
                  <c:v>405</c:v>
                </c:pt>
                <c:pt idx="46">
                  <c:v>414</c:v>
                </c:pt>
                <c:pt idx="47">
                  <c:v>423</c:v>
                </c:pt>
                <c:pt idx="48">
                  <c:v>432</c:v>
                </c:pt>
                <c:pt idx="49">
                  <c:v>441</c:v>
                </c:pt>
                <c:pt idx="50">
                  <c:v>450</c:v>
                </c:pt>
                <c:pt idx="51">
                  <c:v>459</c:v>
                </c:pt>
                <c:pt idx="52">
                  <c:v>468</c:v>
                </c:pt>
                <c:pt idx="53">
                  <c:v>477</c:v>
                </c:pt>
                <c:pt idx="54">
                  <c:v>486</c:v>
                </c:pt>
                <c:pt idx="55">
                  <c:v>495</c:v>
                </c:pt>
                <c:pt idx="56">
                  <c:v>504</c:v>
                </c:pt>
                <c:pt idx="57">
                  <c:v>513</c:v>
                </c:pt>
                <c:pt idx="58">
                  <c:v>522</c:v>
                </c:pt>
                <c:pt idx="59">
                  <c:v>531</c:v>
                </c:pt>
              </c:numCache>
            </c:numRef>
          </c:xVal>
          <c:yVal>
            <c:numRef>
              <c:f>'Vessel permeability'!$AD$136:$AD$195</c:f>
              <c:numCache>
                <c:formatCode>General</c:formatCode>
                <c:ptCount val="60"/>
                <c:pt idx="0">
                  <c:v>101.14786431933251</c:v>
                </c:pt>
                <c:pt idx="1">
                  <c:v>98.873702876680355</c:v>
                </c:pt>
                <c:pt idx="2">
                  <c:v>100.6478643666139</c:v>
                </c:pt>
                <c:pt idx="3">
                  <c:v>101.2342139115962</c:v>
                </c:pt>
                <c:pt idx="4">
                  <c:v>99.299551838515328</c:v>
                </c:pt>
                <c:pt idx="5">
                  <c:v>100.49211771339132</c:v>
                </c:pt>
                <c:pt idx="6">
                  <c:v>99.331747893405108</c:v>
                </c:pt>
                <c:pt idx="7">
                  <c:v>99.904726258270031</c:v>
                </c:pt>
                <c:pt idx="8">
                  <c:v>98.611110573822444</c:v>
                </c:pt>
                <c:pt idx="9">
                  <c:v>100.45710024837263</c:v>
                </c:pt>
                <c:pt idx="10">
                  <c:v>99.703833604337404</c:v>
                </c:pt>
                <c:pt idx="11">
                  <c:v>167.94866574079364</c:v>
                </c:pt>
                <c:pt idx="12">
                  <c:v>189.23690148957127</c:v>
                </c:pt>
                <c:pt idx="13">
                  <c:v>198.65</c:v>
                </c:pt>
                <c:pt idx="14">
                  <c:v>201.74</c:v>
                </c:pt>
                <c:pt idx="15">
                  <c:v>202.63</c:v>
                </c:pt>
                <c:pt idx="16">
                  <c:v>203.30172348184598</c:v>
                </c:pt>
                <c:pt idx="17">
                  <c:v>205.25828299862866</c:v>
                </c:pt>
                <c:pt idx="18">
                  <c:v>205.41613011518234</c:v>
                </c:pt>
                <c:pt idx="19">
                  <c:v>204.79202883037564</c:v>
                </c:pt>
                <c:pt idx="20">
                  <c:v>205.30037204186812</c:v>
                </c:pt>
                <c:pt idx="21">
                  <c:v>206.73895573318401</c:v>
                </c:pt>
                <c:pt idx="22">
                  <c:v>205.80976005196345</c:v>
                </c:pt>
                <c:pt idx="23">
                  <c:v>206.00235951382714</c:v>
                </c:pt>
                <c:pt idx="24">
                  <c:v>205.27652983678604</c:v>
                </c:pt>
                <c:pt idx="25">
                  <c:v>204.86959150958771</c:v>
                </c:pt>
                <c:pt idx="26">
                  <c:v>204.94947486310545</c:v>
                </c:pt>
                <c:pt idx="27">
                  <c:v>206.41</c:v>
                </c:pt>
                <c:pt idx="28">
                  <c:v>206</c:v>
                </c:pt>
                <c:pt idx="29">
                  <c:v>205.8251510935186</c:v>
                </c:pt>
                <c:pt idx="30">
                  <c:v>204.24775244208217</c:v>
                </c:pt>
                <c:pt idx="31">
                  <c:v>206.13914257724431</c:v>
                </c:pt>
                <c:pt idx="32">
                  <c:v>203.46238430595855</c:v>
                </c:pt>
                <c:pt idx="33">
                  <c:v>205.08329044265543</c:v>
                </c:pt>
                <c:pt idx="34">
                  <c:v>203.15942056419928</c:v>
                </c:pt>
                <c:pt idx="35">
                  <c:v>201.59317172670924</c:v>
                </c:pt>
                <c:pt idx="36">
                  <c:v>203.61166974086035</c:v>
                </c:pt>
                <c:pt idx="37">
                  <c:v>201.26985807008961</c:v>
                </c:pt>
                <c:pt idx="38">
                  <c:v>202.80088828169252</c:v>
                </c:pt>
                <c:pt idx="39">
                  <c:v>203.27270851959517</c:v>
                </c:pt>
                <c:pt idx="40">
                  <c:v>200.95753089166845</c:v>
                </c:pt>
                <c:pt idx="41">
                  <c:v>200.58750149183564</c:v>
                </c:pt>
                <c:pt idx="42">
                  <c:v>202.47104635312922</c:v>
                </c:pt>
                <c:pt idx="43">
                  <c:v>202.55395042077478</c:v>
                </c:pt>
                <c:pt idx="44">
                  <c:v>201.16916931848698</c:v>
                </c:pt>
                <c:pt idx="45">
                  <c:v>198.149754999387</c:v>
                </c:pt>
                <c:pt idx="46">
                  <c:v>199.40907877340109</c:v>
                </c:pt>
                <c:pt idx="47">
                  <c:v>199.80507511849726</c:v>
                </c:pt>
                <c:pt idx="48">
                  <c:v>197.26328203533464</c:v>
                </c:pt>
                <c:pt idx="49">
                  <c:v>197.23910490600323</c:v>
                </c:pt>
                <c:pt idx="50">
                  <c:v>198.63547768841849</c:v>
                </c:pt>
                <c:pt idx="51">
                  <c:v>194.0753206983504</c:v>
                </c:pt>
                <c:pt idx="52">
                  <c:v>195.31139405848677</c:v>
                </c:pt>
                <c:pt idx="53">
                  <c:v>198.64305302847211</c:v>
                </c:pt>
                <c:pt idx="54">
                  <c:v>195.87080524033689</c:v>
                </c:pt>
                <c:pt idx="55">
                  <c:v>194.20370603482002</c:v>
                </c:pt>
                <c:pt idx="56">
                  <c:v>192.07989772706355</c:v>
                </c:pt>
                <c:pt idx="57">
                  <c:v>193.59531991846518</c:v>
                </c:pt>
                <c:pt idx="58">
                  <c:v>193.30772349159457</c:v>
                </c:pt>
                <c:pt idx="59">
                  <c:v>192.4542271553744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102A-4513-9AE8-E64BC7E519D4}"/>
            </c:ext>
          </c:extLst>
        </c:ser>
        <c:ser>
          <c:idx val="5"/>
          <c:order val="4"/>
          <c:tx>
            <c:v>Muscle 72h after EBRT</c:v>
          </c:tx>
          <c:xVal>
            <c:numRef>
              <c:f>'Vessel permeability'!$O$5:$O$64</c:f>
              <c:numCache>
                <c:formatCode>General</c:formatCode>
                <c:ptCount val="60"/>
                <c:pt idx="0">
                  <c:v>0</c:v>
                </c:pt>
                <c:pt idx="1">
                  <c:v>9</c:v>
                </c:pt>
                <c:pt idx="2">
                  <c:v>18</c:v>
                </c:pt>
                <c:pt idx="3">
                  <c:v>27</c:v>
                </c:pt>
                <c:pt idx="4">
                  <c:v>36</c:v>
                </c:pt>
                <c:pt idx="5">
                  <c:v>45</c:v>
                </c:pt>
                <c:pt idx="6">
                  <c:v>54</c:v>
                </c:pt>
                <c:pt idx="7">
                  <c:v>63</c:v>
                </c:pt>
                <c:pt idx="8">
                  <c:v>72</c:v>
                </c:pt>
                <c:pt idx="9">
                  <c:v>81</c:v>
                </c:pt>
                <c:pt idx="10">
                  <c:v>90</c:v>
                </c:pt>
                <c:pt idx="11">
                  <c:v>99</c:v>
                </c:pt>
                <c:pt idx="12">
                  <c:v>108</c:v>
                </c:pt>
                <c:pt idx="13">
                  <c:v>117</c:v>
                </c:pt>
                <c:pt idx="14">
                  <c:v>126</c:v>
                </c:pt>
                <c:pt idx="15">
                  <c:v>135</c:v>
                </c:pt>
                <c:pt idx="16">
                  <c:v>144</c:v>
                </c:pt>
                <c:pt idx="17">
                  <c:v>153</c:v>
                </c:pt>
                <c:pt idx="18">
                  <c:v>162</c:v>
                </c:pt>
                <c:pt idx="19">
                  <c:v>171</c:v>
                </c:pt>
                <c:pt idx="20">
                  <c:v>180</c:v>
                </c:pt>
                <c:pt idx="21">
                  <c:v>189</c:v>
                </c:pt>
                <c:pt idx="22">
                  <c:v>198</c:v>
                </c:pt>
                <c:pt idx="23">
                  <c:v>207</c:v>
                </c:pt>
                <c:pt idx="24">
                  <c:v>216</c:v>
                </c:pt>
                <c:pt idx="25">
                  <c:v>225</c:v>
                </c:pt>
                <c:pt idx="26">
                  <c:v>234</c:v>
                </c:pt>
                <c:pt idx="27">
                  <c:v>243</c:v>
                </c:pt>
                <c:pt idx="28">
                  <c:v>252</c:v>
                </c:pt>
                <c:pt idx="29">
                  <c:v>261</c:v>
                </c:pt>
                <c:pt idx="30">
                  <c:v>270</c:v>
                </c:pt>
                <c:pt idx="31">
                  <c:v>279</c:v>
                </c:pt>
                <c:pt idx="32">
                  <c:v>288</c:v>
                </c:pt>
                <c:pt idx="33">
                  <c:v>297</c:v>
                </c:pt>
                <c:pt idx="34">
                  <c:v>306</c:v>
                </c:pt>
                <c:pt idx="35">
                  <c:v>315</c:v>
                </c:pt>
                <c:pt idx="36">
                  <c:v>324</c:v>
                </c:pt>
                <c:pt idx="37">
                  <c:v>333</c:v>
                </c:pt>
                <c:pt idx="38">
                  <c:v>342</c:v>
                </c:pt>
                <c:pt idx="39">
                  <c:v>351</c:v>
                </c:pt>
                <c:pt idx="40">
                  <c:v>360</c:v>
                </c:pt>
                <c:pt idx="41">
                  <c:v>369</c:v>
                </c:pt>
                <c:pt idx="42">
                  <c:v>378</c:v>
                </c:pt>
                <c:pt idx="43">
                  <c:v>387</c:v>
                </c:pt>
                <c:pt idx="44">
                  <c:v>396</c:v>
                </c:pt>
                <c:pt idx="45">
                  <c:v>405</c:v>
                </c:pt>
                <c:pt idx="46">
                  <c:v>414</c:v>
                </c:pt>
                <c:pt idx="47">
                  <c:v>423</c:v>
                </c:pt>
                <c:pt idx="48">
                  <c:v>432</c:v>
                </c:pt>
                <c:pt idx="49">
                  <c:v>441</c:v>
                </c:pt>
                <c:pt idx="50">
                  <c:v>450</c:v>
                </c:pt>
                <c:pt idx="51">
                  <c:v>459</c:v>
                </c:pt>
                <c:pt idx="52">
                  <c:v>468</c:v>
                </c:pt>
                <c:pt idx="53">
                  <c:v>477</c:v>
                </c:pt>
                <c:pt idx="54">
                  <c:v>486</c:v>
                </c:pt>
                <c:pt idx="55">
                  <c:v>495</c:v>
                </c:pt>
                <c:pt idx="56">
                  <c:v>504</c:v>
                </c:pt>
                <c:pt idx="57">
                  <c:v>513</c:v>
                </c:pt>
                <c:pt idx="58">
                  <c:v>522</c:v>
                </c:pt>
                <c:pt idx="59">
                  <c:v>531</c:v>
                </c:pt>
              </c:numCache>
            </c:numRef>
          </c:xVal>
          <c:yVal>
            <c:numRef>
              <c:f>'Vessel permeability'!$AM$136:$AM$195</c:f>
              <c:numCache>
                <c:formatCode>General</c:formatCode>
                <c:ptCount val="60"/>
                <c:pt idx="0">
                  <c:v>100.16665627962347</c:v>
                </c:pt>
                <c:pt idx="1">
                  <c:v>97.70600080438318</c:v>
                </c:pt>
                <c:pt idx="2">
                  <c:v>100.04684699517527</c:v>
                </c:pt>
                <c:pt idx="3">
                  <c:v>98.221447932716998</c:v>
                </c:pt>
                <c:pt idx="4">
                  <c:v>99.619911965317769</c:v>
                </c:pt>
                <c:pt idx="5">
                  <c:v>95.926939708631053</c:v>
                </c:pt>
                <c:pt idx="6">
                  <c:v>107.02673739323527</c:v>
                </c:pt>
                <c:pt idx="7">
                  <c:v>100.8690283220881</c:v>
                </c:pt>
                <c:pt idx="8">
                  <c:v>98.18435142105065</c:v>
                </c:pt>
                <c:pt idx="9">
                  <c:v>102.23207917777823</c:v>
                </c:pt>
                <c:pt idx="10">
                  <c:v>102.38374922234222</c:v>
                </c:pt>
                <c:pt idx="11">
                  <c:v>115.15493591715118</c:v>
                </c:pt>
                <c:pt idx="12">
                  <c:v>125.93385258049463</c:v>
                </c:pt>
                <c:pt idx="13">
                  <c:v>127.21397910146867</c:v>
                </c:pt>
                <c:pt idx="14">
                  <c:v>130.93716171847888</c:v>
                </c:pt>
                <c:pt idx="15">
                  <c:v>132.62205373298784</c:v>
                </c:pt>
                <c:pt idx="16">
                  <c:v>133.12469811723992</c:v>
                </c:pt>
                <c:pt idx="17">
                  <c:v>132.77604052461569</c:v>
                </c:pt>
                <c:pt idx="18">
                  <c:v>131.27657763091506</c:v>
                </c:pt>
                <c:pt idx="19">
                  <c:v>129.6064900407581</c:v>
                </c:pt>
                <c:pt idx="20">
                  <c:v>132.14466914291168</c:v>
                </c:pt>
                <c:pt idx="21">
                  <c:v>130.57215718288813</c:v>
                </c:pt>
                <c:pt idx="22">
                  <c:v>131.58512019187197</c:v>
                </c:pt>
                <c:pt idx="23">
                  <c:v>130.2921994402333</c:v>
                </c:pt>
                <c:pt idx="24">
                  <c:v>130.69222393840028</c:v>
                </c:pt>
                <c:pt idx="25">
                  <c:v>131.82613872537868</c:v>
                </c:pt>
                <c:pt idx="26">
                  <c:v>131.75249559843539</c:v>
                </c:pt>
                <c:pt idx="27">
                  <c:v>128.40826232545524</c:v>
                </c:pt>
                <c:pt idx="28">
                  <c:v>127.37677776532816</c:v>
                </c:pt>
                <c:pt idx="29">
                  <c:v>129.04451387227212</c:v>
                </c:pt>
                <c:pt idx="30">
                  <c:v>128.72067364349513</c:v>
                </c:pt>
                <c:pt idx="31">
                  <c:v>128.72426406108841</c:v>
                </c:pt>
                <c:pt idx="32">
                  <c:v>131.77384893023682</c:v>
                </c:pt>
                <c:pt idx="33">
                  <c:v>129.93074745511919</c:v>
                </c:pt>
                <c:pt idx="34">
                  <c:v>127.94979106553673</c:v>
                </c:pt>
                <c:pt idx="35">
                  <c:v>129.11437676056312</c:v>
                </c:pt>
                <c:pt idx="36">
                  <c:v>127.65509201039086</c:v>
                </c:pt>
                <c:pt idx="37">
                  <c:v>127.97752889029826</c:v>
                </c:pt>
                <c:pt idx="38">
                  <c:v>127.12108119301685</c:v>
                </c:pt>
                <c:pt idx="39">
                  <c:v>128.73561723759209</c:v>
                </c:pt>
                <c:pt idx="40">
                  <c:v>125.89463519368194</c:v>
                </c:pt>
                <c:pt idx="41">
                  <c:v>128.35727473837994</c:v>
                </c:pt>
                <c:pt idx="42">
                  <c:v>128.25163308875236</c:v>
                </c:pt>
                <c:pt idx="43">
                  <c:v>127.28515698202375</c:v>
                </c:pt>
                <c:pt idx="44">
                  <c:v>126.0705949461266</c:v>
                </c:pt>
                <c:pt idx="45">
                  <c:v>128.29858782790583</c:v>
                </c:pt>
                <c:pt idx="46">
                  <c:v>123.35979389985205</c:v>
                </c:pt>
                <c:pt idx="47">
                  <c:v>124.41304897736472</c:v>
                </c:pt>
                <c:pt idx="48">
                  <c:v>127.44787991164996</c:v>
                </c:pt>
                <c:pt idx="49">
                  <c:v>127.93173751311703</c:v>
                </c:pt>
                <c:pt idx="50">
                  <c:v>126.52456535939977</c:v>
                </c:pt>
                <c:pt idx="51">
                  <c:v>126.38826558592162</c:v>
                </c:pt>
                <c:pt idx="52">
                  <c:v>126.79755717084635</c:v>
                </c:pt>
                <c:pt idx="53">
                  <c:v>126.02649755602634</c:v>
                </c:pt>
                <c:pt idx="54">
                  <c:v>123.39595165600555</c:v>
                </c:pt>
                <c:pt idx="55">
                  <c:v>124.26179282559212</c:v>
                </c:pt>
                <c:pt idx="56">
                  <c:v>122.10066663695635</c:v>
                </c:pt>
                <c:pt idx="57">
                  <c:v>123.52896443429944</c:v>
                </c:pt>
                <c:pt idx="58">
                  <c:v>123.05761042528553</c:v>
                </c:pt>
                <c:pt idx="59">
                  <c:v>123.442628217494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5-102A-4513-9AE8-E64BC7E519D4}"/>
            </c:ext>
          </c:extLst>
        </c:ser>
        <c:ser>
          <c:idx val="3"/>
          <c:order val="5"/>
          <c:tx>
            <c:v>Tumour 72h after EBRT</c:v>
          </c:tx>
          <c:spPr>
            <a:ln w="19050" cap="rnd">
              <a:solidFill>
                <a:schemeClr val="tx1">
                  <a:lumMod val="85000"/>
                  <a:lumOff val="15000"/>
                </a:schemeClr>
              </a:solidFill>
              <a:round/>
            </a:ln>
            <a:effectLst/>
          </c:spPr>
          <c:marker>
            <c:symbol val="diamond"/>
            <c:size val="9"/>
            <c:spPr>
              <a:solidFill>
                <a:schemeClr val="tx1">
                  <a:lumMod val="85000"/>
                  <a:lumOff val="15000"/>
                </a:schemeClr>
              </a:solidFill>
              <a:ln w="9525">
                <a:solidFill>
                  <a:schemeClr val="tx1">
                    <a:lumMod val="85000"/>
                    <a:lumOff val="15000"/>
                  </a:schemeClr>
                </a:solidFill>
              </a:ln>
              <a:effectLst/>
            </c:spPr>
          </c:marker>
          <c:xVal>
            <c:numRef>
              <c:f>'Vessel permeability'!$O$5:$O$64</c:f>
              <c:numCache>
                <c:formatCode>General</c:formatCode>
                <c:ptCount val="60"/>
                <c:pt idx="0">
                  <c:v>0</c:v>
                </c:pt>
                <c:pt idx="1">
                  <c:v>9</c:v>
                </c:pt>
                <c:pt idx="2">
                  <c:v>18</c:v>
                </c:pt>
                <c:pt idx="3">
                  <c:v>27</c:v>
                </c:pt>
                <c:pt idx="4">
                  <c:v>36</c:v>
                </c:pt>
                <c:pt idx="5">
                  <c:v>45</c:v>
                </c:pt>
                <c:pt idx="6">
                  <c:v>54</c:v>
                </c:pt>
                <c:pt idx="7">
                  <c:v>63</c:v>
                </c:pt>
                <c:pt idx="8">
                  <c:v>72</c:v>
                </c:pt>
                <c:pt idx="9">
                  <c:v>81</c:v>
                </c:pt>
                <c:pt idx="10">
                  <c:v>90</c:v>
                </c:pt>
                <c:pt idx="11">
                  <c:v>99</c:v>
                </c:pt>
                <c:pt idx="12">
                  <c:v>108</c:v>
                </c:pt>
                <c:pt idx="13">
                  <c:v>117</c:v>
                </c:pt>
                <c:pt idx="14">
                  <c:v>126</c:v>
                </c:pt>
                <c:pt idx="15">
                  <c:v>135</c:v>
                </c:pt>
                <c:pt idx="16">
                  <c:v>144</c:v>
                </c:pt>
                <c:pt idx="17">
                  <c:v>153</c:v>
                </c:pt>
                <c:pt idx="18">
                  <c:v>162</c:v>
                </c:pt>
                <c:pt idx="19">
                  <c:v>171</c:v>
                </c:pt>
                <c:pt idx="20">
                  <c:v>180</c:v>
                </c:pt>
                <c:pt idx="21">
                  <c:v>189</c:v>
                </c:pt>
                <c:pt idx="22">
                  <c:v>198</c:v>
                </c:pt>
                <c:pt idx="23">
                  <c:v>207</c:v>
                </c:pt>
                <c:pt idx="24">
                  <c:v>216</c:v>
                </c:pt>
                <c:pt idx="25">
                  <c:v>225</c:v>
                </c:pt>
                <c:pt idx="26">
                  <c:v>234</c:v>
                </c:pt>
                <c:pt idx="27">
                  <c:v>243</c:v>
                </c:pt>
                <c:pt idx="28">
                  <c:v>252</c:v>
                </c:pt>
                <c:pt idx="29">
                  <c:v>261</c:v>
                </c:pt>
                <c:pt idx="30">
                  <c:v>270</c:v>
                </c:pt>
                <c:pt idx="31">
                  <c:v>279</c:v>
                </c:pt>
                <c:pt idx="32">
                  <c:v>288</c:v>
                </c:pt>
                <c:pt idx="33">
                  <c:v>297</c:v>
                </c:pt>
                <c:pt idx="34">
                  <c:v>306</c:v>
                </c:pt>
                <c:pt idx="35">
                  <c:v>315</c:v>
                </c:pt>
                <c:pt idx="36">
                  <c:v>324</c:v>
                </c:pt>
                <c:pt idx="37">
                  <c:v>333</c:v>
                </c:pt>
                <c:pt idx="38">
                  <c:v>342</c:v>
                </c:pt>
                <c:pt idx="39">
                  <c:v>351</c:v>
                </c:pt>
                <c:pt idx="40">
                  <c:v>360</c:v>
                </c:pt>
                <c:pt idx="41">
                  <c:v>369</c:v>
                </c:pt>
                <c:pt idx="42">
                  <c:v>378</c:v>
                </c:pt>
                <c:pt idx="43">
                  <c:v>387</c:v>
                </c:pt>
                <c:pt idx="44">
                  <c:v>396</c:v>
                </c:pt>
                <c:pt idx="45">
                  <c:v>405</c:v>
                </c:pt>
                <c:pt idx="46">
                  <c:v>414</c:v>
                </c:pt>
                <c:pt idx="47">
                  <c:v>423</c:v>
                </c:pt>
                <c:pt idx="48">
                  <c:v>432</c:v>
                </c:pt>
                <c:pt idx="49">
                  <c:v>441</c:v>
                </c:pt>
                <c:pt idx="50">
                  <c:v>450</c:v>
                </c:pt>
                <c:pt idx="51">
                  <c:v>459</c:v>
                </c:pt>
                <c:pt idx="52">
                  <c:v>468</c:v>
                </c:pt>
                <c:pt idx="53">
                  <c:v>477</c:v>
                </c:pt>
                <c:pt idx="54">
                  <c:v>486</c:v>
                </c:pt>
                <c:pt idx="55">
                  <c:v>495</c:v>
                </c:pt>
                <c:pt idx="56">
                  <c:v>504</c:v>
                </c:pt>
                <c:pt idx="57">
                  <c:v>513</c:v>
                </c:pt>
                <c:pt idx="58">
                  <c:v>522</c:v>
                </c:pt>
                <c:pt idx="59">
                  <c:v>531</c:v>
                </c:pt>
              </c:numCache>
            </c:numRef>
          </c:xVal>
          <c:yVal>
            <c:numRef>
              <c:f>'Vessel permeability'!$AH$136:$AH$283</c:f>
              <c:numCache>
                <c:formatCode>General</c:formatCode>
                <c:ptCount val="148"/>
                <c:pt idx="0">
                  <c:v>100.57665668704223</c:v>
                </c:pt>
                <c:pt idx="1">
                  <c:v>100.41739840720523</c:v>
                </c:pt>
                <c:pt idx="2">
                  <c:v>100.34546468344961</c:v>
                </c:pt>
                <c:pt idx="3">
                  <c:v>100.40793681275215</c:v>
                </c:pt>
                <c:pt idx="4">
                  <c:v>99.34870207881076</c:v>
                </c:pt>
                <c:pt idx="5">
                  <c:v>99.297926814168136</c:v>
                </c:pt>
                <c:pt idx="6">
                  <c:v>99.949979270230045</c:v>
                </c:pt>
                <c:pt idx="7">
                  <c:v>100.66169350178514</c:v>
                </c:pt>
                <c:pt idx="8">
                  <c:v>100.12513420410156</c:v>
                </c:pt>
                <c:pt idx="9">
                  <c:v>98.869107540455275</c:v>
                </c:pt>
                <c:pt idx="10">
                  <c:v>99.540884944314442</c:v>
                </c:pt>
                <c:pt idx="11">
                  <c:v>131.79888155264348</c:v>
                </c:pt>
                <c:pt idx="12">
                  <c:v>146.94814308495603</c:v>
                </c:pt>
                <c:pt idx="13">
                  <c:v>156.77737966997404</c:v>
                </c:pt>
                <c:pt idx="14">
                  <c:v>163.92548834855961</c:v>
                </c:pt>
                <c:pt idx="15">
                  <c:v>165.82136897958961</c:v>
                </c:pt>
                <c:pt idx="16">
                  <c:v>168.83485113252593</c:v>
                </c:pt>
                <c:pt idx="17">
                  <c:v>170.24798056192242</c:v>
                </c:pt>
                <c:pt idx="18">
                  <c:v>171.81096544437023</c:v>
                </c:pt>
                <c:pt idx="19">
                  <c:v>172.44091286210474</c:v>
                </c:pt>
                <c:pt idx="20">
                  <c:v>174.03907019349771</c:v>
                </c:pt>
                <c:pt idx="21">
                  <c:v>174.40954786538884</c:v>
                </c:pt>
                <c:pt idx="22">
                  <c:v>174.42150288801633</c:v>
                </c:pt>
                <c:pt idx="23">
                  <c:v>175.02555895056605</c:v>
                </c:pt>
                <c:pt idx="24">
                  <c:v>175.21209382346254</c:v>
                </c:pt>
                <c:pt idx="25">
                  <c:v>177.39887860586472</c:v>
                </c:pt>
                <c:pt idx="26">
                  <c:v>173.61041253087021</c:v>
                </c:pt>
                <c:pt idx="27">
                  <c:v>176.24595561699951</c:v>
                </c:pt>
                <c:pt idx="28">
                  <c:v>177.35813162389664</c:v>
                </c:pt>
                <c:pt idx="29">
                  <c:v>175.92706336402313</c:v>
                </c:pt>
                <c:pt idx="30">
                  <c:v>176.50644330279624</c:v>
                </c:pt>
                <c:pt idx="31">
                  <c:v>175.01132668082639</c:v>
                </c:pt>
                <c:pt idx="32">
                  <c:v>174.80547613495924</c:v>
                </c:pt>
                <c:pt idx="33">
                  <c:v>176.11520385354709</c:v>
                </c:pt>
                <c:pt idx="34">
                  <c:v>174.60746267731037</c:v>
                </c:pt>
                <c:pt idx="35">
                  <c:v>177.58616696421123</c:v>
                </c:pt>
                <c:pt idx="36">
                  <c:v>174.74870866708602</c:v>
                </c:pt>
                <c:pt idx="37">
                  <c:v>173.85781391644181</c:v>
                </c:pt>
                <c:pt idx="38">
                  <c:v>175.90432027673529</c:v>
                </c:pt>
                <c:pt idx="39">
                  <c:v>174.52451001591524</c:v>
                </c:pt>
                <c:pt idx="40">
                  <c:v>174.35470084093282</c:v>
                </c:pt>
                <c:pt idx="41">
                  <c:v>175.30060632596374</c:v>
                </c:pt>
                <c:pt idx="42">
                  <c:v>173.64520928651299</c:v>
                </c:pt>
                <c:pt idx="43">
                  <c:v>173.33531688203146</c:v>
                </c:pt>
                <c:pt idx="44">
                  <c:v>172.01594706829781</c:v>
                </c:pt>
                <c:pt idx="45">
                  <c:v>171.58656950174452</c:v>
                </c:pt>
                <c:pt idx="46">
                  <c:v>173.38654129956075</c:v>
                </c:pt>
                <c:pt idx="47">
                  <c:v>171.72296086242309</c:v>
                </c:pt>
                <c:pt idx="48">
                  <c:v>172.10811575925001</c:v>
                </c:pt>
                <c:pt idx="49">
                  <c:v>170.67780098482649</c:v>
                </c:pt>
                <c:pt idx="50">
                  <c:v>170.83767422632604</c:v>
                </c:pt>
                <c:pt idx="51">
                  <c:v>172.52468617199833</c:v>
                </c:pt>
                <c:pt idx="52">
                  <c:v>170.95947231587945</c:v>
                </c:pt>
                <c:pt idx="53">
                  <c:v>170.65866581254861</c:v>
                </c:pt>
                <c:pt idx="54">
                  <c:v>170.95288194174842</c:v>
                </c:pt>
                <c:pt idx="55">
                  <c:v>169.61583565319577</c:v>
                </c:pt>
                <c:pt idx="56">
                  <c:v>170.54554225047406</c:v>
                </c:pt>
                <c:pt idx="57">
                  <c:v>170.30433875496902</c:v>
                </c:pt>
                <c:pt idx="58">
                  <c:v>170.36841859974427</c:v>
                </c:pt>
                <c:pt idx="59">
                  <c:v>169.61414608275771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102A-4513-9AE8-E64BC7E519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5772584"/>
        <c:axId val="165772976"/>
      </c:scatterChart>
      <c:valAx>
        <c:axId val="165772584"/>
        <c:scaling>
          <c:orientation val="minMax"/>
          <c:max val="500"/>
          <c:min val="0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en-GB"/>
                  <a:t>Time (sec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65772976"/>
        <c:crosses val="autoZero"/>
        <c:crossBetween val="midCat"/>
        <c:majorUnit val="100"/>
        <c:minorUnit val="45"/>
      </c:valAx>
      <c:valAx>
        <c:axId val="165772976"/>
        <c:scaling>
          <c:orientation val="minMax"/>
          <c:max val="215"/>
          <c:min val="9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Normalized T1 signal enhancement (%)</a:t>
                </a:r>
              </a:p>
            </c:rich>
          </c:tx>
          <c:layout>
            <c:manualLayout>
              <c:xMode val="edge"/>
              <c:yMode val="edge"/>
              <c:x val="6.3051049883346297E-2"/>
              <c:y val="0.1435348569870510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65772584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1819172869681144"/>
          <c:y val="1.4388342496932565E-2"/>
          <c:w val="0.78180826410843063"/>
          <c:h val="0.20708336968183633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8981822303648699"/>
          <c:y val="0.25144742571404499"/>
          <c:w val="0.73673230752138652"/>
          <c:h val="0.54495696148418205"/>
        </c:manualLayout>
      </c:layout>
      <c:scatterChart>
        <c:scatterStyle val="smoothMarker"/>
        <c:varyColors val="0"/>
        <c:ser>
          <c:idx val="0"/>
          <c:order val="0"/>
          <c:tx>
            <c:v>Muscle before EBRT</c:v>
          </c:tx>
          <c:spPr>
            <a:ln w="19050" cap="rnd">
              <a:solidFill>
                <a:srgbClr val="9BBB59"/>
              </a:solidFill>
              <a:round/>
            </a:ln>
            <a:effectLst/>
          </c:spPr>
          <c:marker>
            <c:symbol val="x"/>
            <c:size val="9"/>
            <c:spPr>
              <a:solidFill>
                <a:srgbClr val="9BBB59"/>
              </a:solidFill>
              <a:ln w="25400">
                <a:solidFill>
                  <a:srgbClr val="9BBB59"/>
                </a:solidFill>
              </a:ln>
              <a:effectLst/>
            </c:spPr>
          </c:marker>
          <c:xVal>
            <c:numRef>
              <c:f>'Vessel permeability'!$O$5:$O$64</c:f>
              <c:numCache>
                <c:formatCode>General</c:formatCode>
                <c:ptCount val="60"/>
                <c:pt idx="0">
                  <c:v>0</c:v>
                </c:pt>
                <c:pt idx="1">
                  <c:v>9</c:v>
                </c:pt>
                <c:pt idx="2">
                  <c:v>18</c:v>
                </c:pt>
                <c:pt idx="3">
                  <c:v>27</c:v>
                </c:pt>
                <c:pt idx="4">
                  <c:v>36</c:v>
                </c:pt>
                <c:pt idx="5">
                  <c:v>45</c:v>
                </c:pt>
                <c:pt idx="6">
                  <c:v>54</c:v>
                </c:pt>
                <c:pt idx="7">
                  <c:v>63</c:v>
                </c:pt>
                <c:pt idx="8">
                  <c:v>72</c:v>
                </c:pt>
                <c:pt idx="9">
                  <c:v>81</c:v>
                </c:pt>
                <c:pt idx="10">
                  <c:v>90</c:v>
                </c:pt>
                <c:pt idx="11">
                  <c:v>99</c:v>
                </c:pt>
                <c:pt idx="12">
                  <c:v>108</c:v>
                </c:pt>
                <c:pt idx="13">
                  <c:v>117</c:v>
                </c:pt>
                <c:pt idx="14">
                  <c:v>126</c:v>
                </c:pt>
                <c:pt idx="15">
                  <c:v>135</c:v>
                </c:pt>
                <c:pt idx="16">
                  <c:v>144</c:v>
                </c:pt>
                <c:pt idx="17">
                  <c:v>153</c:v>
                </c:pt>
                <c:pt idx="18">
                  <c:v>162</c:v>
                </c:pt>
                <c:pt idx="19">
                  <c:v>171</c:v>
                </c:pt>
                <c:pt idx="20">
                  <c:v>180</c:v>
                </c:pt>
                <c:pt idx="21">
                  <c:v>189</c:v>
                </c:pt>
                <c:pt idx="22">
                  <c:v>198</c:v>
                </c:pt>
                <c:pt idx="23">
                  <c:v>207</c:v>
                </c:pt>
                <c:pt idx="24">
                  <c:v>216</c:v>
                </c:pt>
                <c:pt idx="25">
                  <c:v>225</c:v>
                </c:pt>
                <c:pt idx="26">
                  <c:v>234</c:v>
                </c:pt>
                <c:pt idx="27">
                  <c:v>243</c:v>
                </c:pt>
                <c:pt idx="28">
                  <c:v>252</c:v>
                </c:pt>
                <c:pt idx="29">
                  <c:v>261</c:v>
                </c:pt>
                <c:pt idx="30">
                  <c:v>270</c:v>
                </c:pt>
                <c:pt idx="31">
                  <c:v>279</c:v>
                </c:pt>
                <c:pt idx="32">
                  <c:v>288</c:v>
                </c:pt>
                <c:pt idx="33">
                  <c:v>297</c:v>
                </c:pt>
                <c:pt idx="34">
                  <c:v>306</c:v>
                </c:pt>
                <c:pt idx="35">
                  <c:v>315</c:v>
                </c:pt>
                <c:pt idx="36">
                  <c:v>324</c:v>
                </c:pt>
                <c:pt idx="37">
                  <c:v>333</c:v>
                </c:pt>
                <c:pt idx="38">
                  <c:v>342</c:v>
                </c:pt>
                <c:pt idx="39">
                  <c:v>351</c:v>
                </c:pt>
                <c:pt idx="40">
                  <c:v>360</c:v>
                </c:pt>
                <c:pt idx="41">
                  <c:v>369</c:v>
                </c:pt>
                <c:pt idx="42">
                  <c:v>378</c:v>
                </c:pt>
                <c:pt idx="43">
                  <c:v>387</c:v>
                </c:pt>
                <c:pt idx="44">
                  <c:v>396</c:v>
                </c:pt>
                <c:pt idx="45">
                  <c:v>405</c:v>
                </c:pt>
                <c:pt idx="46">
                  <c:v>414</c:v>
                </c:pt>
                <c:pt idx="47">
                  <c:v>423</c:v>
                </c:pt>
                <c:pt idx="48">
                  <c:v>432</c:v>
                </c:pt>
                <c:pt idx="49">
                  <c:v>441</c:v>
                </c:pt>
                <c:pt idx="50">
                  <c:v>450</c:v>
                </c:pt>
                <c:pt idx="51">
                  <c:v>459</c:v>
                </c:pt>
                <c:pt idx="52">
                  <c:v>468</c:v>
                </c:pt>
                <c:pt idx="53">
                  <c:v>477</c:v>
                </c:pt>
                <c:pt idx="54">
                  <c:v>486</c:v>
                </c:pt>
                <c:pt idx="55">
                  <c:v>495</c:v>
                </c:pt>
                <c:pt idx="56">
                  <c:v>504</c:v>
                </c:pt>
                <c:pt idx="57">
                  <c:v>513</c:v>
                </c:pt>
                <c:pt idx="58">
                  <c:v>522</c:v>
                </c:pt>
                <c:pt idx="59">
                  <c:v>531</c:v>
                </c:pt>
              </c:numCache>
            </c:numRef>
          </c:xVal>
          <c:yVal>
            <c:numRef>
              <c:f>'Vessel permeability'!$AU$70:$AU$129</c:f>
              <c:numCache>
                <c:formatCode>General</c:formatCode>
                <c:ptCount val="60"/>
                <c:pt idx="0">
                  <c:v>100.11249599009255</c:v>
                </c:pt>
                <c:pt idx="1">
                  <c:v>101.06172753751703</c:v>
                </c:pt>
                <c:pt idx="2">
                  <c:v>101.33348942201357</c:v>
                </c:pt>
                <c:pt idx="3">
                  <c:v>103.03224930603582</c:v>
                </c:pt>
                <c:pt idx="4">
                  <c:v>101.22766646737233</c:v>
                </c:pt>
                <c:pt idx="5">
                  <c:v>101.42096427700335</c:v>
                </c:pt>
                <c:pt idx="6">
                  <c:v>96.085825498063031</c:v>
                </c:pt>
                <c:pt idx="7">
                  <c:v>98.410547189134661</c:v>
                </c:pt>
                <c:pt idx="8">
                  <c:v>98.715837164881933</c:v>
                </c:pt>
                <c:pt idx="9">
                  <c:v>98.599197147885604</c:v>
                </c:pt>
                <c:pt idx="10">
                  <c:v>99.468561354709905</c:v>
                </c:pt>
                <c:pt idx="11">
                  <c:v>121.83041180868574</c:v>
                </c:pt>
                <c:pt idx="12">
                  <c:v>126.01686370143474</c:v>
                </c:pt>
                <c:pt idx="13">
                  <c:v>128.39945490355899</c:v>
                </c:pt>
                <c:pt idx="14">
                  <c:v>125.48</c:v>
                </c:pt>
                <c:pt idx="15">
                  <c:v>125.19663744467977</c:v>
                </c:pt>
                <c:pt idx="16">
                  <c:v>126.1187</c:v>
                </c:pt>
                <c:pt idx="17">
                  <c:v>124.09393597454992</c:v>
                </c:pt>
                <c:pt idx="18">
                  <c:v>124.04786773867657</c:v>
                </c:pt>
                <c:pt idx="19">
                  <c:v>123.20331337675321</c:v>
                </c:pt>
                <c:pt idx="20">
                  <c:v>125.78881302761999</c:v>
                </c:pt>
                <c:pt idx="21">
                  <c:v>123.68083945957179</c:v>
                </c:pt>
                <c:pt idx="22">
                  <c:v>125.31617093204599</c:v>
                </c:pt>
                <c:pt idx="23">
                  <c:v>124.85324409512286</c:v>
                </c:pt>
                <c:pt idx="24">
                  <c:v>123.80700586347666</c:v>
                </c:pt>
                <c:pt idx="25">
                  <c:v>125.88195278990348</c:v>
                </c:pt>
                <c:pt idx="26">
                  <c:v>125.02649520439748</c:v>
                </c:pt>
                <c:pt idx="27">
                  <c:v>124.84216920714393</c:v>
                </c:pt>
                <c:pt idx="28">
                  <c:v>125.9080229684088</c:v>
                </c:pt>
                <c:pt idx="29">
                  <c:v>124.72400209377064</c:v>
                </c:pt>
                <c:pt idx="30">
                  <c:v>126.08078561137457</c:v>
                </c:pt>
                <c:pt idx="31">
                  <c:v>124.03919513848021</c:v>
                </c:pt>
                <c:pt idx="32">
                  <c:v>124.35141668671751</c:v>
                </c:pt>
                <c:pt idx="33">
                  <c:v>124.89786044895119</c:v>
                </c:pt>
                <c:pt idx="34">
                  <c:v>126.96061041726514</c:v>
                </c:pt>
                <c:pt idx="35">
                  <c:v>124.52746612840564</c:v>
                </c:pt>
                <c:pt idx="36">
                  <c:v>124.75395313794471</c:v>
                </c:pt>
                <c:pt idx="37">
                  <c:v>124.73056268121681</c:v>
                </c:pt>
                <c:pt idx="38">
                  <c:v>125.25414382094912</c:v>
                </c:pt>
                <c:pt idx="39">
                  <c:v>125.7869517530235</c:v>
                </c:pt>
                <c:pt idx="40">
                  <c:v>126.24136447518701</c:v>
                </c:pt>
                <c:pt idx="41">
                  <c:v>124.96687038108323</c:v>
                </c:pt>
                <c:pt idx="42">
                  <c:v>123.74064895728094</c:v>
                </c:pt>
                <c:pt idx="43">
                  <c:v>124.63413595124995</c:v>
                </c:pt>
                <c:pt idx="44">
                  <c:v>125.15621232413801</c:v>
                </c:pt>
                <c:pt idx="45">
                  <c:v>123.19840286262851</c:v>
                </c:pt>
                <c:pt idx="46">
                  <c:v>123.44994358117644</c:v>
                </c:pt>
                <c:pt idx="47">
                  <c:v>124.82280475360096</c:v>
                </c:pt>
                <c:pt idx="48">
                  <c:v>122.48901748567846</c:v>
                </c:pt>
                <c:pt idx="49">
                  <c:v>123.8056462341486</c:v>
                </c:pt>
                <c:pt idx="50">
                  <c:v>121.92588882271829</c:v>
                </c:pt>
                <c:pt idx="51">
                  <c:v>122.40161969469921</c:v>
                </c:pt>
                <c:pt idx="52">
                  <c:v>122.04845162598828</c:v>
                </c:pt>
                <c:pt idx="53">
                  <c:v>123.04068839498838</c:v>
                </c:pt>
                <c:pt idx="54">
                  <c:v>121.76516465242861</c:v>
                </c:pt>
                <c:pt idx="55">
                  <c:v>122.15063333725789</c:v>
                </c:pt>
                <c:pt idx="56">
                  <c:v>121.61566050763409</c:v>
                </c:pt>
                <c:pt idx="57">
                  <c:v>121.21472141389017</c:v>
                </c:pt>
                <c:pt idx="58">
                  <c:v>121.39847970211648</c:v>
                </c:pt>
                <c:pt idx="59">
                  <c:v>122.6139430398523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0-102A-4513-9AE8-E64BC7E519D4}"/>
            </c:ext>
          </c:extLst>
        </c:ser>
        <c:ser>
          <c:idx val="1"/>
          <c:order val="1"/>
          <c:tx>
            <c:v>Tumour before EBRT</c:v>
          </c:tx>
          <c:spPr>
            <a:ln w="19050" cap="rnd">
              <a:solidFill>
                <a:srgbClr val="4F81BD"/>
              </a:solidFill>
              <a:round/>
            </a:ln>
            <a:effectLst/>
          </c:spPr>
          <c:marker>
            <c:symbol val="triangle"/>
            <c:size val="9"/>
            <c:spPr>
              <a:solidFill>
                <a:srgbClr val="4F81BD"/>
              </a:solidFill>
              <a:ln w="25400">
                <a:solidFill>
                  <a:srgbClr val="4F81BD"/>
                </a:solidFill>
              </a:ln>
              <a:effectLst/>
            </c:spPr>
          </c:marker>
          <c:xVal>
            <c:numRef>
              <c:f>'Vessel permeability'!$O$5:$O$64</c:f>
              <c:numCache>
                <c:formatCode>General</c:formatCode>
                <c:ptCount val="60"/>
                <c:pt idx="0">
                  <c:v>0</c:v>
                </c:pt>
                <c:pt idx="1">
                  <c:v>9</c:v>
                </c:pt>
                <c:pt idx="2">
                  <c:v>18</c:v>
                </c:pt>
                <c:pt idx="3">
                  <c:v>27</c:v>
                </c:pt>
                <c:pt idx="4">
                  <c:v>36</c:v>
                </c:pt>
                <c:pt idx="5">
                  <c:v>45</c:v>
                </c:pt>
                <c:pt idx="6">
                  <c:v>54</c:v>
                </c:pt>
                <c:pt idx="7">
                  <c:v>63</c:v>
                </c:pt>
                <c:pt idx="8">
                  <c:v>72</c:v>
                </c:pt>
                <c:pt idx="9">
                  <c:v>81</c:v>
                </c:pt>
                <c:pt idx="10">
                  <c:v>90</c:v>
                </c:pt>
                <c:pt idx="11">
                  <c:v>99</c:v>
                </c:pt>
                <c:pt idx="12">
                  <c:v>108</c:v>
                </c:pt>
                <c:pt idx="13">
                  <c:v>117</c:v>
                </c:pt>
                <c:pt idx="14">
                  <c:v>126</c:v>
                </c:pt>
                <c:pt idx="15">
                  <c:v>135</c:v>
                </c:pt>
                <c:pt idx="16">
                  <c:v>144</c:v>
                </c:pt>
                <c:pt idx="17">
                  <c:v>153</c:v>
                </c:pt>
                <c:pt idx="18">
                  <c:v>162</c:v>
                </c:pt>
                <c:pt idx="19">
                  <c:v>171</c:v>
                </c:pt>
                <c:pt idx="20">
                  <c:v>180</c:v>
                </c:pt>
                <c:pt idx="21">
                  <c:v>189</c:v>
                </c:pt>
                <c:pt idx="22">
                  <c:v>198</c:v>
                </c:pt>
                <c:pt idx="23">
                  <c:v>207</c:v>
                </c:pt>
                <c:pt idx="24">
                  <c:v>216</c:v>
                </c:pt>
                <c:pt idx="25">
                  <c:v>225</c:v>
                </c:pt>
                <c:pt idx="26">
                  <c:v>234</c:v>
                </c:pt>
                <c:pt idx="27">
                  <c:v>243</c:v>
                </c:pt>
                <c:pt idx="28">
                  <c:v>252</c:v>
                </c:pt>
                <c:pt idx="29">
                  <c:v>261</c:v>
                </c:pt>
                <c:pt idx="30">
                  <c:v>270</c:v>
                </c:pt>
                <c:pt idx="31">
                  <c:v>279</c:v>
                </c:pt>
                <c:pt idx="32">
                  <c:v>288</c:v>
                </c:pt>
                <c:pt idx="33">
                  <c:v>297</c:v>
                </c:pt>
                <c:pt idx="34">
                  <c:v>306</c:v>
                </c:pt>
                <c:pt idx="35">
                  <c:v>315</c:v>
                </c:pt>
                <c:pt idx="36">
                  <c:v>324</c:v>
                </c:pt>
                <c:pt idx="37">
                  <c:v>333</c:v>
                </c:pt>
                <c:pt idx="38">
                  <c:v>342</c:v>
                </c:pt>
                <c:pt idx="39">
                  <c:v>351</c:v>
                </c:pt>
                <c:pt idx="40">
                  <c:v>360</c:v>
                </c:pt>
                <c:pt idx="41">
                  <c:v>369</c:v>
                </c:pt>
                <c:pt idx="42">
                  <c:v>378</c:v>
                </c:pt>
                <c:pt idx="43">
                  <c:v>387</c:v>
                </c:pt>
                <c:pt idx="44">
                  <c:v>396</c:v>
                </c:pt>
                <c:pt idx="45">
                  <c:v>405</c:v>
                </c:pt>
                <c:pt idx="46">
                  <c:v>414</c:v>
                </c:pt>
                <c:pt idx="47">
                  <c:v>423</c:v>
                </c:pt>
                <c:pt idx="48">
                  <c:v>432</c:v>
                </c:pt>
                <c:pt idx="49">
                  <c:v>441</c:v>
                </c:pt>
                <c:pt idx="50">
                  <c:v>450</c:v>
                </c:pt>
                <c:pt idx="51">
                  <c:v>459</c:v>
                </c:pt>
                <c:pt idx="52">
                  <c:v>468</c:v>
                </c:pt>
                <c:pt idx="53">
                  <c:v>477</c:v>
                </c:pt>
                <c:pt idx="54">
                  <c:v>486</c:v>
                </c:pt>
                <c:pt idx="55">
                  <c:v>495</c:v>
                </c:pt>
                <c:pt idx="56">
                  <c:v>504</c:v>
                </c:pt>
                <c:pt idx="57">
                  <c:v>513</c:v>
                </c:pt>
                <c:pt idx="58">
                  <c:v>522</c:v>
                </c:pt>
                <c:pt idx="59">
                  <c:v>531</c:v>
                </c:pt>
              </c:numCache>
            </c:numRef>
          </c:xVal>
          <c:yVal>
            <c:numRef>
              <c:f>'Vessel permeability'!$Z$70:$Z$129</c:f>
              <c:numCache>
                <c:formatCode>General</c:formatCode>
                <c:ptCount val="60"/>
                <c:pt idx="0">
                  <c:v>99.703516851714426</c:v>
                </c:pt>
                <c:pt idx="1">
                  <c:v>100.63453666249099</c:v>
                </c:pt>
                <c:pt idx="2">
                  <c:v>99.118669573113593</c:v>
                </c:pt>
                <c:pt idx="3">
                  <c:v>101.82054923448283</c:v>
                </c:pt>
                <c:pt idx="4">
                  <c:v>99.970747153405213</c:v>
                </c:pt>
                <c:pt idx="5">
                  <c:v>100.14811384093161</c:v>
                </c:pt>
                <c:pt idx="6">
                  <c:v>98.755833486457874</c:v>
                </c:pt>
                <c:pt idx="7">
                  <c:v>100.81209359097021</c:v>
                </c:pt>
                <c:pt idx="8">
                  <c:v>100.20565978792652</c:v>
                </c:pt>
                <c:pt idx="9">
                  <c:v>98.83027981850671</c:v>
                </c:pt>
                <c:pt idx="10">
                  <c:v>98.27594485925772</c:v>
                </c:pt>
                <c:pt idx="11">
                  <c:v>118.79055370273808</c:v>
                </c:pt>
                <c:pt idx="12">
                  <c:v>125.01575874521355</c:v>
                </c:pt>
                <c:pt idx="13">
                  <c:v>135.015383659939</c:v>
                </c:pt>
                <c:pt idx="14">
                  <c:v>138.37640330268232</c:v>
                </c:pt>
                <c:pt idx="15">
                  <c:v>137.03288970230227</c:v>
                </c:pt>
                <c:pt idx="16">
                  <c:v>139.54155968136675</c:v>
                </c:pt>
                <c:pt idx="17">
                  <c:v>142.35864111058225</c:v>
                </c:pt>
                <c:pt idx="18">
                  <c:v>141.29290686685047</c:v>
                </c:pt>
                <c:pt idx="19">
                  <c:v>140.51217721468112</c:v>
                </c:pt>
                <c:pt idx="20">
                  <c:v>142</c:v>
                </c:pt>
                <c:pt idx="21">
                  <c:v>139.18708433516548</c:v>
                </c:pt>
                <c:pt idx="22">
                  <c:v>141.44999999999999</c:v>
                </c:pt>
                <c:pt idx="23">
                  <c:v>140.71140157824516</c:v>
                </c:pt>
                <c:pt idx="24">
                  <c:v>140.33080688689023</c:v>
                </c:pt>
                <c:pt idx="25">
                  <c:v>140.99222811120211</c:v>
                </c:pt>
                <c:pt idx="26">
                  <c:v>141.32580000000002</c:v>
                </c:pt>
                <c:pt idx="27">
                  <c:v>142.05099999999999</c:v>
                </c:pt>
                <c:pt idx="28">
                  <c:v>142.49283328048517</c:v>
                </c:pt>
                <c:pt idx="29">
                  <c:v>140.62547659330448</c:v>
                </c:pt>
                <c:pt idx="30">
                  <c:v>139.7142536630391</c:v>
                </c:pt>
                <c:pt idx="31">
                  <c:v>139.1124318673381</c:v>
                </c:pt>
                <c:pt idx="32">
                  <c:v>139.56</c:v>
                </c:pt>
                <c:pt idx="33">
                  <c:v>138.57543416402004</c:v>
                </c:pt>
                <c:pt idx="34">
                  <c:v>137.32785274772542</c:v>
                </c:pt>
                <c:pt idx="35">
                  <c:v>138.04478575250249</c:v>
                </c:pt>
                <c:pt idx="36">
                  <c:v>138.5526166233725</c:v>
                </c:pt>
                <c:pt idx="37">
                  <c:v>138.37448089261801</c:v>
                </c:pt>
                <c:pt idx="38">
                  <c:v>136.83701620988026</c:v>
                </c:pt>
                <c:pt idx="39">
                  <c:v>137.41999999999999</c:v>
                </c:pt>
                <c:pt idx="40">
                  <c:v>139.28</c:v>
                </c:pt>
                <c:pt idx="41">
                  <c:v>139.24760326216801</c:v>
                </c:pt>
                <c:pt idx="42">
                  <c:v>134.81214951559843</c:v>
                </c:pt>
                <c:pt idx="43">
                  <c:v>137.74581838582992</c:v>
                </c:pt>
                <c:pt idx="44">
                  <c:v>136.74372163390922</c:v>
                </c:pt>
                <c:pt idx="45">
                  <c:v>134.55019380350586</c:v>
                </c:pt>
                <c:pt idx="46">
                  <c:v>132.604832578333</c:v>
                </c:pt>
                <c:pt idx="47">
                  <c:v>136.62850142433791</c:v>
                </c:pt>
                <c:pt idx="48">
                  <c:v>134.02431197379354</c:v>
                </c:pt>
                <c:pt idx="49">
                  <c:v>132.46500469064307</c:v>
                </c:pt>
                <c:pt idx="50">
                  <c:v>132.42054368410595</c:v>
                </c:pt>
                <c:pt idx="51">
                  <c:v>133.28180868642986</c:v>
                </c:pt>
                <c:pt idx="52">
                  <c:v>134.20783957497594</c:v>
                </c:pt>
                <c:pt idx="53">
                  <c:v>131.49</c:v>
                </c:pt>
                <c:pt idx="54">
                  <c:v>130.78</c:v>
                </c:pt>
                <c:pt idx="55">
                  <c:v>132.97</c:v>
                </c:pt>
                <c:pt idx="56">
                  <c:v>131.74</c:v>
                </c:pt>
                <c:pt idx="57">
                  <c:v>131.34029497659526</c:v>
                </c:pt>
                <c:pt idx="58">
                  <c:v>132.12</c:v>
                </c:pt>
                <c:pt idx="59">
                  <c:v>131.44999999999999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1-102A-4513-9AE8-E64BC7E519D4}"/>
            </c:ext>
          </c:extLst>
        </c:ser>
        <c:ser>
          <c:idx val="4"/>
          <c:order val="2"/>
          <c:tx>
            <c:v>Muscle 24h after EBRT</c:v>
          </c:tx>
          <c:xVal>
            <c:numRef>
              <c:f>'Vessel permeability'!$O$5:$O$64</c:f>
              <c:numCache>
                <c:formatCode>General</c:formatCode>
                <c:ptCount val="60"/>
                <c:pt idx="0">
                  <c:v>0</c:v>
                </c:pt>
                <c:pt idx="1">
                  <c:v>9</c:v>
                </c:pt>
                <c:pt idx="2">
                  <c:v>18</c:v>
                </c:pt>
                <c:pt idx="3">
                  <c:v>27</c:v>
                </c:pt>
                <c:pt idx="4">
                  <c:v>36</c:v>
                </c:pt>
                <c:pt idx="5">
                  <c:v>45</c:v>
                </c:pt>
                <c:pt idx="6">
                  <c:v>54</c:v>
                </c:pt>
                <c:pt idx="7">
                  <c:v>63</c:v>
                </c:pt>
                <c:pt idx="8">
                  <c:v>72</c:v>
                </c:pt>
                <c:pt idx="9">
                  <c:v>81</c:v>
                </c:pt>
                <c:pt idx="10">
                  <c:v>90</c:v>
                </c:pt>
                <c:pt idx="11">
                  <c:v>99</c:v>
                </c:pt>
                <c:pt idx="12">
                  <c:v>108</c:v>
                </c:pt>
                <c:pt idx="13">
                  <c:v>117</c:v>
                </c:pt>
                <c:pt idx="14">
                  <c:v>126</c:v>
                </c:pt>
                <c:pt idx="15">
                  <c:v>135</c:v>
                </c:pt>
                <c:pt idx="16">
                  <c:v>144</c:v>
                </c:pt>
                <c:pt idx="17">
                  <c:v>153</c:v>
                </c:pt>
                <c:pt idx="18">
                  <c:v>162</c:v>
                </c:pt>
                <c:pt idx="19">
                  <c:v>171</c:v>
                </c:pt>
                <c:pt idx="20">
                  <c:v>180</c:v>
                </c:pt>
                <c:pt idx="21">
                  <c:v>189</c:v>
                </c:pt>
                <c:pt idx="22">
                  <c:v>198</c:v>
                </c:pt>
                <c:pt idx="23">
                  <c:v>207</c:v>
                </c:pt>
                <c:pt idx="24">
                  <c:v>216</c:v>
                </c:pt>
                <c:pt idx="25">
                  <c:v>225</c:v>
                </c:pt>
                <c:pt idx="26">
                  <c:v>234</c:v>
                </c:pt>
                <c:pt idx="27">
                  <c:v>243</c:v>
                </c:pt>
                <c:pt idx="28">
                  <c:v>252</c:v>
                </c:pt>
                <c:pt idx="29">
                  <c:v>261</c:v>
                </c:pt>
                <c:pt idx="30">
                  <c:v>270</c:v>
                </c:pt>
                <c:pt idx="31">
                  <c:v>279</c:v>
                </c:pt>
                <c:pt idx="32">
                  <c:v>288</c:v>
                </c:pt>
                <c:pt idx="33">
                  <c:v>297</c:v>
                </c:pt>
                <c:pt idx="34">
                  <c:v>306</c:v>
                </c:pt>
                <c:pt idx="35">
                  <c:v>315</c:v>
                </c:pt>
                <c:pt idx="36">
                  <c:v>324</c:v>
                </c:pt>
                <c:pt idx="37">
                  <c:v>333</c:v>
                </c:pt>
                <c:pt idx="38">
                  <c:v>342</c:v>
                </c:pt>
                <c:pt idx="39">
                  <c:v>351</c:v>
                </c:pt>
                <c:pt idx="40">
                  <c:v>360</c:v>
                </c:pt>
                <c:pt idx="41">
                  <c:v>369</c:v>
                </c:pt>
                <c:pt idx="42">
                  <c:v>378</c:v>
                </c:pt>
                <c:pt idx="43">
                  <c:v>387</c:v>
                </c:pt>
                <c:pt idx="44">
                  <c:v>396</c:v>
                </c:pt>
                <c:pt idx="45">
                  <c:v>405</c:v>
                </c:pt>
                <c:pt idx="46">
                  <c:v>414</c:v>
                </c:pt>
                <c:pt idx="47">
                  <c:v>423</c:v>
                </c:pt>
                <c:pt idx="48">
                  <c:v>432</c:v>
                </c:pt>
                <c:pt idx="49">
                  <c:v>441</c:v>
                </c:pt>
                <c:pt idx="50">
                  <c:v>450</c:v>
                </c:pt>
                <c:pt idx="51">
                  <c:v>459</c:v>
                </c:pt>
                <c:pt idx="52">
                  <c:v>468</c:v>
                </c:pt>
                <c:pt idx="53">
                  <c:v>477</c:v>
                </c:pt>
                <c:pt idx="54">
                  <c:v>486</c:v>
                </c:pt>
                <c:pt idx="55">
                  <c:v>495</c:v>
                </c:pt>
                <c:pt idx="56">
                  <c:v>504</c:v>
                </c:pt>
                <c:pt idx="57">
                  <c:v>513</c:v>
                </c:pt>
                <c:pt idx="58">
                  <c:v>522</c:v>
                </c:pt>
                <c:pt idx="59">
                  <c:v>531</c:v>
                </c:pt>
              </c:numCache>
            </c:numRef>
          </c:xVal>
          <c:yVal>
            <c:numRef>
              <c:f>'Vessel permeability'!$AQ$70:$AQ$129</c:f>
              <c:numCache>
                <c:formatCode>General</c:formatCode>
                <c:ptCount val="60"/>
                <c:pt idx="0">
                  <c:v>99.944222172672738</c:v>
                </c:pt>
                <c:pt idx="1">
                  <c:v>100.36638999820366</c:v>
                </c:pt>
                <c:pt idx="2">
                  <c:v>100.60997805125966</c:v>
                </c:pt>
                <c:pt idx="3">
                  <c:v>99.385790790368105</c:v>
                </c:pt>
                <c:pt idx="4">
                  <c:v>100.10658847482701</c:v>
                </c:pt>
                <c:pt idx="5">
                  <c:v>100.15884954933554</c:v>
                </c:pt>
                <c:pt idx="6">
                  <c:v>100.94370441469761</c:v>
                </c:pt>
                <c:pt idx="7">
                  <c:v>99.031022890549806</c:v>
                </c:pt>
                <c:pt idx="8">
                  <c:v>100.09350004630511</c:v>
                </c:pt>
                <c:pt idx="9">
                  <c:v>99.359953611780711</c:v>
                </c:pt>
                <c:pt idx="10">
                  <c:v>99.015853159486042</c:v>
                </c:pt>
                <c:pt idx="11">
                  <c:v>123.95706677691066</c:v>
                </c:pt>
                <c:pt idx="12">
                  <c:v>126.72987424484404</c:v>
                </c:pt>
                <c:pt idx="13">
                  <c:v>125.95</c:v>
                </c:pt>
                <c:pt idx="14">
                  <c:v>124.86064085309367</c:v>
                </c:pt>
                <c:pt idx="15">
                  <c:v>125.19663744467977</c:v>
                </c:pt>
                <c:pt idx="16">
                  <c:v>126.1187</c:v>
                </c:pt>
                <c:pt idx="17">
                  <c:v>125.34099999999999</c:v>
                </c:pt>
                <c:pt idx="18">
                  <c:v>124.32608156153432</c:v>
                </c:pt>
                <c:pt idx="19">
                  <c:v>123.58700845981701</c:v>
                </c:pt>
                <c:pt idx="20">
                  <c:v>124.43019976195117</c:v>
                </c:pt>
                <c:pt idx="21">
                  <c:v>123.95665253903309</c:v>
                </c:pt>
                <c:pt idx="22">
                  <c:v>122.65246439337179</c:v>
                </c:pt>
                <c:pt idx="23">
                  <c:v>121.64104723998305</c:v>
                </c:pt>
                <c:pt idx="24">
                  <c:v>122.32307649581844</c:v>
                </c:pt>
                <c:pt idx="25">
                  <c:v>122.4284466057821</c:v>
                </c:pt>
                <c:pt idx="26">
                  <c:v>122.0842511979189</c:v>
                </c:pt>
                <c:pt idx="27">
                  <c:v>123.57660950495328</c:v>
                </c:pt>
                <c:pt idx="28">
                  <c:v>122.64938227457796</c:v>
                </c:pt>
                <c:pt idx="29">
                  <c:v>121.70652072565007</c:v>
                </c:pt>
                <c:pt idx="30">
                  <c:v>122.30417663210559</c:v>
                </c:pt>
                <c:pt idx="31">
                  <c:v>121.71116752693349</c:v>
                </c:pt>
                <c:pt idx="32">
                  <c:v>122.53361105588031</c:v>
                </c:pt>
                <c:pt idx="33">
                  <c:v>121.15019411458066</c:v>
                </c:pt>
                <c:pt idx="34">
                  <c:v>121.62382878462938</c:v>
                </c:pt>
                <c:pt idx="35">
                  <c:v>121.88877427503017</c:v>
                </c:pt>
                <c:pt idx="36">
                  <c:v>122.66241944253278</c:v>
                </c:pt>
                <c:pt idx="37">
                  <c:v>121.04012439877354</c:v>
                </c:pt>
                <c:pt idx="38">
                  <c:v>121.67242148620821</c:v>
                </c:pt>
                <c:pt idx="39">
                  <c:v>121.20128391601186</c:v>
                </c:pt>
                <c:pt idx="40">
                  <c:v>119.75250187735264</c:v>
                </c:pt>
                <c:pt idx="41">
                  <c:v>120.41496982288101</c:v>
                </c:pt>
                <c:pt idx="42">
                  <c:v>119.2466466985245</c:v>
                </c:pt>
                <c:pt idx="43">
                  <c:v>120.31089064545093</c:v>
                </c:pt>
                <c:pt idx="44">
                  <c:v>119.95986677421855</c:v>
                </c:pt>
                <c:pt idx="45">
                  <c:v>119.93878385882621</c:v>
                </c:pt>
                <c:pt idx="46">
                  <c:v>118.3032432080594</c:v>
                </c:pt>
                <c:pt idx="47">
                  <c:v>120.19754148854666</c:v>
                </c:pt>
                <c:pt idx="48">
                  <c:v>119.57933488108026</c:v>
                </c:pt>
                <c:pt idx="49">
                  <c:v>120.27048404027178</c:v>
                </c:pt>
                <c:pt idx="50">
                  <c:v>119.74393642187688</c:v>
                </c:pt>
                <c:pt idx="51">
                  <c:v>118.77393471868278</c:v>
                </c:pt>
                <c:pt idx="52">
                  <c:v>119.81769327550154</c:v>
                </c:pt>
                <c:pt idx="53">
                  <c:v>119.44627016896999</c:v>
                </c:pt>
                <c:pt idx="54">
                  <c:v>118.79795940390675</c:v>
                </c:pt>
                <c:pt idx="55">
                  <c:v>118.39571649903043</c:v>
                </c:pt>
                <c:pt idx="56">
                  <c:v>118.09042832476003</c:v>
                </c:pt>
                <c:pt idx="57">
                  <c:v>119.31064443569778</c:v>
                </c:pt>
                <c:pt idx="58">
                  <c:v>119.82248598323257</c:v>
                </c:pt>
                <c:pt idx="59">
                  <c:v>119.4510480197767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4-102A-4513-9AE8-E64BC7E519D4}"/>
            </c:ext>
          </c:extLst>
        </c:ser>
        <c:ser>
          <c:idx val="2"/>
          <c:order val="3"/>
          <c:tx>
            <c:v>Tumour 24h after EBRT</c:v>
          </c:tx>
          <c:spPr>
            <a:ln w="19050" cap="rnd">
              <a:solidFill>
                <a:srgbClr val="C0504D"/>
              </a:solidFill>
              <a:round/>
            </a:ln>
            <a:effectLst/>
          </c:spPr>
          <c:marker>
            <c:symbol val="diamond"/>
            <c:size val="9"/>
            <c:spPr>
              <a:solidFill>
                <a:srgbClr val="C0504D"/>
              </a:solidFill>
              <a:ln w="25400">
                <a:solidFill>
                  <a:srgbClr val="C0504D"/>
                </a:solidFill>
              </a:ln>
              <a:effectLst/>
            </c:spPr>
          </c:marker>
          <c:xVal>
            <c:numRef>
              <c:f>'Vessel permeability'!$O$5:$O$64</c:f>
              <c:numCache>
                <c:formatCode>General</c:formatCode>
                <c:ptCount val="60"/>
                <c:pt idx="0">
                  <c:v>0</c:v>
                </c:pt>
                <c:pt idx="1">
                  <c:v>9</c:v>
                </c:pt>
                <c:pt idx="2">
                  <c:v>18</c:v>
                </c:pt>
                <c:pt idx="3">
                  <c:v>27</c:v>
                </c:pt>
                <c:pt idx="4">
                  <c:v>36</c:v>
                </c:pt>
                <c:pt idx="5">
                  <c:v>45</c:v>
                </c:pt>
                <c:pt idx="6">
                  <c:v>54</c:v>
                </c:pt>
                <c:pt idx="7">
                  <c:v>63</c:v>
                </c:pt>
                <c:pt idx="8">
                  <c:v>72</c:v>
                </c:pt>
                <c:pt idx="9">
                  <c:v>81</c:v>
                </c:pt>
                <c:pt idx="10">
                  <c:v>90</c:v>
                </c:pt>
                <c:pt idx="11">
                  <c:v>99</c:v>
                </c:pt>
                <c:pt idx="12">
                  <c:v>108</c:v>
                </c:pt>
                <c:pt idx="13">
                  <c:v>117</c:v>
                </c:pt>
                <c:pt idx="14">
                  <c:v>126</c:v>
                </c:pt>
                <c:pt idx="15">
                  <c:v>135</c:v>
                </c:pt>
                <c:pt idx="16">
                  <c:v>144</c:v>
                </c:pt>
                <c:pt idx="17">
                  <c:v>153</c:v>
                </c:pt>
                <c:pt idx="18">
                  <c:v>162</c:v>
                </c:pt>
                <c:pt idx="19">
                  <c:v>171</c:v>
                </c:pt>
                <c:pt idx="20">
                  <c:v>180</c:v>
                </c:pt>
                <c:pt idx="21">
                  <c:v>189</c:v>
                </c:pt>
                <c:pt idx="22">
                  <c:v>198</c:v>
                </c:pt>
                <c:pt idx="23">
                  <c:v>207</c:v>
                </c:pt>
                <c:pt idx="24">
                  <c:v>216</c:v>
                </c:pt>
                <c:pt idx="25">
                  <c:v>225</c:v>
                </c:pt>
                <c:pt idx="26">
                  <c:v>234</c:v>
                </c:pt>
                <c:pt idx="27">
                  <c:v>243</c:v>
                </c:pt>
                <c:pt idx="28">
                  <c:v>252</c:v>
                </c:pt>
                <c:pt idx="29">
                  <c:v>261</c:v>
                </c:pt>
                <c:pt idx="30">
                  <c:v>270</c:v>
                </c:pt>
                <c:pt idx="31">
                  <c:v>279</c:v>
                </c:pt>
                <c:pt idx="32">
                  <c:v>288</c:v>
                </c:pt>
                <c:pt idx="33">
                  <c:v>297</c:v>
                </c:pt>
                <c:pt idx="34">
                  <c:v>306</c:v>
                </c:pt>
                <c:pt idx="35">
                  <c:v>315</c:v>
                </c:pt>
                <c:pt idx="36">
                  <c:v>324</c:v>
                </c:pt>
                <c:pt idx="37">
                  <c:v>333</c:v>
                </c:pt>
                <c:pt idx="38">
                  <c:v>342</c:v>
                </c:pt>
                <c:pt idx="39">
                  <c:v>351</c:v>
                </c:pt>
                <c:pt idx="40">
                  <c:v>360</c:v>
                </c:pt>
                <c:pt idx="41">
                  <c:v>369</c:v>
                </c:pt>
                <c:pt idx="42">
                  <c:v>378</c:v>
                </c:pt>
                <c:pt idx="43">
                  <c:v>387</c:v>
                </c:pt>
                <c:pt idx="44">
                  <c:v>396</c:v>
                </c:pt>
                <c:pt idx="45">
                  <c:v>405</c:v>
                </c:pt>
                <c:pt idx="46">
                  <c:v>414</c:v>
                </c:pt>
                <c:pt idx="47">
                  <c:v>423</c:v>
                </c:pt>
                <c:pt idx="48">
                  <c:v>432</c:v>
                </c:pt>
                <c:pt idx="49">
                  <c:v>441</c:v>
                </c:pt>
                <c:pt idx="50">
                  <c:v>450</c:v>
                </c:pt>
                <c:pt idx="51">
                  <c:v>459</c:v>
                </c:pt>
                <c:pt idx="52">
                  <c:v>468</c:v>
                </c:pt>
                <c:pt idx="53">
                  <c:v>477</c:v>
                </c:pt>
                <c:pt idx="54">
                  <c:v>486</c:v>
                </c:pt>
                <c:pt idx="55">
                  <c:v>495</c:v>
                </c:pt>
                <c:pt idx="56">
                  <c:v>504</c:v>
                </c:pt>
                <c:pt idx="57">
                  <c:v>513</c:v>
                </c:pt>
                <c:pt idx="58">
                  <c:v>522</c:v>
                </c:pt>
                <c:pt idx="59">
                  <c:v>531</c:v>
                </c:pt>
              </c:numCache>
            </c:numRef>
          </c:xVal>
          <c:yVal>
            <c:numRef>
              <c:f>'Vessel permeability'!$AD$70:$AD$129</c:f>
              <c:numCache>
                <c:formatCode>General</c:formatCode>
                <c:ptCount val="60"/>
                <c:pt idx="0">
                  <c:v>100.49635799190517</c:v>
                </c:pt>
                <c:pt idx="1">
                  <c:v>99.152833753854409</c:v>
                </c:pt>
                <c:pt idx="2">
                  <c:v>100.30524468753576</c:v>
                </c:pt>
                <c:pt idx="3">
                  <c:v>100.51328330588581</c:v>
                </c:pt>
                <c:pt idx="4">
                  <c:v>100.21524823889973</c:v>
                </c:pt>
                <c:pt idx="5">
                  <c:v>99.88500166787658</c:v>
                </c:pt>
                <c:pt idx="6">
                  <c:v>100.36270336102187</c:v>
                </c:pt>
                <c:pt idx="7">
                  <c:v>99.61251673637291</c:v>
                </c:pt>
                <c:pt idx="8">
                  <c:v>99.311751090906426</c:v>
                </c:pt>
                <c:pt idx="9">
                  <c:v>100.14505916574143</c:v>
                </c:pt>
                <c:pt idx="10">
                  <c:v>99.473278596861462</c:v>
                </c:pt>
                <c:pt idx="11">
                  <c:v>139.37800106184548</c:v>
                </c:pt>
                <c:pt idx="12">
                  <c:v>154.99756251202555</c:v>
                </c:pt>
                <c:pt idx="13">
                  <c:v>164.77023492027016</c:v>
                </c:pt>
                <c:pt idx="14">
                  <c:v>169.58816586086022</c:v>
                </c:pt>
                <c:pt idx="15">
                  <c:v>173.61835209911095</c:v>
                </c:pt>
                <c:pt idx="16">
                  <c:v>175.17206873327476</c:v>
                </c:pt>
                <c:pt idx="17">
                  <c:v>178.53563259357296</c:v>
                </c:pt>
                <c:pt idx="18">
                  <c:v>177.99885640809683</c:v>
                </c:pt>
                <c:pt idx="19">
                  <c:v>178.9956030054052</c:v>
                </c:pt>
                <c:pt idx="20">
                  <c:v>181.80746183472303</c:v>
                </c:pt>
                <c:pt idx="21">
                  <c:v>182.16611147137638</c:v>
                </c:pt>
                <c:pt idx="22">
                  <c:v>181.52940893131091</c:v>
                </c:pt>
                <c:pt idx="23">
                  <c:v>183.42596658987301</c:v>
                </c:pt>
                <c:pt idx="24">
                  <c:v>183.16182681891723</c:v>
                </c:pt>
                <c:pt idx="25">
                  <c:v>184.32876458548157</c:v>
                </c:pt>
                <c:pt idx="26">
                  <c:v>182.59083683465772</c:v>
                </c:pt>
                <c:pt idx="27">
                  <c:v>184.09398533050506</c:v>
                </c:pt>
                <c:pt idx="28">
                  <c:v>183.33139457729683</c:v>
                </c:pt>
                <c:pt idx="29">
                  <c:v>181.90494504014572</c:v>
                </c:pt>
                <c:pt idx="30">
                  <c:v>184.81439388983389</c:v>
                </c:pt>
                <c:pt idx="31">
                  <c:v>184.60117377547689</c:v>
                </c:pt>
                <c:pt idx="32">
                  <c:v>183.77033798115795</c:v>
                </c:pt>
                <c:pt idx="33">
                  <c:v>184.85464564629547</c:v>
                </c:pt>
                <c:pt idx="34">
                  <c:v>185.41381607107292</c:v>
                </c:pt>
                <c:pt idx="35">
                  <c:v>185.12775204658558</c:v>
                </c:pt>
                <c:pt idx="36">
                  <c:v>185.45006323804191</c:v>
                </c:pt>
                <c:pt idx="37">
                  <c:v>185.90624269027686</c:v>
                </c:pt>
                <c:pt idx="38">
                  <c:v>184.88567441754836</c:v>
                </c:pt>
                <c:pt idx="39">
                  <c:v>184.35370878889725</c:v>
                </c:pt>
                <c:pt idx="40">
                  <c:v>185.26339537758548</c:v>
                </c:pt>
                <c:pt idx="41">
                  <c:v>184.45955269158748</c:v>
                </c:pt>
                <c:pt idx="42">
                  <c:v>184.46892910190283</c:v>
                </c:pt>
                <c:pt idx="43">
                  <c:v>183.23198481863619</c:v>
                </c:pt>
                <c:pt idx="44">
                  <c:v>185.60574893740443</c:v>
                </c:pt>
                <c:pt idx="45">
                  <c:v>184.88297297041731</c:v>
                </c:pt>
                <c:pt idx="46">
                  <c:v>184.08627717546329</c:v>
                </c:pt>
                <c:pt idx="47">
                  <c:v>184.41851050451311</c:v>
                </c:pt>
                <c:pt idx="48">
                  <c:v>182.58208189312882</c:v>
                </c:pt>
                <c:pt idx="49">
                  <c:v>184.20944840475539</c:v>
                </c:pt>
                <c:pt idx="50">
                  <c:v>184.34452852966757</c:v>
                </c:pt>
                <c:pt idx="51">
                  <c:v>184.88567441754836</c:v>
                </c:pt>
                <c:pt idx="52">
                  <c:v>184.35370878889725</c:v>
                </c:pt>
                <c:pt idx="53">
                  <c:v>185.26339537758548</c:v>
                </c:pt>
                <c:pt idx="54">
                  <c:v>184.45955269158748</c:v>
                </c:pt>
                <c:pt idx="55">
                  <c:v>184.46892910190283</c:v>
                </c:pt>
                <c:pt idx="56">
                  <c:v>184.45955269158748</c:v>
                </c:pt>
                <c:pt idx="57">
                  <c:v>184.46892910190283</c:v>
                </c:pt>
                <c:pt idx="58">
                  <c:v>183.23198481863619</c:v>
                </c:pt>
                <c:pt idx="59">
                  <c:v>184.34452852966757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2-102A-4513-9AE8-E64BC7E519D4}"/>
            </c:ext>
          </c:extLst>
        </c:ser>
        <c:ser>
          <c:idx val="5"/>
          <c:order val="4"/>
          <c:tx>
            <c:v>Muscle 72h after EBRT</c:v>
          </c:tx>
          <c:xVal>
            <c:numRef>
              <c:f>'Vessel permeability'!$O$5:$O$64</c:f>
              <c:numCache>
                <c:formatCode>General</c:formatCode>
                <c:ptCount val="60"/>
                <c:pt idx="0">
                  <c:v>0</c:v>
                </c:pt>
                <c:pt idx="1">
                  <c:v>9</c:v>
                </c:pt>
                <c:pt idx="2">
                  <c:v>18</c:v>
                </c:pt>
                <c:pt idx="3">
                  <c:v>27</c:v>
                </c:pt>
                <c:pt idx="4">
                  <c:v>36</c:v>
                </c:pt>
                <c:pt idx="5">
                  <c:v>45</c:v>
                </c:pt>
                <c:pt idx="6">
                  <c:v>54</c:v>
                </c:pt>
                <c:pt idx="7">
                  <c:v>63</c:v>
                </c:pt>
                <c:pt idx="8">
                  <c:v>72</c:v>
                </c:pt>
                <c:pt idx="9">
                  <c:v>81</c:v>
                </c:pt>
                <c:pt idx="10">
                  <c:v>90</c:v>
                </c:pt>
                <c:pt idx="11">
                  <c:v>99</c:v>
                </c:pt>
                <c:pt idx="12">
                  <c:v>108</c:v>
                </c:pt>
                <c:pt idx="13">
                  <c:v>117</c:v>
                </c:pt>
                <c:pt idx="14">
                  <c:v>126</c:v>
                </c:pt>
                <c:pt idx="15">
                  <c:v>135</c:v>
                </c:pt>
                <c:pt idx="16">
                  <c:v>144</c:v>
                </c:pt>
                <c:pt idx="17">
                  <c:v>153</c:v>
                </c:pt>
                <c:pt idx="18">
                  <c:v>162</c:v>
                </c:pt>
                <c:pt idx="19">
                  <c:v>171</c:v>
                </c:pt>
                <c:pt idx="20">
                  <c:v>180</c:v>
                </c:pt>
                <c:pt idx="21">
                  <c:v>189</c:v>
                </c:pt>
                <c:pt idx="22">
                  <c:v>198</c:v>
                </c:pt>
                <c:pt idx="23">
                  <c:v>207</c:v>
                </c:pt>
                <c:pt idx="24">
                  <c:v>216</c:v>
                </c:pt>
                <c:pt idx="25">
                  <c:v>225</c:v>
                </c:pt>
                <c:pt idx="26">
                  <c:v>234</c:v>
                </c:pt>
                <c:pt idx="27">
                  <c:v>243</c:v>
                </c:pt>
                <c:pt idx="28">
                  <c:v>252</c:v>
                </c:pt>
                <c:pt idx="29">
                  <c:v>261</c:v>
                </c:pt>
                <c:pt idx="30">
                  <c:v>270</c:v>
                </c:pt>
                <c:pt idx="31">
                  <c:v>279</c:v>
                </c:pt>
                <c:pt idx="32">
                  <c:v>288</c:v>
                </c:pt>
                <c:pt idx="33">
                  <c:v>297</c:v>
                </c:pt>
                <c:pt idx="34">
                  <c:v>306</c:v>
                </c:pt>
                <c:pt idx="35">
                  <c:v>315</c:v>
                </c:pt>
                <c:pt idx="36">
                  <c:v>324</c:v>
                </c:pt>
                <c:pt idx="37">
                  <c:v>333</c:v>
                </c:pt>
                <c:pt idx="38">
                  <c:v>342</c:v>
                </c:pt>
                <c:pt idx="39">
                  <c:v>351</c:v>
                </c:pt>
                <c:pt idx="40">
                  <c:v>360</c:v>
                </c:pt>
                <c:pt idx="41">
                  <c:v>369</c:v>
                </c:pt>
                <c:pt idx="42">
                  <c:v>378</c:v>
                </c:pt>
                <c:pt idx="43">
                  <c:v>387</c:v>
                </c:pt>
                <c:pt idx="44">
                  <c:v>396</c:v>
                </c:pt>
                <c:pt idx="45">
                  <c:v>405</c:v>
                </c:pt>
                <c:pt idx="46">
                  <c:v>414</c:v>
                </c:pt>
                <c:pt idx="47">
                  <c:v>423</c:v>
                </c:pt>
                <c:pt idx="48">
                  <c:v>432</c:v>
                </c:pt>
                <c:pt idx="49">
                  <c:v>441</c:v>
                </c:pt>
                <c:pt idx="50">
                  <c:v>450</c:v>
                </c:pt>
                <c:pt idx="51">
                  <c:v>459</c:v>
                </c:pt>
                <c:pt idx="52">
                  <c:v>468</c:v>
                </c:pt>
                <c:pt idx="53">
                  <c:v>477</c:v>
                </c:pt>
                <c:pt idx="54">
                  <c:v>486</c:v>
                </c:pt>
                <c:pt idx="55">
                  <c:v>495</c:v>
                </c:pt>
                <c:pt idx="56">
                  <c:v>504</c:v>
                </c:pt>
                <c:pt idx="57">
                  <c:v>513</c:v>
                </c:pt>
                <c:pt idx="58">
                  <c:v>522</c:v>
                </c:pt>
                <c:pt idx="59">
                  <c:v>531</c:v>
                </c:pt>
              </c:numCache>
            </c:numRef>
          </c:xVal>
          <c:yVal>
            <c:numRef>
              <c:f>'Vessel permeability'!$AM$70:$AM$129</c:f>
              <c:numCache>
                <c:formatCode>General</c:formatCode>
                <c:ptCount val="60"/>
                <c:pt idx="0">
                  <c:v>100.01284945881348</c:v>
                </c:pt>
                <c:pt idx="1">
                  <c:v>100.48789136497295</c:v>
                </c:pt>
                <c:pt idx="2">
                  <c:v>101.62532176542783</c:v>
                </c:pt>
                <c:pt idx="3">
                  <c:v>100.99014994783653</c:v>
                </c:pt>
                <c:pt idx="4">
                  <c:v>99.46447412885729</c:v>
                </c:pt>
                <c:pt idx="5">
                  <c:v>100.30532013708751</c:v>
                </c:pt>
                <c:pt idx="6">
                  <c:v>99.570351920432572</c:v>
                </c:pt>
                <c:pt idx="7">
                  <c:v>99.200882873205856</c:v>
                </c:pt>
                <c:pt idx="8">
                  <c:v>99.514063080662069</c:v>
                </c:pt>
                <c:pt idx="9">
                  <c:v>98.828695322704078</c:v>
                </c:pt>
                <c:pt idx="10">
                  <c:v>100.64546962306613</c:v>
                </c:pt>
                <c:pt idx="11">
                  <c:v>121.83041180868574</c:v>
                </c:pt>
                <c:pt idx="12">
                  <c:v>126.01686370143474</c:v>
                </c:pt>
                <c:pt idx="13">
                  <c:v>128.39945490355899</c:v>
                </c:pt>
                <c:pt idx="14">
                  <c:v>129.4952389845291</c:v>
                </c:pt>
                <c:pt idx="15">
                  <c:v>129.1549427856753</c:v>
                </c:pt>
                <c:pt idx="16">
                  <c:v>128.37765509634374</c:v>
                </c:pt>
                <c:pt idx="17">
                  <c:v>129.08808198872401</c:v>
                </c:pt>
                <c:pt idx="18">
                  <c:v>128.71062428160855</c:v>
                </c:pt>
                <c:pt idx="19">
                  <c:v>127.74677534953172</c:v>
                </c:pt>
                <c:pt idx="20">
                  <c:v>126.93618096081532</c:v>
                </c:pt>
                <c:pt idx="21">
                  <c:v>127.02487608565841</c:v>
                </c:pt>
                <c:pt idx="22">
                  <c:v>126.40218924607112</c:v>
                </c:pt>
                <c:pt idx="23">
                  <c:v>123.88518891323714</c:v>
                </c:pt>
                <c:pt idx="24">
                  <c:v>125.40801102295833</c:v>
                </c:pt>
                <c:pt idx="25">
                  <c:v>123.49141730974831</c:v>
                </c:pt>
                <c:pt idx="26">
                  <c:v>123.73570287706224</c:v>
                </c:pt>
                <c:pt idx="27">
                  <c:v>124.13311641192276</c:v>
                </c:pt>
                <c:pt idx="28">
                  <c:v>121.37593559555633</c:v>
                </c:pt>
                <c:pt idx="29">
                  <c:v>122.30485823317545</c:v>
                </c:pt>
                <c:pt idx="30">
                  <c:v>123.65159037202569</c:v>
                </c:pt>
                <c:pt idx="31">
                  <c:v>121.59015940707725</c:v>
                </c:pt>
                <c:pt idx="32">
                  <c:v>119.38802791812537</c:v>
                </c:pt>
                <c:pt idx="33">
                  <c:v>121.04902191229574</c:v>
                </c:pt>
                <c:pt idx="34">
                  <c:v>119.57038626850569</c:v>
                </c:pt>
                <c:pt idx="35">
                  <c:v>118.81960758200979</c:v>
                </c:pt>
                <c:pt idx="36">
                  <c:v>120.07891323087864</c:v>
                </c:pt>
                <c:pt idx="37">
                  <c:v>119.32669618286155</c:v>
                </c:pt>
                <c:pt idx="38">
                  <c:v>122.44832328802266</c:v>
                </c:pt>
                <c:pt idx="39">
                  <c:v>118.22407988466574</c:v>
                </c:pt>
                <c:pt idx="40">
                  <c:v>119.21553960450349</c:v>
                </c:pt>
                <c:pt idx="41">
                  <c:v>118.55876935030993</c:v>
                </c:pt>
                <c:pt idx="42">
                  <c:v>119.57224175486805</c:v>
                </c:pt>
                <c:pt idx="43">
                  <c:v>119.60790736714763</c:v>
                </c:pt>
                <c:pt idx="44">
                  <c:v>119.6485871076901</c:v>
                </c:pt>
                <c:pt idx="45">
                  <c:v>116.94502840883389</c:v>
                </c:pt>
                <c:pt idx="46">
                  <c:v>117.99194271875983</c:v>
                </c:pt>
                <c:pt idx="47">
                  <c:v>116.49076507320962</c:v>
                </c:pt>
                <c:pt idx="48">
                  <c:v>116.18836107027022</c:v>
                </c:pt>
                <c:pt idx="49">
                  <c:v>116.52535191434832</c:v>
                </c:pt>
                <c:pt idx="50">
                  <c:v>115.87998786701786</c:v>
                </c:pt>
                <c:pt idx="51">
                  <c:v>116.00711601170728</c:v>
                </c:pt>
                <c:pt idx="52">
                  <c:v>115.04934559541901</c:v>
                </c:pt>
                <c:pt idx="53">
                  <c:v>115.60581314729346</c:v>
                </c:pt>
                <c:pt idx="54">
                  <c:v>113.28730958110765</c:v>
                </c:pt>
                <c:pt idx="55">
                  <c:v>114.82264831278628</c:v>
                </c:pt>
                <c:pt idx="56">
                  <c:v>114.03005358014613</c:v>
                </c:pt>
                <c:pt idx="57">
                  <c:v>114.18768937270013</c:v>
                </c:pt>
                <c:pt idx="58">
                  <c:v>115.22994051457435</c:v>
                </c:pt>
                <c:pt idx="59">
                  <c:v>115.3855309570452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5-102A-4513-9AE8-E64BC7E519D4}"/>
            </c:ext>
          </c:extLst>
        </c:ser>
        <c:ser>
          <c:idx val="3"/>
          <c:order val="5"/>
          <c:tx>
            <c:v>Tumour 72h after EBRT</c:v>
          </c:tx>
          <c:spPr>
            <a:ln w="19050" cap="rnd">
              <a:solidFill>
                <a:schemeClr val="tx1">
                  <a:lumMod val="85000"/>
                  <a:lumOff val="15000"/>
                </a:schemeClr>
              </a:solidFill>
              <a:round/>
            </a:ln>
            <a:effectLst/>
          </c:spPr>
          <c:marker>
            <c:symbol val="diamond"/>
            <c:size val="9"/>
            <c:spPr>
              <a:solidFill>
                <a:schemeClr val="tx1">
                  <a:lumMod val="85000"/>
                  <a:lumOff val="15000"/>
                </a:schemeClr>
              </a:solidFill>
              <a:ln w="9525">
                <a:solidFill>
                  <a:schemeClr val="tx1">
                    <a:lumMod val="85000"/>
                    <a:lumOff val="15000"/>
                  </a:schemeClr>
                </a:solidFill>
              </a:ln>
              <a:effectLst/>
            </c:spPr>
          </c:marker>
          <c:xVal>
            <c:numRef>
              <c:f>'Vessel permeability'!$O$5:$O$64</c:f>
              <c:numCache>
                <c:formatCode>General</c:formatCode>
                <c:ptCount val="60"/>
                <c:pt idx="0">
                  <c:v>0</c:v>
                </c:pt>
                <c:pt idx="1">
                  <c:v>9</c:v>
                </c:pt>
                <c:pt idx="2">
                  <c:v>18</c:v>
                </c:pt>
                <c:pt idx="3">
                  <c:v>27</c:v>
                </c:pt>
                <c:pt idx="4">
                  <c:v>36</c:v>
                </c:pt>
                <c:pt idx="5">
                  <c:v>45</c:v>
                </c:pt>
                <c:pt idx="6">
                  <c:v>54</c:v>
                </c:pt>
                <c:pt idx="7">
                  <c:v>63</c:v>
                </c:pt>
                <c:pt idx="8">
                  <c:v>72</c:v>
                </c:pt>
                <c:pt idx="9">
                  <c:v>81</c:v>
                </c:pt>
                <c:pt idx="10">
                  <c:v>90</c:v>
                </c:pt>
                <c:pt idx="11">
                  <c:v>99</c:v>
                </c:pt>
                <c:pt idx="12">
                  <c:v>108</c:v>
                </c:pt>
                <c:pt idx="13">
                  <c:v>117</c:v>
                </c:pt>
                <c:pt idx="14">
                  <c:v>126</c:v>
                </c:pt>
                <c:pt idx="15">
                  <c:v>135</c:v>
                </c:pt>
                <c:pt idx="16">
                  <c:v>144</c:v>
                </c:pt>
                <c:pt idx="17">
                  <c:v>153</c:v>
                </c:pt>
                <c:pt idx="18">
                  <c:v>162</c:v>
                </c:pt>
                <c:pt idx="19">
                  <c:v>171</c:v>
                </c:pt>
                <c:pt idx="20">
                  <c:v>180</c:v>
                </c:pt>
                <c:pt idx="21">
                  <c:v>189</c:v>
                </c:pt>
                <c:pt idx="22">
                  <c:v>198</c:v>
                </c:pt>
                <c:pt idx="23">
                  <c:v>207</c:v>
                </c:pt>
                <c:pt idx="24">
                  <c:v>216</c:v>
                </c:pt>
                <c:pt idx="25">
                  <c:v>225</c:v>
                </c:pt>
                <c:pt idx="26">
                  <c:v>234</c:v>
                </c:pt>
                <c:pt idx="27">
                  <c:v>243</c:v>
                </c:pt>
                <c:pt idx="28">
                  <c:v>252</c:v>
                </c:pt>
                <c:pt idx="29">
                  <c:v>261</c:v>
                </c:pt>
                <c:pt idx="30">
                  <c:v>270</c:v>
                </c:pt>
                <c:pt idx="31">
                  <c:v>279</c:v>
                </c:pt>
                <c:pt idx="32">
                  <c:v>288</c:v>
                </c:pt>
                <c:pt idx="33">
                  <c:v>297</c:v>
                </c:pt>
                <c:pt idx="34">
                  <c:v>306</c:v>
                </c:pt>
                <c:pt idx="35">
                  <c:v>315</c:v>
                </c:pt>
                <c:pt idx="36">
                  <c:v>324</c:v>
                </c:pt>
                <c:pt idx="37">
                  <c:v>333</c:v>
                </c:pt>
                <c:pt idx="38">
                  <c:v>342</c:v>
                </c:pt>
                <c:pt idx="39">
                  <c:v>351</c:v>
                </c:pt>
                <c:pt idx="40">
                  <c:v>360</c:v>
                </c:pt>
                <c:pt idx="41">
                  <c:v>369</c:v>
                </c:pt>
                <c:pt idx="42">
                  <c:v>378</c:v>
                </c:pt>
                <c:pt idx="43">
                  <c:v>387</c:v>
                </c:pt>
                <c:pt idx="44">
                  <c:v>396</c:v>
                </c:pt>
                <c:pt idx="45">
                  <c:v>405</c:v>
                </c:pt>
                <c:pt idx="46">
                  <c:v>414</c:v>
                </c:pt>
                <c:pt idx="47">
                  <c:v>423</c:v>
                </c:pt>
                <c:pt idx="48">
                  <c:v>432</c:v>
                </c:pt>
                <c:pt idx="49">
                  <c:v>441</c:v>
                </c:pt>
                <c:pt idx="50">
                  <c:v>450</c:v>
                </c:pt>
                <c:pt idx="51">
                  <c:v>459</c:v>
                </c:pt>
                <c:pt idx="52">
                  <c:v>468</c:v>
                </c:pt>
                <c:pt idx="53">
                  <c:v>477</c:v>
                </c:pt>
                <c:pt idx="54">
                  <c:v>486</c:v>
                </c:pt>
                <c:pt idx="55">
                  <c:v>495</c:v>
                </c:pt>
                <c:pt idx="56">
                  <c:v>504</c:v>
                </c:pt>
                <c:pt idx="57">
                  <c:v>513</c:v>
                </c:pt>
                <c:pt idx="58">
                  <c:v>522</c:v>
                </c:pt>
                <c:pt idx="59">
                  <c:v>531</c:v>
                </c:pt>
              </c:numCache>
            </c:numRef>
          </c:xVal>
          <c:yVal>
            <c:numRef>
              <c:f>'Vessel permeability'!$AH$70:$AH$129</c:f>
              <c:numCache>
                <c:formatCode>General</c:formatCode>
                <c:ptCount val="60"/>
                <c:pt idx="0">
                  <c:v>99.633325210882617</c:v>
                </c:pt>
                <c:pt idx="1">
                  <c:v>102.65768488506801</c:v>
                </c:pt>
                <c:pt idx="2">
                  <c:v>100.91443566960152</c:v>
                </c:pt>
                <c:pt idx="3">
                  <c:v>100.06701456550769</c:v>
                </c:pt>
                <c:pt idx="4">
                  <c:v>100.97051164614817</c:v>
                </c:pt>
                <c:pt idx="5">
                  <c:v>99.877518601413911</c:v>
                </c:pt>
                <c:pt idx="6">
                  <c:v>96.122443114689943</c:v>
                </c:pt>
                <c:pt idx="7">
                  <c:v>101.54683522442053</c:v>
                </c:pt>
                <c:pt idx="8">
                  <c:v>98.110382285551495</c:v>
                </c:pt>
                <c:pt idx="9">
                  <c:v>100.09984879671603</c:v>
                </c:pt>
                <c:pt idx="10">
                  <c:v>104.15295283434571</c:v>
                </c:pt>
                <c:pt idx="11">
                  <c:v>155.01386535481663</c:v>
                </c:pt>
                <c:pt idx="12">
                  <c:v>162.22932031917017</c:v>
                </c:pt>
                <c:pt idx="13">
                  <c:v>164.70965285041021</c:v>
                </c:pt>
                <c:pt idx="14">
                  <c:v>166.06467438975375</c:v>
                </c:pt>
                <c:pt idx="15">
                  <c:v>165.70219279512312</c:v>
                </c:pt>
                <c:pt idx="16">
                  <c:v>166.09575182108304</c:v>
                </c:pt>
                <c:pt idx="17">
                  <c:v>164.84005401041011</c:v>
                </c:pt>
                <c:pt idx="18">
                  <c:v>167.03494779232648</c:v>
                </c:pt>
                <c:pt idx="19">
                  <c:v>166.70652660351365</c:v>
                </c:pt>
                <c:pt idx="20">
                  <c:v>164.98213609695259</c:v>
                </c:pt>
                <c:pt idx="21">
                  <c:v>164.16988146553916</c:v>
                </c:pt>
                <c:pt idx="22">
                  <c:v>163.335751090326</c:v>
                </c:pt>
                <c:pt idx="23">
                  <c:v>166.50105810174426</c:v>
                </c:pt>
                <c:pt idx="24">
                  <c:v>163.87716095998221</c:v>
                </c:pt>
                <c:pt idx="25">
                  <c:v>160.94208436536286</c:v>
                </c:pt>
                <c:pt idx="26">
                  <c:v>161.06625247109812</c:v>
                </c:pt>
                <c:pt idx="27">
                  <c:v>161.46789098384863</c:v>
                </c:pt>
                <c:pt idx="28">
                  <c:v>161.84429252854108</c:v>
                </c:pt>
                <c:pt idx="29">
                  <c:v>159.54209233442225</c:v>
                </c:pt>
                <c:pt idx="30">
                  <c:v>157.8307380000247</c:v>
                </c:pt>
                <c:pt idx="31">
                  <c:v>157.33558753942788</c:v>
                </c:pt>
                <c:pt idx="32">
                  <c:v>160.81982005704756</c:v>
                </c:pt>
                <c:pt idx="33">
                  <c:v>156.39775039911129</c:v>
                </c:pt>
                <c:pt idx="34">
                  <c:v>158.77382761344899</c:v>
                </c:pt>
                <c:pt idx="35">
                  <c:v>159.30732471303781</c:v>
                </c:pt>
                <c:pt idx="36">
                  <c:v>156.09397998084589</c:v>
                </c:pt>
                <c:pt idx="37">
                  <c:v>159.43152150122003</c:v>
                </c:pt>
                <c:pt idx="38">
                  <c:v>158.69583466208502</c:v>
                </c:pt>
                <c:pt idx="39">
                  <c:v>155.70407796687903</c:v>
                </c:pt>
                <c:pt idx="40">
                  <c:v>153.61790679298596</c:v>
                </c:pt>
                <c:pt idx="41">
                  <c:v>155.30483443845336</c:v>
                </c:pt>
                <c:pt idx="42">
                  <c:v>154.27747579573</c:v>
                </c:pt>
                <c:pt idx="43">
                  <c:v>155.25646149158035</c:v>
                </c:pt>
                <c:pt idx="44">
                  <c:v>154.316803015879</c:v>
                </c:pt>
                <c:pt idx="45">
                  <c:v>156.91944108645194</c:v>
                </c:pt>
                <c:pt idx="46">
                  <c:v>155.58412438820048</c:v>
                </c:pt>
                <c:pt idx="47">
                  <c:v>155.30940032548588</c:v>
                </c:pt>
                <c:pt idx="48">
                  <c:v>153.47258896789083</c:v>
                </c:pt>
                <c:pt idx="49">
                  <c:v>158.09792754244179</c:v>
                </c:pt>
                <c:pt idx="50">
                  <c:v>153.44194535857244</c:v>
                </c:pt>
                <c:pt idx="51">
                  <c:v>154.25543333520707</c:v>
                </c:pt>
                <c:pt idx="52">
                  <c:v>155.1541960194389</c:v>
                </c:pt>
                <c:pt idx="53">
                  <c:v>153.20111498495243</c:v>
                </c:pt>
                <c:pt idx="54">
                  <c:v>152.84465670419274</c:v>
                </c:pt>
                <c:pt idx="55">
                  <c:v>155.96139357691484</c:v>
                </c:pt>
                <c:pt idx="56">
                  <c:v>153.01484579614666</c:v>
                </c:pt>
                <c:pt idx="57">
                  <c:v>153.11422688971123</c:v>
                </c:pt>
                <c:pt idx="58">
                  <c:v>154.62218323648253</c:v>
                </c:pt>
                <c:pt idx="59">
                  <c:v>153.5004593431145</c:v>
                </c:pt>
              </c:numCache>
            </c:numRef>
          </c:yVal>
          <c:smooth val="1"/>
          <c:extLst xmlns:c16r2="http://schemas.microsoft.com/office/drawing/2015/06/chart">
            <c:ext xmlns:c16="http://schemas.microsoft.com/office/drawing/2014/chart" uri="{C3380CC4-5D6E-409C-BE32-E72D297353CC}">
              <c16:uniqueId val="{00000003-102A-4513-9AE8-E64BC7E519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5774152"/>
        <c:axId val="165774544"/>
      </c:scatterChart>
      <c:valAx>
        <c:axId val="165774152"/>
        <c:scaling>
          <c:orientation val="minMax"/>
          <c:max val="500"/>
          <c:min val="0"/>
        </c:scaling>
        <c:delete val="0"/>
        <c:axPos val="b"/>
        <c:title>
          <c:tx>
            <c:rich>
              <a:bodyPr rot="0" vert="horz"/>
              <a:lstStyle/>
              <a:p>
                <a:pPr>
                  <a:defRPr/>
                </a:pPr>
                <a:r>
                  <a:rPr lang="en-GB"/>
                  <a:t>Time (sec)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65774544"/>
        <c:crosses val="autoZero"/>
        <c:crossBetween val="midCat"/>
        <c:majorUnit val="100"/>
        <c:minorUnit val="45"/>
      </c:valAx>
      <c:valAx>
        <c:axId val="165774544"/>
        <c:scaling>
          <c:orientation val="minMax"/>
          <c:max val="190"/>
          <c:min val="9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GB"/>
                  <a:t>Normalized T1 signal enhancement (%)</a:t>
                </a:r>
              </a:p>
            </c:rich>
          </c:tx>
          <c:layout>
            <c:manualLayout>
              <c:xMode val="edge"/>
              <c:yMode val="edge"/>
              <c:x val="6.3051049883346297E-2"/>
              <c:y val="0.14353485698705101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165774152"/>
        <c:crosses val="autoZero"/>
        <c:crossBetween val="midCat"/>
        <c:majorUnit val="25"/>
      </c:valAx>
      <c:spPr>
        <a:noFill/>
        <a:ln>
          <a:noFill/>
        </a:ln>
        <a:effectLst/>
      </c:spPr>
    </c:plotArea>
    <c:legend>
      <c:legendPos val="r"/>
      <c:layout>
        <c:manualLayout>
          <c:xMode val="edge"/>
          <c:yMode val="edge"/>
          <c:x val="0.21819172869681144"/>
          <c:y val="1.4388342496932565E-2"/>
          <c:w val="0.78180826410843063"/>
          <c:h val="0.20708336968183633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6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737327-987C-47AA-AE0A-906EE5FF642B}" type="datetimeFigureOut">
              <a:rPr lang="en-GB" smtClean="0"/>
              <a:t>02/06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18D34BB-1BED-45C4-967A-EEAB7E9B6FB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57965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660416"/>
            <a:ext cx="10363200" cy="5659496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8538164"/>
            <a:ext cx="9144000" cy="3924769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9EACD-1343-491E-B767-5A6BC3DF8645}" type="datetimeFigureOut">
              <a:rPr lang="en-GB" smtClean="0"/>
              <a:t>02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0731D-5C18-4F84-A7C4-900977E756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856918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9EACD-1343-491E-B767-5A6BC3DF8645}" type="datetimeFigureOut">
              <a:rPr lang="en-GB" smtClean="0"/>
              <a:t>02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0731D-5C18-4F84-A7C4-900977E756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29428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865481"/>
            <a:ext cx="2628900" cy="1377620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865481"/>
            <a:ext cx="7734300" cy="1377620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9EACD-1343-491E-B767-5A6BC3DF8645}" type="datetimeFigureOut">
              <a:rPr lang="en-GB" smtClean="0"/>
              <a:t>02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0731D-5C18-4F84-A7C4-900977E756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22880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9EACD-1343-491E-B767-5A6BC3DF8645}" type="datetimeFigureOut">
              <a:rPr lang="en-GB" smtClean="0"/>
              <a:t>02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0731D-5C18-4F84-A7C4-900977E756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111364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4052716"/>
            <a:ext cx="10515600" cy="6762043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10878731"/>
            <a:ext cx="10515600" cy="355599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9EACD-1343-491E-B767-5A6BC3DF8645}" type="datetimeFigureOut">
              <a:rPr lang="en-GB" smtClean="0"/>
              <a:t>02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0731D-5C18-4F84-A7C4-900977E756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2580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4327407"/>
            <a:ext cx="5181600" cy="103142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9EACD-1343-491E-B767-5A6BC3DF8645}" type="datetimeFigureOut">
              <a:rPr lang="en-GB" smtClean="0"/>
              <a:t>02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0731D-5C18-4F84-A7C4-900977E756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98916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865485"/>
            <a:ext cx="10515600" cy="314207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984979"/>
            <a:ext cx="5157787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937956"/>
            <a:ext cx="5157787" cy="873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984979"/>
            <a:ext cx="5183188" cy="1952977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937956"/>
            <a:ext cx="5183188" cy="87338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9EACD-1343-491E-B767-5A6BC3DF8645}" type="datetimeFigureOut">
              <a:rPr lang="en-GB" smtClean="0"/>
              <a:t>02/06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0731D-5C18-4F84-A7C4-900977E756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71649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9EACD-1343-491E-B767-5A6BC3DF8645}" type="datetimeFigureOut">
              <a:rPr lang="en-GB" smtClean="0"/>
              <a:t>02/06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0731D-5C18-4F84-A7C4-900977E756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47717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9EACD-1343-491E-B767-5A6BC3DF8645}" type="datetimeFigureOut">
              <a:rPr lang="en-GB" smtClean="0"/>
              <a:t>02/06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0731D-5C18-4F84-A7C4-900977E756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70839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340567"/>
            <a:ext cx="6172200" cy="11552296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9EACD-1343-491E-B767-5A6BC3DF8645}" type="datetimeFigureOut">
              <a:rPr lang="en-GB" smtClean="0"/>
              <a:t>02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0731D-5C18-4F84-A7C4-900977E756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71912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1083733"/>
            <a:ext cx="3932237" cy="3793067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340567"/>
            <a:ext cx="6172200" cy="11552296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876800"/>
            <a:ext cx="3932237" cy="9034875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5F9EACD-1343-491E-B767-5A6BC3DF8645}" type="datetimeFigureOut">
              <a:rPr lang="en-GB" smtClean="0"/>
              <a:t>02/06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80731D-5C18-4F84-A7C4-900977E756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86162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865485"/>
            <a:ext cx="10515600" cy="31420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4327407"/>
            <a:ext cx="10515600" cy="1031428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5F9EACD-1343-491E-B767-5A6BC3DF8645}" type="datetimeFigureOut">
              <a:rPr lang="en-GB" smtClean="0"/>
              <a:t>02/06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5066908"/>
            <a:ext cx="41148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5066908"/>
            <a:ext cx="2743200" cy="86548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80731D-5C18-4F84-A7C4-900977E756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64788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6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30344778"/>
              </p:ext>
            </p:extLst>
          </p:nvPr>
        </p:nvGraphicFramePr>
        <p:xfrm>
          <a:off x="0" y="0"/>
          <a:ext cx="7204203" cy="52959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7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09615144"/>
              </p:ext>
            </p:extLst>
          </p:nvPr>
        </p:nvGraphicFramePr>
        <p:xfrm>
          <a:off x="6418022" y="-144167"/>
          <a:ext cx="5664249" cy="518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8" name="TextBox 3"/>
          <p:cNvSpPr txBox="1"/>
          <p:nvPr/>
        </p:nvSpPr>
        <p:spPr>
          <a:xfrm>
            <a:off x="116197" y="468699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MOUSE 1: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3"/>
          <p:cNvSpPr txBox="1"/>
          <p:nvPr/>
        </p:nvSpPr>
        <p:spPr>
          <a:xfrm>
            <a:off x="116197" y="10483327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MOUSE 3: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3"/>
          <p:cNvSpPr txBox="1"/>
          <p:nvPr/>
        </p:nvSpPr>
        <p:spPr>
          <a:xfrm>
            <a:off x="116197" y="5433824"/>
            <a:ext cx="13003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>
                <a:latin typeface="Arial" panose="020B0604020202020204" pitchFamily="34" charset="0"/>
                <a:cs typeface="Arial" panose="020B0604020202020204" pitchFamily="34" charset="0"/>
              </a:rPr>
              <a:t>MOUSE 2:</a:t>
            </a:r>
            <a:endParaRPr lang="en-GB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2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37704628"/>
              </p:ext>
            </p:extLst>
          </p:nvPr>
        </p:nvGraphicFramePr>
        <p:xfrm>
          <a:off x="6418022" y="9999840"/>
          <a:ext cx="5664249" cy="518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74235476"/>
              </p:ext>
            </p:extLst>
          </p:nvPr>
        </p:nvGraphicFramePr>
        <p:xfrm>
          <a:off x="6418022" y="5004743"/>
          <a:ext cx="5664249" cy="5180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4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1744610"/>
              </p:ext>
            </p:extLst>
          </p:nvPr>
        </p:nvGraphicFramePr>
        <p:xfrm>
          <a:off x="-5412" y="10153965"/>
          <a:ext cx="7215029" cy="52959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5" name="Chart 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30845321"/>
              </p:ext>
            </p:extLst>
          </p:nvPr>
        </p:nvGraphicFramePr>
        <p:xfrm>
          <a:off x="7143" y="5121497"/>
          <a:ext cx="7189917" cy="52959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13" name="ZoneTexte 12"/>
          <p:cNvSpPr txBox="1"/>
          <p:nvPr/>
        </p:nvSpPr>
        <p:spPr>
          <a:xfrm>
            <a:off x="118945" y="61882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fr-F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ZoneTexte 15"/>
          <p:cNvSpPr txBox="1"/>
          <p:nvPr/>
        </p:nvSpPr>
        <p:spPr>
          <a:xfrm>
            <a:off x="7270074" y="73741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7" name="ZoneTexte 16"/>
          <p:cNvSpPr txBox="1"/>
          <p:nvPr/>
        </p:nvSpPr>
        <p:spPr>
          <a:xfrm>
            <a:off x="118945" y="4763952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fr-F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ZoneTexte 17"/>
          <p:cNvSpPr txBox="1"/>
          <p:nvPr/>
        </p:nvSpPr>
        <p:spPr>
          <a:xfrm>
            <a:off x="7337785" y="4763952"/>
            <a:ext cx="38985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fr-F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ZoneTexte 18"/>
          <p:cNvSpPr txBox="1"/>
          <p:nvPr/>
        </p:nvSpPr>
        <p:spPr>
          <a:xfrm>
            <a:off x="118945" y="9828498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fr-F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ZoneTexte 19"/>
          <p:cNvSpPr txBox="1"/>
          <p:nvPr/>
        </p:nvSpPr>
        <p:spPr>
          <a:xfrm>
            <a:off x="7305340" y="9828498"/>
            <a:ext cx="37221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fr-FR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/>
          <p:cNvSpPr/>
          <p:nvPr/>
        </p:nvSpPr>
        <p:spPr>
          <a:xfrm>
            <a:off x="322687" y="14971132"/>
            <a:ext cx="11771086" cy="13388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b="1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Supplementary </a:t>
            </a:r>
            <a:r>
              <a:rPr lang="en-US" b="1" dirty="0" smtClean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Fig. 1 </a:t>
            </a:r>
            <a:r>
              <a:rPr lang="en-GB" b="1" dirty="0" smtClean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(</a:t>
            </a:r>
            <a:r>
              <a:rPr lang="en-GB" b="1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A-C)</a:t>
            </a:r>
            <a:r>
              <a:rPr lang="en-GB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Normalized T1 signal enhancement curves for individual animals during </a:t>
            </a:r>
            <a:r>
              <a:rPr lang="en-GB" dirty="0" err="1" smtClean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Gadodiamide</a:t>
            </a:r>
            <a:r>
              <a:rPr lang="en-GB" dirty="0" smtClean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injection </a:t>
            </a:r>
            <a:r>
              <a:rPr lang="en-GB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in healthy tissue and tumour at different time points: before (blue), 24h (red) and 72h (black) after EBRT treatment. </a:t>
            </a:r>
            <a:r>
              <a:rPr lang="en-GB" b="1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(D-F):</a:t>
            </a:r>
            <a:r>
              <a:rPr lang="en-GB" dirty="0"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 Quantitative normalized T1 signal enhancement in individual animals.</a:t>
            </a:r>
            <a:endParaRPr lang="en-GB" sz="1600" dirty="0">
              <a:effectLst/>
              <a:latin typeface="Arial" panose="020B0604020202020204" pitchFamily="34" charset="0"/>
              <a:ea typeface="MS Mincho" panose="02020609040205080304" pitchFamily="49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66379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3"/>
          <p:cNvSpPr txBox="1"/>
          <p:nvPr/>
        </p:nvSpPr>
        <p:spPr>
          <a:xfrm>
            <a:off x="568702" y="6142269"/>
            <a:ext cx="9563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2 </a:t>
            </a:r>
            <a:r>
              <a:rPr lang="en-GB" dirty="0" smtClean="0">
                <a:latin typeface="Arial" panose="020B0604020202020204" pitchFamily="34" charset="0"/>
                <a:cs typeface="Arial" panose="020B0604020202020204" pitchFamily="34" charset="0"/>
              </a:rPr>
              <a:t>Representative 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BRT dose map co-registered with anatomical MRI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Group 4"/>
          <p:cNvGrpSpPr/>
          <p:nvPr/>
        </p:nvGrpSpPr>
        <p:grpSpPr>
          <a:xfrm>
            <a:off x="1944047" y="380768"/>
            <a:ext cx="6407822" cy="5610740"/>
            <a:chOff x="381664" y="1034760"/>
            <a:chExt cx="6407822" cy="5610740"/>
          </a:xfrm>
        </p:grpSpPr>
        <p:sp>
          <p:nvSpPr>
            <p:cNvPr id="4" name="Rectangle 3"/>
            <p:cNvSpPr/>
            <p:nvPr/>
          </p:nvSpPr>
          <p:spPr>
            <a:xfrm>
              <a:off x="3607492" y="1034761"/>
              <a:ext cx="3181994" cy="561073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Rectangle 1"/>
            <p:cNvSpPr/>
            <p:nvPr/>
          </p:nvSpPr>
          <p:spPr>
            <a:xfrm>
              <a:off x="5969572" y="1034761"/>
              <a:ext cx="819914" cy="4822825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30" name="Picture 6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414"/>
            <a:stretch/>
          </p:blipFill>
          <p:spPr bwMode="auto">
            <a:xfrm>
              <a:off x="568702" y="1034761"/>
              <a:ext cx="2763549" cy="48228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4" name="Picture 6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64" r="50000"/>
            <a:stretch/>
          </p:blipFill>
          <p:spPr bwMode="auto">
            <a:xfrm>
              <a:off x="3626422" y="1034761"/>
              <a:ext cx="2823784" cy="482282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 xmlns="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 xmlns="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1032" name="Picture 8" descr="Afficher l'image d'origine"/>
            <p:cNvPicPr>
              <a:picLocks noChangeAspect="1" noChangeArrowheads="1"/>
            </p:cNvPicPr>
            <p:nvPr/>
          </p:nvPicPr>
          <p:blipFill rotWithShape="1">
            <a:blip r:embed="rId3">
              <a:clrChange>
                <a:clrFrom>
                  <a:srgbClr val="FFFFFF"/>
                </a:clrFrom>
                <a:clrTo>
                  <a:srgbClr val="FFFFFF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7613"/>
            <a:stretch/>
          </p:blipFill>
          <p:spPr bwMode="auto">
            <a:xfrm>
              <a:off x="6269754" y="4390736"/>
              <a:ext cx="223830" cy="146685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ZoneTexte 2"/>
            <p:cNvSpPr txBox="1"/>
            <p:nvPr/>
          </p:nvSpPr>
          <p:spPr>
            <a:xfrm>
              <a:off x="6442860" y="5589854"/>
              <a:ext cx="26321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fr-FR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ZoneTexte 18"/>
            <p:cNvSpPr txBox="1"/>
            <p:nvPr/>
          </p:nvSpPr>
          <p:spPr>
            <a:xfrm>
              <a:off x="6442860" y="4383354"/>
              <a:ext cx="34176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  <a:endParaRPr lang="fr-FR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ZoneTexte 19"/>
            <p:cNvSpPr txBox="1"/>
            <p:nvPr/>
          </p:nvSpPr>
          <p:spPr>
            <a:xfrm rot="16200000">
              <a:off x="6171793" y="5003396"/>
              <a:ext cx="84991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 smtClean="0"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se (Gy)</a:t>
              </a:r>
              <a:endParaRPr lang="fr-FR" sz="11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Rectangle 30"/>
            <p:cNvSpPr/>
            <p:nvPr/>
          </p:nvSpPr>
          <p:spPr>
            <a:xfrm>
              <a:off x="3626422" y="5918413"/>
              <a:ext cx="3103434" cy="6463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fr-FR" b="1" cap="al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ose </a:t>
              </a:r>
              <a:r>
                <a:rPr lang="fr-FR" b="1" cap="al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ap</a:t>
              </a:r>
              <a:r>
                <a:rPr lang="fr-FR" b="1" cap="al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MRI </a:t>
              </a:r>
              <a:r>
                <a:rPr lang="fr-FR" b="1" cap="all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o</a:t>
              </a:r>
              <a:r>
                <a:rPr lang="fr-FR" b="1" cap="all" smtClean="0">
                  <a:latin typeface="Arial" panose="020B0604020202020204" pitchFamily="34" charset="0"/>
                  <a:cs typeface="Arial" panose="020B0604020202020204" pitchFamily="34" charset="0"/>
                </a:rPr>
                <a:t>-registration</a:t>
              </a:r>
              <a:endParaRPr lang="fr-FR" b="1" cap="all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Rectangle 31"/>
            <p:cNvSpPr/>
            <p:nvPr/>
          </p:nvSpPr>
          <p:spPr>
            <a:xfrm>
              <a:off x="568702" y="1034760"/>
              <a:ext cx="2763549" cy="5610739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Rectangle 32"/>
            <p:cNvSpPr/>
            <p:nvPr/>
          </p:nvSpPr>
          <p:spPr>
            <a:xfrm>
              <a:off x="381664" y="6056912"/>
              <a:ext cx="3103434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fr-FR" b="1" cap="all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RI image</a:t>
              </a:r>
              <a:endParaRPr lang="fr-FR" b="1" cap="all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59744635"/>
              </p:ext>
            </p:extLst>
          </p:nvPr>
        </p:nvGraphicFramePr>
        <p:xfrm>
          <a:off x="825753" y="12441431"/>
          <a:ext cx="6177905" cy="115824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859073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446650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436091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1436091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</a:tblGrid>
              <a:tr h="36576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 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dius (mm)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i="1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  <a:r>
                        <a:rPr lang="en-GB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 (</a:t>
                      </a:r>
                      <a:r>
                        <a:rPr lang="en-GB" sz="1400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y</a:t>
                      </a:r>
                      <a:r>
                        <a:rPr lang="en-GB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GB" sz="1400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Bqs</a:t>
                      </a:r>
                      <a:r>
                        <a:rPr lang="en-GB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ose (</a:t>
                      </a:r>
                      <a:r>
                        <a:rPr lang="en-GB" sz="1400" dirty="0" err="1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y</a:t>
                      </a:r>
                      <a:r>
                        <a:rPr lang="en-GB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)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RT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r>
                        <a:rPr lang="en-GB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53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08E-02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.61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36576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BRT and MRT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8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5E-01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GB" sz="14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8.03</a:t>
                      </a:r>
                      <a:endParaRPr lang="en-GB" sz="14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</a:tbl>
          </a:graphicData>
        </a:graphic>
      </p:graphicFrame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91373378"/>
              </p:ext>
            </p:extLst>
          </p:nvPr>
        </p:nvGraphicFramePr>
        <p:xfrm>
          <a:off x="568702" y="8247754"/>
          <a:ext cx="9158513" cy="1977561"/>
        </p:xfrm>
        <a:graphic>
          <a:graphicData uri="http://schemas.openxmlformats.org/drawingml/2006/table">
            <a:tbl>
              <a:tblPr/>
              <a:tblGrid>
                <a:gridCol w="1599223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376971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784442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2107609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2290268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</a:tblGrid>
              <a:tr h="556341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SS (g</a:t>
                      </a:r>
                      <a:r>
                        <a:rPr lang="en-GB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endParaRPr lang="en-GB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dius (mm</a:t>
                      </a:r>
                      <a:r>
                        <a:rPr lang="en-GB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endParaRPr lang="en-GB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NELOPE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1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  <a:r>
                        <a:rPr lang="en-GB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 </a:t>
                      </a:r>
                      <a:r>
                        <a:rPr lang="en-GB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</a:t>
                      </a:r>
                      <a:r>
                        <a:rPr lang="en-GB" sz="14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y</a:t>
                      </a:r>
                      <a:r>
                        <a:rPr lang="en-GB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GB" sz="14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Bqs</a:t>
                      </a:r>
                      <a:r>
                        <a:rPr lang="en-GB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121917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LINDA**</a:t>
                      </a:r>
                    </a:p>
                    <a:p>
                      <a:pPr marL="0" marR="0" lvl="0" indent="0" algn="ctr" defTabSz="121917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400" b="1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</a:t>
                      </a:r>
                      <a:r>
                        <a:rPr lang="en-GB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value (</a:t>
                      </a:r>
                      <a:r>
                        <a:rPr lang="en-GB" sz="14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y</a:t>
                      </a:r>
                      <a:r>
                        <a:rPr lang="en-GB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/</a:t>
                      </a:r>
                      <a:r>
                        <a:rPr lang="en-GB" sz="1400" b="1" i="0" u="none" strike="noStrike" dirty="0" err="1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Bqs</a:t>
                      </a:r>
                      <a:r>
                        <a:rPr lang="en-GB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NELOPE/OLINDA**</a:t>
                      </a:r>
                    </a:p>
                    <a:p>
                      <a:pPr algn="ctr" fontAlgn="b">
                        <a:lnSpc>
                          <a:spcPct val="100000"/>
                        </a:lnSpc>
                      </a:pPr>
                      <a:endParaRPr lang="en-GB" sz="14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28424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1*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55E+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9E+0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28424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*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2E-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0E-0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0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8424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*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9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66E-0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94E-0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5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28424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.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92E-0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09E-0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4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284244"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8</a:t>
                      </a:r>
                      <a:endParaRPr lang="en-GB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9E-0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6E-02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>
                        <a:lnSpc>
                          <a:spcPct val="100000"/>
                        </a:lnSpc>
                      </a:pPr>
                      <a:r>
                        <a:rPr lang="en-GB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6</a:t>
                      </a:r>
                    </a:p>
                  </a:txBody>
                  <a:tcPr marL="9525" marR="9525" marT="952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</a:tbl>
          </a:graphicData>
        </a:graphic>
      </p:graphicFrame>
      <p:sp>
        <p:nvSpPr>
          <p:cNvPr id="21" name="TextBox 3"/>
          <p:cNvSpPr txBox="1"/>
          <p:nvPr/>
        </p:nvSpPr>
        <p:spPr>
          <a:xfrm>
            <a:off x="426428" y="7181809"/>
            <a:ext cx="1028201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</a:t>
            </a:r>
            <a:r>
              <a:rPr lang="en-US" b="1" dirty="0" smtClean="0">
                <a:latin typeface="Arial" panose="020B0604020202020204" pitchFamily="34" charset="0"/>
                <a:cs typeface="Arial" panose="020B0604020202020204" pitchFamily="34" charset="0"/>
              </a:rPr>
              <a:t>1 </a:t>
            </a:r>
            <a:r>
              <a:rPr lang="en-US" dirty="0" smtClean="0">
                <a:latin typeface="Arial" panose="020B0604020202020204" pitchFamily="34" charset="0"/>
                <a:cs typeface="Arial" panose="020B0604020202020204" pitchFamily="34" charset="0"/>
              </a:rPr>
              <a:t>Comparison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f PENELOPE and OLINDA/EXM derived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-values for spheres of uniform density.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3"/>
          <p:cNvSpPr txBox="1"/>
          <p:nvPr/>
        </p:nvSpPr>
        <p:spPr>
          <a:xfrm>
            <a:off x="568702" y="10900375"/>
            <a:ext cx="11013698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2 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</a:pP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Quantitative evaluation of MRT dose alone after injection of </a:t>
            </a:r>
            <a:r>
              <a:rPr lang="en-US" baseline="30000" dirty="0">
                <a:latin typeface="Arial" panose="020B0604020202020204" pitchFamily="34" charset="0"/>
                <a:cs typeface="Arial" panose="020B0604020202020204" pitchFamily="34" charset="0"/>
              </a:rPr>
              <a:t>131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-mIBG in the MRT only and EBRT+MRT groups. 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Rectangle 9"/>
          <p:cNvSpPr/>
          <p:nvPr/>
        </p:nvSpPr>
        <p:spPr>
          <a:xfrm>
            <a:off x="167450" y="10225315"/>
            <a:ext cx="390844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algn="ctr" defTabSz="1219170" fontAlgn="b"/>
            <a:r>
              <a:rPr lang="en-GB" sz="14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Photons not included. **</a:t>
            </a:r>
            <a:r>
              <a:rPr lang="en-GB" sz="1400" dirty="0" err="1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tabin</a:t>
            </a:r>
            <a:r>
              <a:rPr lang="en-GB" sz="14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GB" sz="1400" i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t al </a:t>
            </a:r>
            <a:r>
              <a:rPr lang="en-GB" sz="14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05 [18].</a:t>
            </a:r>
            <a:endParaRPr lang="en-GB" sz="1400" dirty="0">
              <a:solidFill>
                <a:srgbClr val="0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59311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53</TotalTime>
  <Words>259</Words>
  <Application>Microsoft Office PowerPoint</Application>
  <PresentationFormat>Custom</PresentationFormat>
  <Paragraphs>7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MS Mincho</vt:lpstr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relien Corroyer-Dulmont</dc:creator>
  <cp:lastModifiedBy>Pendle, Emma (ELS-EXE)</cp:lastModifiedBy>
  <cp:revision>285</cp:revision>
  <cp:lastPrinted>2015-11-12T16:25:48Z</cp:lastPrinted>
  <dcterms:created xsi:type="dcterms:W3CDTF">2015-11-10T16:42:14Z</dcterms:created>
  <dcterms:modified xsi:type="dcterms:W3CDTF">2017-06-02T09:13:45Z</dcterms:modified>
</cp:coreProperties>
</file>